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6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7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8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9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10.xml" ContentType="application/vnd.openxmlformats-officedocument.presentationml.notesSl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11.xml" ContentType="application/vnd.openxmlformats-officedocument.presentationml.notesSl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notesSlides/notesSlide12.xml" ContentType="application/vnd.openxmlformats-officedocument.presentationml.notesSl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notesSlides/notesSlide1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5"/>
  </p:notesMasterIdLst>
  <p:sldIdLst>
    <p:sldId id="294" r:id="rId2"/>
    <p:sldId id="276" r:id="rId3"/>
    <p:sldId id="279" r:id="rId4"/>
    <p:sldId id="280" r:id="rId5"/>
    <p:sldId id="289" r:id="rId6"/>
    <p:sldId id="291" r:id="rId7"/>
    <p:sldId id="292" r:id="rId8"/>
    <p:sldId id="293" r:id="rId9"/>
    <p:sldId id="287" r:id="rId10"/>
    <p:sldId id="288" r:id="rId11"/>
    <p:sldId id="283" r:id="rId12"/>
    <p:sldId id="286" r:id="rId13"/>
    <p:sldId id="278" r:id="rId1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E538F"/>
    <a:srgbClr val="2081E0"/>
    <a:srgbClr val="2568FD"/>
    <a:srgbClr val="4170DE"/>
    <a:srgbClr val="D44958"/>
    <a:srgbClr val="FFFFFF"/>
    <a:srgbClr val="D34959"/>
    <a:srgbClr val="D53A58"/>
    <a:srgbClr val="1E81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113A9D2-9D6B-4929-AA2D-F23B5EE8CBE7}" styleName="テーマ スタイル 2 - アクセント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62"/>
    <p:restoredTop sz="94663"/>
  </p:normalViewPr>
  <p:slideViewPr>
    <p:cSldViewPr snapToGrid="0" snapToObjects="1">
      <p:cViewPr varScale="1">
        <p:scale>
          <a:sx n="86" d="100"/>
          <a:sy n="86" d="100"/>
        </p:scale>
        <p:origin x="213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杉山 耀一" userId="f29f29a06448fb82" providerId="LiveId" clId="{43D6B3F2-7A4F-4121-AFDE-32A2471D5C8E}"/>
    <pc:docChg chg="undo redo custSel delSld modSld">
      <pc:chgData name="杉山 耀一" userId="f29f29a06448fb82" providerId="LiveId" clId="{43D6B3F2-7A4F-4121-AFDE-32A2471D5C8E}" dt="2022-05-18T11:48:45.020" v="1702" actId="20577"/>
      <pc:docMkLst>
        <pc:docMk/>
      </pc:docMkLst>
      <pc:sldChg chg="addSp delSp modSp mod">
        <pc:chgData name="杉山 耀一" userId="f29f29a06448fb82" providerId="LiveId" clId="{43D6B3F2-7A4F-4121-AFDE-32A2471D5C8E}" dt="2022-05-18T11:48:45.020" v="1702" actId="20577"/>
        <pc:sldMkLst>
          <pc:docMk/>
          <pc:sldMk cId="1031857953" sldId="258"/>
        </pc:sldMkLst>
        <pc:spChg chg="mod">
          <ac:chgData name="杉山 耀一" userId="f29f29a06448fb82" providerId="LiveId" clId="{43D6B3F2-7A4F-4121-AFDE-32A2471D5C8E}" dt="2022-05-18T09:56:37.440" v="794" actId="164"/>
          <ac:spMkLst>
            <pc:docMk/>
            <pc:sldMk cId="1031857953" sldId="258"/>
            <ac:spMk id="5" creationId="{BE032756-2D4F-8048-84D2-3C8004D9FEB8}"/>
          </ac:spMkLst>
        </pc:spChg>
        <pc:spChg chg="mod topLvl">
          <ac:chgData name="杉山 耀一" userId="f29f29a06448fb82" providerId="LiveId" clId="{43D6B3F2-7A4F-4121-AFDE-32A2471D5C8E}" dt="2022-05-18T09:56:37.440" v="794" actId="164"/>
          <ac:spMkLst>
            <pc:docMk/>
            <pc:sldMk cId="1031857953" sldId="258"/>
            <ac:spMk id="6" creationId="{17317483-60B9-0D4B-9960-FB1C87196B4E}"/>
          </ac:spMkLst>
        </pc:spChg>
        <pc:spChg chg="mod">
          <ac:chgData name="杉山 耀一" userId="f29f29a06448fb82" providerId="LiveId" clId="{43D6B3F2-7A4F-4121-AFDE-32A2471D5C8E}" dt="2022-05-18T09:07:41.750" v="655" actId="1035"/>
          <ac:spMkLst>
            <pc:docMk/>
            <pc:sldMk cId="1031857953" sldId="258"/>
            <ac:spMk id="10" creationId="{BE7E6F6E-F57F-1D4F-883F-94ACA5670771}"/>
          </ac:spMkLst>
        </pc:spChg>
        <pc:spChg chg="mod">
          <ac:chgData name="杉山 耀一" userId="f29f29a06448fb82" providerId="LiveId" clId="{43D6B3F2-7A4F-4121-AFDE-32A2471D5C8E}" dt="2022-05-18T11:39:46.596" v="1164" actId="1038"/>
          <ac:spMkLst>
            <pc:docMk/>
            <pc:sldMk cId="1031857953" sldId="258"/>
            <ac:spMk id="14" creationId="{ED60FDC7-DE81-5647-91CB-5827E556BEA4}"/>
          </ac:spMkLst>
        </pc:spChg>
        <pc:spChg chg="add mod">
          <ac:chgData name="杉山 耀一" userId="f29f29a06448fb82" providerId="LiveId" clId="{43D6B3F2-7A4F-4121-AFDE-32A2471D5C8E}" dt="2022-05-18T09:07:35.380" v="640" actId="1035"/>
          <ac:spMkLst>
            <pc:docMk/>
            <pc:sldMk cId="1031857953" sldId="258"/>
            <ac:spMk id="15" creationId="{A1B57DC8-84C9-E8E6-3815-C536DD1B29FE}"/>
          </ac:spMkLst>
        </pc:spChg>
        <pc:spChg chg="add mod">
          <ac:chgData name="杉山 耀一" userId="f29f29a06448fb82" providerId="LiveId" clId="{43D6B3F2-7A4F-4121-AFDE-32A2471D5C8E}" dt="2022-05-18T11:42:20.898" v="1239" actId="14100"/>
          <ac:spMkLst>
            <pc:docMk/>
            <pc:sldMk cId="1031857953" sldId="258"/>
            <ac:spMk id="16" creationId="{2CFD7B42-8B46-9A8B-AB81-585992423658}"/>
          </ac:spMkLst>
        </pc:spChg>
        <pc:spChg chg="del">
          <ac:chgData name="杉山 耀一" userId="f29f29a06448fb82" providerId="LiveId" clId="{43D6B3F2-7A4F-4121-AFDE-32A2471D5C8E}" dt="2022-05-18T08:33:21.856" v="152" actId="478"/>
          <ac:spMkLst>
            <pc:docMk/>
            <pc:sldMk cId="1031857953" sldId="258"/>
            <ac:spMk id="18" creationId="{16992B08-5313-994C-95EC-4F9199356BF3}"/>
          </ac:spMkLst>
        </pc:spChg>
        <pc:spChg chg="del">
          <ac:chgData name="杉山 耀一" userId="f29f29a06448fb82" providerId="LiveId" clId="{43D6B3F2-7A4F-4121-AFDE-32A2471D5C8E}" dt="2022-05-18T09:55:45.083" v="754" actId="478"/>
          <ac:spMkLst>
            <pc:docMk/>
            <pc:sldMk cId="1031857953" sldId="258"/>
            <ac:spMk id="19" creationId="{A38B3202-AF20-9244-931D-BA5CF59529A6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21" creationId="{18B22D9F-DC3E-0EE9-A606-719E65C614CC}"/>
          </ac:spMkLst>
        </pc:spChg>
        <pc:spChg chg="mod">
          <ac:chgData name="杉山 耀一" userId="f29f29a06448fb82" providerId="LiveId" clId="{43D6B3F2-7A4F-4121-AFDE-32A2471D5C8E}" dt="2022-05-18T11:39:46.596" v="1164" actId="1038"/>
          <ac:spMkLst>
            <pc:docMk/>
            <pc:sldMk cId="1031857953" sldId="258"/>
            <ac:spMk id="25" creationId="{97ACF5DF-2A95-B14E-8A0D-1C4FF3167BF4}"/>
          </ac:spMkLst>
        </pc:spChg>
        <pc:spChg chg="mod">
          <ac:chgData name="杉山 耀一" userId="f29f29a06448fb82" providerId="LiveId" clId="{43D6B3F2-7A4F-4121-AFDE-32A2471D5C8E}" dt="2022-05-18T11:42:05.967" v="1238" actId="1038"/>
          <ac:spMkLst>
            <pc:docMk/>
            <pc:sldMk cId="1031857953" sldId="258"/>
            <ac:spMk id="26" creationId="{47471961-4DEE-E147-8A17-4B553E4E9D13}"/>
          </ac:spMkLst>
        </pc:spChg>
        <pc:spChg chg="del">
          <ac:chgData name="杉山 耀一" userId="f29f29a06448fb82" providerId="LiveId" clId="{43D6B3F2-7A4F-4121-AFDE-32A2471D5C8E}" dt="2022-05-18T09:56:22.844" v="793" actId="478"/>
          <ac:spMkLst>
            <pc:docMk/>
            <pc:sldMk cId="1031857953" sldId="258"/>
            <ac:spMk id="27" creationId="{9AE78794-F276-DB49-8921-CC198386EB7F}"/>
          </ac:spMkLst>
        </pc:spChg>
        <pc:spChg chg="del">
          <ac:chgData name="杉山 耀一" userId="f29f29a06448fb82" providerId="LiveId" clId="{43D6B3F2-7A4F-4121-AFDE-32A2471D5C8E}" dt="2022-05-18T09:56:16.744" v="790" actId="478"/>
          <ac:spMkLst>
            <pc:docMk/>
            <pc:sldMk cId="1031857953" sldId="258"/>
            <ac:spMk id="28" creationId="{5477CC8B-20C0-FA40-B38C-11FFEB3D5532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32" creationId="{7699368E-865E-1EEC-7703-988B37448968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33" creationId="{46173E64-B852-74F0-3637-58DE30BF42AB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34" creationId="{3266A9FD-4D4E-91D3-E6FC-E929728DAE38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35" creationId="{96E65BAE-9592-C0C7-27C5-5B66C87A2C8F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36" creationId="{809C8F3E-7472-EF4D-2EFC-2427B389B85C}"/>
          </ac:spMkLst>
        </pc:spChg>
        <pc:spChg chg="add del mod">
          <ac:chgData name="杉山 耀一" userId="f29f29a06448fb82" providerId="LiveId" clId="{43D6B3F2-7A4F-4121-AFDE-32A2471D5C8E}" dt="2022-05-18T09:01:05.428" v="515" actId="478"/>
          <ac:spMkLst>
            <pc:docMk/>
            <pc:sldMk cId="1031857953" sldId="258"/>
            <ac:spMk id="37" creationId="{7BDDF709-8674-C415-21CD-14DF557C1CA6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38" creationId="{BEB67742-F31F-F987-CBF2-1DA2BC88DCF0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39" creationId="{50A59B53-C9E9-5AC7-143B-0F1675B35CA7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40" creationId="{126DEFC5-86C0-2C4D-7B42-91BD877F7F82}"/>
          </ac:spMkLst>
        </pc:spChg>
        <pc:spChg chg="add mod">
          <ac:chgData name="杉山 耀一" userId="f29f29a06448fb82" providerId="LiveId" clId="{43D6B3F2-7A4F-4121-AFDE-32A2471D5C8E}" dt="2022-05-18T09:57:55.326" v="851" actId="164"/>
          <ac:spMkLst>
            <pc:docMk/>
            <pc:sldMk cId="1031857953" sldId="258"/>
            <ac:spMk id="41" creationId="{5A7D0927-1CA2-E824-A374-0B195A2FA6DF}"/>
          </ac:spMkLst>
        </pc:spChg>
        <pc:spChg chg="add del mod">
          <ac:chgData name="杉山 耀一" userId="f29f29a06448fb82" providerId="LiveId" clId="{43D6B3F2-7A4F-4121-AFDE-32A2471D5C8E}" dt="2022-05-18T08:43:46.273" v="410" actId="478"/>
          <ac:spMkLst>
            <pc:docMk/>
            <pc:sldMk cId="1031857953" sldId="258"/>
            <ac:spMk id="42" creationId="{F050E1FA-9568-98F4-F3A2-94A94255CD6D}"/>
          </ac:spMkLst>
        </pc:spChg>
        <pc:spChg chg="mod">
          <ac:chgData name="杉山 耀一" userId="f29f29a06448fb82" providerId="LiveId" clId="{43D6B3F2-7A4F-4121-AFDE-32A2471D5C8E}" dt="2022-05-18T09:57:24.455" v="845" actId="20577"/>
          <ac:spMkLst>
            <pc:docMk/>
            <pc:sldMk cId="1031857953" sldId="258"/>
            <ac:spMk id="48" creationId="{FA950C33-66F6-A9B1-9F1A-C36804A2BF47}"/>
          </ac:spMkLst>
        </pc:spChg>
        <pc:spChg chg="mod">
          <ac:chgData name="杉山 耀一" userId="f29f29a06448fb82" providerId="LiveId" clId="{43D6B3F2-7A4F-4121-AFDE-32A2471D5C8E}" dt="2022-05-18T09:56:39.424" v="795"/>
          <ac:spMkLst>
            <pc:docMk/>
            <pc:sldMk cId="1031857953" sldId="258"/>
            <ac:spMk id="49" creationId="{6CC65172-C50C-C317-465E-625C3028E08A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54" creationId="{CA8EC48B-767F-C64D-27BF-F19868CA8F4B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55" creationId="{08CD9CE3-6CF4-30EC-7B12-3F779E6A2CE8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56" creationId="{25E353C3-E4E6-B749-80C3-DD4800B3951C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57" creationId="{D243FE57-F36E-FDF6-A764-99EAB605ED52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58" creationId="{C1FB518B-2B49-F5B6-C55D-A6A18AD0A890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59" creationId="{B8C6F177-15E9-7F1A-693B-442A6615C742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60" creationId="{93496504-5CB4-5D07-0EA9-2F1840E31012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61" creationId="{835D7C78-6F01-B939-5A36-E67DDE842178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62" creationId="{BBEC08CA-D597-84BF-DD6F-10E2057CB471}"/>
          </ac:spMkLst>
        </pc:spChg>
        <pc:spChg chg="mod">
          <ac:chgData name="杉山 耀一" userId="f29f29a06448fb82" providerId="LiveId" clId="{43D6B3F2-7A4F-4121-AFDE-32A2471D5C8E}" dt="2022-05-18T09:58:09.813" v="852"/>
          <ac:spMkLst>
            <pc:docMk/>
            <pc:sldMk cId="1031857953" sldId="258"/>
            <ac:spMk id="63" creationId="{7B83E278-B837-5492-8302-F6D259008ED0}"/>
          </ac:spMkLst>
        </pc:spChg>
        <pc:spChg chg="add mod">
          <ac:chgData name="杉山 耀一" userId="f29f29a06448fb82" providerId="LiveId" clId="{43D6B3F2-7A4F-4121-AFDE-32A2471D5C8E}" dt="2022-05-18T11:42:05.967" v="1238" actId="1038"/>
          <ac:spMkLst>
            <pc:docMk/>
            <pc:sldMk cId="1031857953" sldId="258"/>
            <ac:spMk id="64" creationId="{1601639E-9C4C-A5E1-9CFA-17D2509AAD79}"/>
          </ac:spMkLst>
        </pc:spChg>
        <pc:spChg chg="add mod">
          <ac:chgData name="杉山 耀一" userId="f29f29a06448fb82" providerId="LiveId" clId="{43D6B3F2-7A4F-4121-AFDE-32A2471D5C8E}" dt="2022-05-18T11:44:09.639" v="1320" actId="1076"/>
          <ac:spMkLst>
            <pc:docMk/>
            <pc:sldMk cId="1031857953" sldId="258"/>
            <ac:spMk id="65" creationId="{79DCA75A-6CE3-AA74-5826-CCA0D24A539C}"/>
          </ac:spMkLst>
        </pc:spChg>
        <pc:spChg chg="add mod">
          <ac:chgData name="杉山 耀一" userId="f29f29a06448fb82" providerId="LiveId" clId="{43D6B3F2-7A4F-4121-AFDE-32A2471D5C8E}" dt="2022-05-18T11:45:29.823" v="1672" actId="1038"/>
          <ac:spMkLst>
            <pc:docMk/>
            <pc:sldMk cId="1031857953" sldId="258"/>
            <ac:spMk id="67" creationId="{EAFF73BE-A016-CF33-0CD3-0131E94FD2CD}"/>
          </ac:spMkLst>
        </pc:spChg>
        <pc:grpChg chg="add del mod">
          <ac:chgData name="杉山 耀一" userId="f29f29a06448fb82" providerId="LiveId" clId="{43D6B3F2-7A4F-4121-AFDE-32A2471D5C8E}" dt="2022-05-18T09:07:20.185" v="598" actId="165"/>
          <ac:grpSpMkLst>
            <pc:docMk/>
            <pc:sldMk cId="1031857953" sldId="258"/>
            <ac:grpSpMk id="22" creationId="{38EEFC22-44B4-40CC-7FC5-9FCE4B18E1A9}"/>
          </ac:grpSpMkLst>
        </pc:grpChg>
        <pc:grpChg chg="add mod">
          <ac:chgData name="杉山 耀一" userId="f29f29a06448fb82" providerId="LiveId" clId="{43D6B3F2-7A4F-4121-AFDE-32A2471D5C8E}" dt="2022-05-18T09:07:25.152" v="602" actId="338"/>
          <ac:grpSpMkLst>
            <pc:docMk/>
            <pc:sldMk cId="1031857953" sldId="258"/>
            <ac:grpSpMk id="43" creationId="{CBCF0885-BAE3-7DE8-901E-A25EBD888A63}"/>
          </ac:grpSpMkLst>
        </pc:grpChg>
        <pc:grpChg chg="add mod">
          <ac:chgData name="杉山 耀一" userId="f29f29a06448fb82" providerId="LiveId" clId="{43D6B3F2-7A4F-4121-AFDE-32A2471D5C8E}" dt="2022-05-18T11:39:46.596" v="1164" actId="1038"/>
          <ac:grpSpMkLst>
            <pc:docMk/>
            <pc:sldMk cId="1031857953" sldId="258"/>
            <ac:grpSpMk id="46" creationId="{51334D03-108E-0B1C-05EB-162AEED317BD}"/>
          </ac:grpSpMkLst>
        </pc:grpChg>
        <pc:grpChg chg="add mod">
          <ac:chgData name="杉山 耀一" userId="f29f29a06448fb82" providerId="LiveId" clId="{43D6B3F2-7A4F-4121-AFDE-32A2471D5C8E}" dt="2022-05-18T11:42:05.967" v="1238" actId="1038"/>
          <ac:grpSpMkLst>
            <pc:docMk/>
            <pc:sldMk cId="1031857953" sldId="258"/>
            <ac:grpSpMk id="47" creationId="{F8FE8C1B-3D10-A0E2-5903-AA6BDCFF65BC}"/>
          </ac:grpSpMkLst>
        </pc:grpChg>
        <pc:grpChg chg="add mod">
          <ac:chgData name="杉山 耀一" userId="f29f29a06448fb82" providerId="LiveId" clId="{43D6B3F2-7A4F-4121-AFDE-32A2471D5C8E}" dt="2022-05-18T11:40:40.491" v="1178" actId="14100"/>
          <ac:grpSpMkLst>
            <pc:docMk/>
            <pc:sldMk cId="1031857953" sldId="258"/>
            <ac:grpSpMk id="52" creationId="{ACFF76ED-8D51-37E6-22C1-B71FBEBF7E0B}"/>
          </ac:grpSpMkLst>
        </pc:grpChg>
        <pc:grpChg chg="add mod">
          <ac:chgData name="杉山 耀一" userId="f29f29a06448fb82" providerId="LiveId" clId="{43D6B3F2-7A4F-4121-AFDE-32A2471D5C8E}" dt="2022-05-18T11:42:05.967" v="1238" actId="1038"/>
          <ac:grpSpMkLst>
            <pc:docMk/>
            <pc:sldMk cId="1031857953" sldId="258"/>
            <ac:grpSpMk id="53" creationId="{20DC7038-BECD-4E15-7461-F0172BCC4A8C}"/>
          </ac:grpSpMkLst>
        </pc:grpChg>
        <pc:graphicFrameChg chg="del">
          <ac:chgData name="杉山 耀一" userId="f29f29a06448fb82" providerId="LiveId" clId="{43D6B3F2-7A4F-4121-AFDE-32A2471D5C8E}" dt="2022-05-18T09:56:08.308" v="789" actId="478"/>
          <ac:graphicFrameMkLst>
            <pc:docMk/>
            <pc:sldMk cId="1031857953" sldId="258"/>
            <ac:graphicFrameMk id="12" creationId="{67DABAED-4007-844C-BC8E-91E8A6F49F58}"/>
          </ac:graphicFrameMkLst>
        </pc:graphicFrameChg>
        <pc:graphicFrameChg chg="mod modGraphic">
          <ac:chgData name="杉山 耀一" userId="f29f29a06448fb82" providerId="LiveId" clId="{43D6B3F2-7A4F-4121-AFDE-32A2471D5C8E}" dt="2022-05-18T11:41:39.337" v="1208" actId="1037"/>
          <ac:graphicFrameMkLst>
            <pc:docMk/>
            <pc:sldMk cId="1031857953" sldId="258"/>
            <ac:graphicFrameMk id="31" creationId="{BADFDA87-3390-F847-9BD8-1574D2C5C787}"/>
          </ac:graphicFrameMkLst>
        </pc:graphicFrameChg>
        <pc:graphicFrameChg chg="add mod modGraphic">
          <ac:chgData name="杉山 耀一" userId="f29f29a06448fb82" providerId="LiveId" clId="{43D6B3F2-7A4F-4121-AFDE-32A2471D5C8E}" dt="2022-05-18T11:48:45.020" v="1702" actId="20577"/>
          <ac:graphicFrameMkLst>
            <pc:docMk/>
            <pc:sldMk cId="1031857953" sldId="258"/>
            <ac:graphicFrameMk id="66" creationId="{E48A8F21-8671-EE3C-CE93-A6227D02ABB1}"/>
          </ac:graphicFrameMkLst>
        </pc:graphicFrameChg>
        <pc:picChg chg="add del mod">
          <ac:chgData name="杉山 耀一" userId="f29f29a06448fb82" providerId="LiveId" clId="{43D6B3F2-7A4F-4121-AFDE-32A2471D5C8E}" dt="2022-05-18T08:28:39.220" v="36" actId="478"/>
          <ac:picMkLst>
            <pc:docMk/>
            <pc:sldMk cId="1031857953" sldId="258"/>
            <ac:picMk id="3" creationId="{7A7A16BE-1D62-2F1C-4CE5-3F2476D9F854}"/>
          </ac:picMkLst>
        </pc:picChg>
        <pc:picChg chg="del mod">
          <ac:chgData name="杉山 耀一" userId="f29f29a06448fb82" providerId="LiveId" clId="{43D6B3F2-7A4F-4121-AFDE-32A2471D5C8E}" dt="2022-05-18T08:33:01.594" v="149" actId="478"/>
          <ac:picMkLst>
            <pc:docMk/>
            <pc:sldMk cId="1031857953" sldId="258"/>
            <ac:picMk id="7" creationId="{CBDB172B-0F99-974D-99DD-85CD4557FEB3}"/>
          </ac:picMkLst>
        </pc:picChg>
        <pc:picChg chg="add del mod ord">
          <ac:chgData name="杉山 耀一" userId="f29f29a06448fb82" providerId="LiveId" clId="{43D6B3F2-7A4F-4121-AFDE-32A2471D5C8E}" dt="2022-05-18T08:36:34.858" v="170" actId="478"/>
          <ac:picMkLst>
            <pc:docMk/>
            <pc:sldMk cId="1031857953" sldId="258"/>
            <ac:picMk id="11" creationId="{3A14F30B-0435-C5DA-3BEC-90BEA00D5820}"/>
          </ac:picMkLst>
        </pc:picChg>
        <pc:picChg chg="add del">
          <ac:chgData name="杉山 耀一" userId="f29f29a06448fb82" providerId="LiveId" clId="{43D6B3F2-7A4F-4121-AFDE-32A2471D5C8E}" dt="2022-05-18T09:55:18.559" v="668" actId="478"/>
          <ac:picMkLst>
            <pc:docMk/>
            <pc:sldMk cId="1031857953" sldId="258"/>
            <ac:picMk id="13" creationId="{9172E0BF-C3BE-BA4C-A7FE-51A0216C0968}"/>
          </ac:picMkLst>
        </pc:picChg>
        <pc:picChg chg="add del mod ord">
          <ac:chgData name="杉山 耀一" userId="f29f29a06448fb82" providerId="LiveId" clId="{43D6B3F2-7A4F-4121-AFDE-32A2471D5C8E}" dt="2022-05-18T08:59:02.527" v="484" actId="478"/>
          <ac:picMkLst>
            <pc:docMk/>
            <pc:sldMk cId="1031857953" sldId="258"/>
            <ac:picMk id="20" creationId="{E0F7D3C2-6C33-5FE0-2D26-6BD259722139}"/>
          </ac:picMkLst>
        </pc:picChg>
        <pc:picChg chg="add mod ord">
          <ac:chgData name="杉山 耀一" userId="f29f29a06448fb82" providerId="LiveId" clId="{43D6B3F2-7A4F-4121-AFDE-32A2471D5C8E}" dt="2022-05-18T11:40:41.633" v="1179" actId="14100"/>
          <ac:picMkLst>
            <pc:docMk/>
            <pc:sldMk cId="1031857953" sldId="258"/>
            <ac:picMk id="24" creationId="{EC9B92BA-AADF-518C-EFBA-5813A018DA88}"/>
          </ac:picMkLst>
        </pc:picChg>
        <pc:picChg chg="add mod ord">
          <ac:chgData name="杉山 耀一" userId="f29f29a06448fb82" providerId="LiveId" clId="{43D6B3F2-7A4F-4121-AFDE-32A2471D5C8E}" dt="2022-05-18T11:42:05.967" v="1238" actId="1038"/>
          <ac:picMkLst>
            <pc:docMk/>
            <pc:sldMk cId="1031857953" sldId="258"/>
            <ac:picMk id="45" creationId="{428AB042-AC4E-5FD1-7322-1EBA524A2DAC}"/>
          </ac:picMkLst>
        </pc:picChg>
        <pc:cxnChg chg="mod topLvl">
          <ac:chgData name="杉山 耀一" userId="f29f29a06448fb82" providerId="LiveId" clId="{43D6B3F2-7A4F-4121-AFDE-32A2471D5C8E}" dt="2022-05-18T09:56:37.440" v="794" actId="164"/>
          <ac:cxnSpMkLst>
            <pc:docMk/>
            <pc:sldMk cId="1031857953" sldId="258"/>
            <ac:cxnSpMk id="8" creationId="{385FEBD8-E548-794A-8AA0-FA1E871E738F}"/>
          </ac:cxnSpMkLst>
        </pc:cxnChg>
        <pc:cxnChg chg="mod topLvl">
          <ac:chgData name="杉山 耀一" userId="f29f29a06448fb82" providerId="LiveId" clId="{43D6B3F2-7A4F-4121-AFDE-32A2471D5C8E}" dt="2022-05-18T09:56:37.440" v="794" actId="164"/>
          <ac:cxnSpMkLst>
            <pc:docMk/>
            <pc:sldMk cId="1031857953" sldId="258"/>
            <ac:cxnSpMk id="9" creationId="{C6AA4859-CFC6-2E4E-9F2F-3FEA3386A7A6}"/>
          </ac:cxnSpMkLst>
        </pc:cxnChg>
        <pc:cxnChg chg="del">
          <ac:chgData name="杉山 耀一" userId="f29f29a06448fb82" providerId="LiveId" clId="{43D6B3F2-7A4F-4121-AFDE-32A2471D5C8E}" dt="2022-05-18T09:56:20.564" v="792" actId="478"/>
          <ac:cxnSpMkLst>
            <pc:docMk/>
            <pc:sldMk cId="1031857953" sldId="258"/>
            <ac:cxnSpMk id="29" creationId="{469FA955-5471-BE41-A3F6-83FC4AA6FA51}"/>
          </ac:cxnSpMkLst>
        </pc:cxnChg>
        <pc:cxnChg chg="del">
          <ac:chgData name="杉山 耀一" userId="f29f29a06448fb82" providerId="LiveId" clId="{43D6B3F2-7A4F-4121-AFDE-32A2471D5C8E}" dt="2022-05-18T09:56:18.749" v="791" actId="478"/>
          <ac:cxnSpMkLst>
            <pc:docMk/>
            <pc:sldMk cId="1031857953" sldId="258"/>
            <ac:cxnSpMk id="30" creationId="{4532C0F6-EA23-0E43-B607-993BFBB6F806}"/>
          </ac:cxnSpMkLst>
        </pc:cxnChg>
        <pc:cxnChg chg="mod">
          <ac:chgData name="杉山 耀一" userId="f29f29a06448fb82" providerId="LiveId" clId="{43D6B3F2-7A4F-4121-AFDE-32A2471D5C8E}" dt="2022-05-18T09:56:39.424" v="795"/>
          <ac:cxnSpMkLst>
            <pc:docMk/>
            <pc:sldMk cId="1031857953" sldId="258"/>
            <ac:cxnSpMk id="50" creationId="{88AE909E-2587-8DD6-176C-23EA8D07B5D8}"/>
          </ac:cxnSpMkLst>
        </pc:cxnChg>
        <pc:cxnChg chg="mod">
          <ac:chgData name="杉山 耀一" userId="f29f29a06448fb82" providerId="LiveId" clId="{43D6B3F2-7A4F-4121-AFDE-32A2471D5C8E}" dt="2022-05-18T09:56:39.424" v="795"/>
          <ac:cxnSpMkLst>
            <pc:docMk/>
            <pc:sldMk cId="1031857953" sldId="258"/>
            <ac:cxnSpMk id="51" creationId="{1D83FDF1-1161-058A-EA28-813D4CACE279}"/>
          </ac:cxnSpMkLst>
        </pc:cxnChg>
      </pc:sldChg>
      <pc:sldChg chg="del">
        <pc:chgData name="杉山 耀一" userId="f29f29a06448fb82" providerId="LiveId" clId="{43D6B3F2-7A4F-4121-AFDE-32A2471D5C8E}" dt="2022-05-18T06:33:33.007" v="1" actId="47"/>
        <pc:sldMkLst>
          <pc:docMk/>
          <pc:sldMk cId="754458350" sldId="262"/>
        </pc:sldMkLst>
      </pc:sldChg>
      <pc:sldChg chg="del">
        <pc:chgData name="杉山 耀一" userId="f29f29a06448fb82" providerId="LiveId" clId="{43D6B3F2-7A4F-4121-AFDE-32A2471D5C8E}" dt="2022-05-18T06:33:33.806" v="2" actId="47"/>
        <pc:sldMkLst>
          <pc:docMk/>
          <pc:sldMk cId="1653261543" sldId="269"/>
        </pc:sldMkLst>
      </pc:sldChg>
      <pc:sldChg chg="del">
        <pc:chgData name="杉山 耀一" userId="f29f29a06448fb82" providerId="LiveId" clId="{43D6B3F2-7A4F-4121-AFDE-32A2471D5C8E}" dt="2022-05-18T06:33:32.186" v="0" actId="47"/>
        <pc:sldMkLst>
          <pc:docMk/>
          <pc:sldMk cId="3154529026" sldId="286"/>
        </pc:sldMkLst>
      </pc:sldChg>
      <pc:sldChg chg="del">
        <pc:chgData name="杉山 耀一" userId="f29f29a06448fb82" providerId="LiveId" clId="{43D6B3F2-7A4F-4121-AFDE-32A2471D5C8E}" dt="2022-05-18T06:33:35.543" v="4" actId="47"/>
        <pc:sldMkLst>
          <pc:docMk/>
          <pc:sldMk cId="3686404043" sldId="287"/>
        </pc:sldMkLst>
      </pc:sldChg>
      <pc:sldChg chg="del">
        <pc:chgData name="杉山 耀一" userId="f29f29a06448fb82" providerId="LiveId" clId="{43D6B3F2-7A4F-4121-AFDE-32A2471D5C8E}" dt="2022-05-18T06:33:34.635" v="3" actId="47"/>
        <pc:sldMkLst>
          <pc:docMk/>
          <pc:sldMk cId="1020514357" sldId="288"/>
        </pc:sldMkLst>
      </pc:sldChg>
      <pc:sldChg chg="del">
        <pc:chgData name="杉山 耀一" userId="f29f29a06448fb82" providerId="LiveId" clId="{43D6B3F2-7A4F-4121-AFDE-32A2471D5C8E}" dt="2022-05-18T06:33:37.127" v="5" actId="47"/>
        <pc:sldMkLst>
          <pc:docMk/>
          <pc:sldMk cId="3817770963" sldId="289"/>
        </pc:sldMkLst>
      </pc:sldChg>
    </pc:docChg>
  </pc:docChgLst>
  <pc:docChgLst>
    <pc:chgData name="杉山 耀一" userId="f29f29a06448fb82" providerId="LiveId" clId="{FF1C5E51-A8ED-4011-9A8E-E79933252A52}"/>
    <pc:docChg chg="undo custSel modSld">
      <pc:chgData name="杉山 耀一" userId="f29f29a06448fb82" providerId="LiveId" clId="{FF1C5E51-A8ED-4011-9A8E-E79933252A52}" dt="2022-06-26T15:20:47.899" v="329" actId="20577"/>
      <pc:docMkLst>
        <pc:docMk/>
      </pc:docMkLst>
      <pc:sldChg chg="addSp delSp modSp mod">
        <pc:chgData name="杉山 耀一" userId="f29f29a06448fb82" providerId="LiveId" clId="{FF1C5E51-A8ED-4011-9A8E-E79933252A52}" dt="2022-06-26T15:20:47.899" v="329" actId="20577"/>
        <pc:sldMkLst>
          <pc:docMk/>
          <pc:sldMk cId="1031857953" sldId="258"/>
        </pc:sldMkLst>
        <pc:spChg chg="mod">
          <ac:chgData name="杉山 耀一" userId="f29f29a06448fb82" providerId="LiveId" clId="{FF1C5E51-A8ED-4011-9A8E-E79933252A52}" dt="2022-06-26T14:44:55.813" v="217" actId="20577"/>
          <ac:spMkLst>
            <pc:docMk/>
            <pc:sldMk cId="1031857953" sldId="258"/>
            <ac:spMk id="5" creationId="{BE032756-2D4F-8048-84D2-3C8004D9FEB8}"/>
          </ac:spMkLst>
        </pc:spChg>
        <pc:spChg chg="mod">
          <ac:chgData name="杉山 耀一" userId="f29f29a06448fb82" providerId="LiveId" clId="{FF1C5E51-A8ED-4011-9A8E-E79933252A52}" dt="2022-06-26T14:32:18.193" v="16" actId="20577"/>
          <ac:spMkLst>
            <pc:docMk/>
            <pc:sldMk cId="1031857953" sldId="258"/>
            <ac:spMk id="10" creationId="{BE7E6F6E-F57F-1D4F-883F-94ACA5670771}"/>
          </ac:spMkLst>
        </pc:spChg>
        <pc:spChg chg="mod">
          <ac:chgData name="杉山 耀一" userId="f29f29a06448fb82" providerId="LiveId" clId="{FF1C5E51-A8ED-4011-9A8E-E79933252A52}" dt="2022-06-26T14:42:13.931" v="57" actId="20577"/>
          <ac:spMkLst>
            <pc:docMk/>
            <pc:sldMk cId="1031857953" sldId="258"/>
            <ac:spMk id="15" creationId="{A1B57DC8-84C9-E8E6-3815-C536DD1B29FE}"/>
          </ac:spMkLst>
        </pc:spChg>
        <pc:spChg chg="mod">
          <ac:chgData name="杉山 耀一" userId="f29f29a06448fb82" providerId="LiveId" clId="{FF1C5E51-A8ED-4011-9A8E-E79933252A52}" dt="2022-06-26T14:43:14.943" v="165" actId="1038"/>
          <ac:spMkLst>
            <pc:docMk/>
            <pc:sldMk cId="1031857953" sldId="258"/>
            <ac:spMk id="32" creationId="{7699368E-865E-1EEC-7703-988B37448968}"/>
          </ac:spMkLst>
        </pc:spChg>
        <pc:spChg chg="mod">
          <ac:chgData name="杉山 耀一" userId="f29f29a06448fb82" providerId="LiveId" clId="{FF1C5E51-A8ED-4011-9A8E-E79933252A52}" dt="2022-06-26T14:42:32.076" v="110" actId="1038"/>
          <ac:spMkLst>
            <pc:docMk/>
            <pc:sldMk cId="1031857953" sldId="258"/>
            <ac:spMk id="33" creationId="{46173E64-B852-74F0-3637-58DE30BF42AB}"/>
          </ac:spMkLst>
        </pc:spChg>
        <pc:spChg chg="mod">
          <ac:chgData name="杉山 耀一" userId="f29f29a06448fb82" providerId="LiveId" clId="{FF1C5E51-A8ED-4011-9A8E-E79933252A52}" dt="2022-06-26T14:43:27.207" v="200" actId="1037"/>
          <ac:spMkLst>
            <pc:docMk/>
            <pc:sldMk cId="1031857953" sldId="258"/>
            <ac:spMk id="34" creationId="{3266A9FD-4D4E-91D3-E6FC-E929728DAE38}"/>
          </ac:spMkLst>
        </pc:spChg>
        <pc:spChg chg="mod">
          <ac:chgData name="杉山 耀一" userId="f29f29a06448fb82" providerId="LiveId" clId="{FF1C5E51-A8ED-4011-9A8E-E79933252A52}" dt="2022-06-26T14:43:34.829" v="209" actId="1038"/>
          <ac:spMkLst>
            <pc:docMk/>
            <pc:sldMk cId="1031857953" sldId="258"/>
            <ac:spMk id="35" creationId="{96E65BAE-9592-C0C7-27C5-5B66C87A2C8F}"/>
          </ac:spMkLst>
        </pc:spChg>
        <pc:spChg chg="del">
          <ac:chgData name="杉山 耀一" userId="f29f29a06448fb82" providerId="LiveId" clId="{FF1C5E51-A8ED-4011-9A8E-E79933252A52}" dt="2022-06-26T14:42:51.492" v="122" actId="478"/>
          <ac:spMkLst>
            <pc:docMk/>
            <pc:sldMk cId="1031857953" sldId="258"/>
            <ac:spMk id="36" creationId="{809C8F3E-7472-EF4D-2EFC-2427B389B85C}"/>
          </ac:spMkLst>
        </pc:spChg>
        <pc:spChg chg="mod">
          <ac:chgData name="杉山 耀一" userId="f29f29a06448fb82" providerId="LiveId" clId="{FF1C5E51-A8ED-4011-9A8E-E79933252A52}" dt="2022-06-26T15:20:29.863" v="327" actId="20577"/>
          <ac:spMkLst>
            <pc:docMk/>
            <pc:sldMk cId="1031857953" sldId="258"/>
            <ac:spMk id="48" creationId="{FA950C33-66F6-A9B1-9F1A-C36804A2BF47}"/>
          </ac:spMkLst>
        </pc:spChg>
        <pc:spChg chg="del">
          <ac:chgData name="杉山 耀一" userId="f29f29a06448fb82" providerId="LiveId" clId="{FF1C5E51-A8ED-4011-9A8E-E79933252A52}" dt="2022-06-26T14:57:19.319" v="249" actId="478"/>
          <ac:spMkLst>
            <pc:docMk/>
            <pc:sldMk cId="1031857953" sldId="258"/>
            <ac:spMk id="55" creationId="{08CD9CE3-6CF4-30EC-7B12-3F779E6A2CE8}"/>
          </ac:spMkLst>
        </pc:spChg>
        <pc:spChg chg="del">
          <ac:chgData name="杉山 耀一" userId="f29f29a06448fb82" providerId="LiveId" clId="{FF1C5E51-A8ED-4011-9A8E-E79933252A52}" dt="2022-06-26T14:57:22.829" v="250" actId="478"/>
          <ac:spMkLst>
            <pc:docMk/>
            <pc:sldMk cId="1031857953" sldId="258"/>
            <ac:spMk id="56" creationId="{25E353C3-E4E6-B749-80C3-DD4800B3951C}"/>
          </ac:spMkLst>
        </pc:spChg>
        <pc:spChg chg="del">
          <ac:chgData name="杉山 耀一" userId="f29f29a06448fb82" providerId="LiveId" clId="{FF1C5E51-A8ED-4011-9A8E-E79933252A52}" dt="2022-06-26T14:57:27.149" v="251" actId="478"/>
          <ac:spMkLst>
            <pc:docMk/>
            <pc:sldMk cId="1031857953" sldId="258"/>
            <ac:spMk id="57" creationId="{D243FE57-F36E-FDF6-A764-99EAB605ED52}"/>
          </ac:spMkLst>
        </pc:spChg>
        <pc:spChg chg="del">
          <ac:chgData name="杉山 耀一" userId="f29f29a06448fb82" providerId="LiveId" clId="{FF1C5E51-A8ED-4011-9A8E-E79933252A52}" dt="2022-06-26T14:57:32.239" v="252" actId="478"/>
          <ac:spMkLst>
            <pc:docMk/>
            <pc:sldMk cId="1031857953" sldId="258"/>
            <ac:spMk id="58" creationId="{C1FB518B-2B49-F5B6-C55D-A6A18AD0A890}"/>
          </ac:spMkLst>
        </pc:spChg>
        <pc:spChg chg="del">
          <ac:chgData name="杉山 耀一" userId="f29f29a06448fb82" providerId="LiveId" clId="{FF1C5E51-A8ED-4011-9A8E-E79933252A52}" dt="2022-06-26T14:57:36.099" v="253" actId="478"/>
          <ac:spMkLst>
            <pc:docMk/>
            <pc:sldMk cId="1031857953" sldId="258"/>
            <ac:spMk id="59" creationId="{B8C6F177-15E9-7F1A-693B-442A6615C742}"/>
          </ac:spMkLst>
        </pc:spChg>
        <pc:spChg chg="del">
          <ac:chgData name="杉山 耀一" userId="f29f29a06448fb82" providerId="LiveId" clId="{FF1C5E51-A8ED-4011-9A8E-E79933252A52}" dt="2022-06-26T14:57:39.609" v="254" actId="478"/>
          <ac:spMkLst>
            <pc:docMk/>
            <pc:sldMk cId="1031857953" sldId="258"/>
            <ac:spMk id="64" creationId="{1601639E-9C4C-A5E1-9CFA-17D2509AAD79}"/>
          </ac:spMkLst>
        </pc:spChg>
        <pc:spChg chg="add mod">
          <ac:chgData name="杉山 耀一" userId="f29f29a06448fb82" providerId="LiveId" clId="{FF1C5E51-A8ED-4011-9A8E-E79933252A52}" dt="2022-06-26T14:58:29.310" v="256" actId="164"/>
          <ac:spMkLst>
            <pc:docMk/>
            <pc:sldMk cId="1031857953" sldId="258"/>
            <ac:spMk id="69" creationId="{1E36B11D-1679-3B9F-662C-3FF5B53DB71E}"/>
          </ac:spMkLst>
        </pc:spChg>
        <pc:spChg chg="add mod">
          <ac:chgData name="杉山 耀一" userId="f29f29a06448fb82" providerId="LiveId" clId="{FF1C5E51-A8ED-4011-9A8E-E79933252A52}" dt="2022-06-26T14:58:29.310" v="256" actId="164"/>
          <ac:spMkLst>
            <pc:docMk/>
            <pc:sldMk cId="1031857953" sldId="258"/>
            <ac:spMk id="70" creationId="{812621B7-9DF0-9DB6-0D98-89B6491DE4BA}"/>
          </ac:spMkLst>
        </pc:spChg>
        <pc:spChg chg="add mod">
          <ac:chgData name="杉山 耀一" userId="f29f29a06448fb82" providerId="LiveId" clId="{FF1C5E51-A8ED-4011-9A8E-E79933252A52}" dt="2022-06-26T14:58:29.310" v="256" actId="164"/>
          <ac:spMkLst>
            <pc:docMk/>
            <pc:sldMk cId="1031857953" sldId="258"/>
            <ac:spMk id="71" creationId="{2A9D66B5-5B7F-26A1-2AA3-5972CD13D50A}"/>
          </ac:spMkLst>
        </pc:spChg>
        <pc:spChg chg="add mod">
          <ac:chgData name="杉山 耀一" userId="f29f29a06448fb82" providerId="LiveId" clId="{FF1C5E51-A8ED-4011-9A8E-E79933252A52}" dt="2022-06-26T14:58:29.310" v="256" actId="164"/>
          <ac:spMkLst>
            <pc:docMk/>
            <pc:sldMk cId="1031857953" sldId="258"/>
            <ac:spMk id="72" creationId="{7F1F296D-4D81-940A-07F1-9D4E548EE1F9}"/>
          </ac:spMkLst>
        </pc:spChg>
        <pc:spChg chg="add mod">
          <ac:chgData name="杉山 耀一" userId="f29f29a06448fb82" providerId="LiveId" clId="{FF1C5E51-A8ED-4011-9A8E-E79933252A52}" dt="2022-06-26T14:59:13.043" v="265" actId="1076"/>
          <ac:spMkLst>
            <pc:docMk/>
            <pc:sldMk cId="1031857953" sldId="258"/>
            <ac:spMk id="73" creationId="{D9798937-A2A3-19B4-E441-AC1EE88147B3}"/>
          </ac:spMkLst>
        </pc:spChg>
        <pc:grpChg chg="add mod">
          <ac:chgData name="杉山 耀一" userId="f29f29a06448fb82" providerId="LiveId" clId="{FF1C5E51-A8ED-4011-9A8E-E79933252A52}" dt="2022-06-26T14:58:57.615" v="263" actId="1076"/>
          <ac:grpSpMkLst>
            <pc:docMk/>
            <pc:sldMk cId="1031857953" sldId="258"/>
            <ac:grpSpMk id="13" creationId="{8511B1B1-53ED-1830-8352-55EEE66459F2}"/>
          </ac:grpSpMkLst>
        </pc:grpChg>
        <pc:grpChg chg="mod">
          <ac:chgData name="杉山 耀一" userId="f29f29a06448fb82" providerId="LiveId" clId="{FF1C5E51-A8ED-4011-9A8E-E79933252A52}" dt="2022-06-26T14:58:43.880" v="262" actId="1076"/>
          <ac:grpSpMkLst>
            <pc:docMk/>
            <pc:sldMk cId="1031857953" sldId="258"/>
            <ac:grpSpMk id="52" creationId="{ACFF76ED-8D51-37E6-22C1-B71FBEBF7E0B}"/>
          </ac:grpSpMkLst>
        </pc:grpChg>
        <pc:graphicFrameChg chg="modGraphic">
          <ac:chgData name="杉山 耀一" userId="f29f29a06448fb82" providerId="LiveId" clId="{FF1C5E51-A8ED-4011-9A8E-E79933252A52}" dt="2022-06-26T14:46:20.355" v="232" actId="14734"/>
          <ac:graphicFrameMkLst>
            <pc:docMk/>
            <pc:sldMk cId="1031857953" sldId="258"/>
            <ac:graphicFrameMk id="31" creationId="{BADFDA87-3390-F847-9BD8-1574D2C5C787}"/>
          </ac:graphicFrameMkLst>
        </pc:graphicFrameChg>
        <pc:graphicFrameChg chg="del">
          <ac:chgData name="杉山 耀一" userId="f29f29a06448fb82" providerId="LiveId" clId="{FF1C5E51-A8ED-4011-9A8E-E79933252A52}" dt="2022-06-26T14:59:23.979" v="266" actId="478"/>
          <ac:graphicFrameMkLst>
            <pc:docMk/>
            <pc:sldMk cId="1031857953" sldId="258"/>
            <ac:graphicFrameMk id="66" creationId="{E48A8F21-8671-EE3C-CE93-A6227D02ABB1}"/>
          </ac:graphicFrameMkLst>
        </pc:graphicFrameChg>
        <pc:graphicFrameChg chg="add mod modGraphic">
          <ac:chgData name="杉山 耀一" userId="f29f29a06448fb82" providerId="LiveId" clId="{FF1C5E51-A8ED-4011-9A8E-E79933252A52}" dt="2022-06-26T15:20:47.899" v="329" actId="20577"/>
          <ac:graphicFrameMkLst>
            <pc:docMk/>
            <pc:sldMk cId="1031857953" sldId="258"/>
            <ac:graphicFrameMk id="74" creationId="{94646C71-9EB9-DFEF-2E8A-2468F8389FF7}"/>
          </ac:graphicFrameMkLst>
        </pc:graphicFrameChg>
        <pc:picChg chg="add del mod ord">
          <ac:chgData name="杉山 耀一" userId="f29f29a06448fb82" providerId="LiveId" clId="{FF1C5E51-A8ED-4011-9A8E-E79933252A52}" dt="2022-06-26T14:34:39.594" v="28" actId="478"/>
          <ac:picMkLst>
            <pc:docMk/>
            <pc:sldMk cId="1031857953" sldId="258"/>
            <ac:picMk id="3" creationId="{CC7DDC66-FA2B-7FC0-A70E-E5BC69C2FEBC}"/>
          </ac:picMkLst>
        </pc:picChg>
        <pc:picChg chg="add del mod ord">
          <ac:chgData name="杉山 耀一" userId="f29f29a06448fb82" providerId="LiveId" clId="{FF1C5E51-A8ED-4011-9A8E-E79933252A52}" dt="2022-06-26T14:41:14.288" v="43" actId="478"/>
          <ac:picMkLst>
            <pc:docMk/>
            <pc:sldMk cId="1031857953" sldId="258"/>
            <ac:picMk id="7" creationId="{86DA0076-A411-2A29-FFA0-EC67620F4156}"/>
          </ac:picMkLst>
        </pc:picChg>
        <pc:picChg chg="add mod ord">
          <ac:chgData name="杉山 耀一" userId="f29f29a06448fb82" providerId="LiveId" clId="{FF1C5E51-A8ED-4011-9A8E-E79933252A52}" dt="2022-06-26T14:56:46.709" v="239" actId="1076"/>
          <ac:picMkLst>
            <pc:docMk/>
            <pc:sldMk cId="1031857953" sldId="258"/>
            <ac:picMk id="12" creationId="{70B065F5-9E20-F5C3-9E9B-9F4C9F8D9637}"/>
          </ac:picMkLst>
        </pc:picChg>
        <pc:picChg chg="add mod ord">
          <ac:chgData name="杉山 耀一" userId="f29f29a06448fb82" providerId="LiveId" clId="{FF1C5E51-A8ED-4011-9A8E-E79933252A52}" dt="2022-06-26T15:20:07.992" v="319" actId="1076"/>
          <ac:picMkLst>
            <pc:docMk/>
            <pc:sldMk cId="1031857953" sldId="258"/>
            <ac:picMk id="18" creationId="{45A4939D-A6FC-42C7-F747-0982518DAE12}"/>
          </ac:picMkLst>
        </pc:picChg>
        <pc:picChg chg="del mod">
          <ac:chgData name="杉山 耀一" userId="f29f29a06448fb82" providerId="LiveId" clId="{FF1C5E51-A8ED-4011-9A8E-E79933252A52}" dt="2022-06-26T14:34:34.454" v="27" actId="478"/>
          <ac:picMkLst>
            <pc:docMk/>
            <pc:sldMk cId="1031857953" sldId="258"/>
            <ac:picMk id="24" creationId="{EC9B92BA-AADF-518C-EFBA-5813A018DA88}"/>
          </ac:picMkLst>
        </pc:picChg>
        <pc:picChg chg="del mod">
          <ac:chgData name="杉山 耀一" userId="f29f29a06448fb82" providerId="LiveId" clId="{FF1C5E51-A8ED-4011-9A8E-E79933252A52}" dt="2022-06-26T14:56:30.779" v="233" actId="478"/>
          <ac:picMkLst>
            <pc:docMk/>
            <pc:sldMk cId="1031857953" sldId="258"/>
            <ac:picMk id="45" creationId="{428AB042-AC4E-5FD1-7322-1EBA524A2DAC}"/>
          </ac:picMkLst>
        </pc:picChg>
        <pc:picChg chg="add del mod ord">
          <ac:chgData name="杉山 耀一" userId="f29f29a06448fb82" providerId="LiveId" clId="{FF1C5E51-A8ED-4011-9A8E-E79933252A52}" dt="2022-06-26T15:02:41.494" v="272" actId="478"/>
          <ac:picMkLst>
            <pc:docMk/>
            <pc:sldMk cId="1031857953" sldId="258"/>
            <ac:picMk id="68" creationId="{165AE25D-4650-6A75-27DC-42D61C21F969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cat>
            <c:strRef>
              <c:f>Sheet1!$D$6:$E$6</c:f>
              <c:strCache>
                <c:ptCount val="2"/>
                <c:pt idx="0">
                  <c:v>Neo2</c:v>
                </c:pt>
                <c:pt idx="1">
                  <c:v>Neo</c:v>
                </c:pt>
              </c:strCache>
            </c:strRef>
          </c:cat>
          <c:val>
            <c:numRef>
              <c:f>Sheet1!$D$7:$E$7</c:f>
              <c:numCache>
                <c:formatCode>General</c:formatCode>
                <c:ptCount val="2"/>
                <c:pt idx="0">
                  <c:v>0</c:v>
                </c:pt>
                <c:pt idx="1">
                  <c:v>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AE-44EC-997D-E2A2BF2DBA50}"/>
            </c:ext>
          </c:extLst>
        </c:ser>
        <c:ser>
          <c:idx val="1"/>
          <c:order val="1"/>
          <c:spPr>
            <a:solidFill>
              <a:srgbClr val="2081E0"/>
            </a:solidFill>
            <a:ln>
              <a:noFill/>
            </a:ln>
            <a:effectLst/>
          </c:spPr>
          <c:invertIfNegative val="0"/>
          <c:cat>
            <c:strRef>
              <c:f>Sheet1!$D$6:$E$6</c:f>
              <c:strCache>
                <c:ptCount val="2"/>
                <c:pt idx="0">
                  <c:v>Neo2</c:v>
                </c:pt>
                <c:pt idx="1">
                  <c:v>Neo</c:v>
                </c:pt>
              </c:strCache>
            </c:strRef>
          </c:cat>
          <c:val>
            <c:numRef>
              <c:f>Sheet1!$D$8:$E$8</c:f>
              <c:numCache>
                <c:formatCode>General</c:formatCode>
                <c:ptCount val="2"/>
                <c:pt idx="0">
                  <c:v>6.8</c:v>
                </c:pt>
                <c:pt idx="1">
                  <c:v>11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AE-44EC-997D-E2A2BF2DBA50}"/>
            </c:ext>
          </c:extLst>
        </c:ser>
        <c:ser>
          <c:idx val="2"/>
          <c:order val="2"/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Sheet1!$D$6:$E$6</c:f>
              <c:strCache>
                <c:ptCount val="2"/>
                <c:pt idx="0">
                  <c:v>Neo2</c:v>
                </c:pt>
                <c:pt idx="1">
                  <c:v>Neo</c:v>
                </c:pt>
              </c:strCache>
            </c:strRef>
          </c:cat>
          <c:val>
            <c:numRef>
              <c:f>Sheet1!$D$9:$E$9</c:f>
              <c:numCache>
                <c:formatCode>General</c:formatCode>
                <c:ptCount val="2"/>
                <c:pt idx="0">
                  <c:v>69.7</c:v>
                </c:pt>
                <c:pt idx="1">
                  <c:v>71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0AE-44EC-997D-E2A2BF2DBA50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D$6:$E$6</c:f>
              <c:strCache>
                <c:ptCount val="2"/>
                <c:pt idx="0">
                  <c:v>Neo2</c:v>
                </c:pt>
                <c:pt idx="1">
                  <c:v>Neo</c:v>
                </c:pt>
              </c:strCache>
            </c:strRef>
          </c:cat>
          <c:val>
            <c:numRef>
              <c:f>Sheet1!$D$10:$E$10</c:f>
              <c:numCache>
                <c:formatCode>General</c:formatCode>
                <c:ptCount val="2"/>
                <c:pt idx="0">
                  <c:v>22</c:v>
                </c:pt>
                <c:pt idx="1">
                  <c:v>14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0AE-44EC-997D-E2A2BF2DBA50}"/>
            </c:ext>
          </c:extLst>
        </c:ser>
        <c:ser>
          <c:idx val="4"/>
          <c:order val="4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D$6:$E$6</c:f>
              <c:strCache>
                <c:ptCount val="2"/>
                <c:pt idx="0">
                  <c:v>Neo2</c:v>
                </c:pt>
                <c:pt idx="1">
                  <c:v>Neo</c:v>
                </c:pt>
              </c:strCache>
            </c:strRef>
          </c:cat>
          <c:val>
            <c:numRef>
              <c:f>Sheet1!$D$11:$E$11</c:f>
              <c:numCache>
                <c:formatCode>General</c:formatCode>
                <c:ptCount val="2"/>
                <c:pt idx="0">
                  <c:v>1.5</c:v>
                </c:pt>
                <c:pt idx="1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0AE-44EC-997D-E2A2BF2DBA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100"/>
        <c:axId val="548602928"/>
        <c:axId val="548592368"/>
      </c:barChart>
      <c:catAx>
        <c:axId val="54860292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48592368"/>
        <c:crosses val="autoZero"/>
        <c:auto val="1"/>
        <c:lblAlgn val="ctr"/>
        <c:lblOffset val="100"/>
        <c:noMultiLvlLbl val="0"/>
      </c:catAx>
      <c:valAx>
        <c:axId val="548592368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548602928"/>
        <c:crosses val="autoZero"/>
        <c:crossBetween val="between"/>
        <c:majorUnit val="10"/>
        <c:min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18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B84C-44BA-90D0-C37FD2830670}"/>
              </c:ext>
            </c:extLst>
          </c:dPt>
          <c:dPt>
            <c:idx val="19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B84C-44BA-90D0-C37FD2830670}"/>
              </c:ext>
            </c:extLst>
          </c:dPt>
          <c:xVal>
            <c:numRef>
              <c:f>Sheet1!$B$3:$B$22</c:f>
              <c:numCache>
                <c:formatCode>General</c:formatCode>
                <c:ptCount val="20"/>
                <c:pt idx="0">
                  <c:v>1.74</c:v>
                </c:pt>
                <c:pt idx="1">
                  <c:v>1.24</c:v>
                </c:pt>
                <c:pt idx="2">
                  <c:v>2.44</c:v>
                </c:pt>
                <c:pt idx="3">
                  <c:v>0.88</c:v>
                </c:pt>
                <c:pt idx="4">
                  <c:v>0.78</c:v>
                </c:pt>
                <c:pt idx="5">
                  <c:v>0.99</c:v>
                </c:pt>
                <c:pt idx="6">
                  <c:v>1.21</c:v>
                </c:pt>
                <c:pt idx="7">
                  <c:v>0.72</c:v>
                </c:pt>
                <c:pt idx="8">
                  <c:v>2.02</c:v>
                </c:pt>
                <c:pt idx="9">
                  <c:v>1</c:v>
                </c:pt>
                <c:pt idx="10">
                  <c:v>0.94</c:v>
                </c:pt>
                <c:pt idx="11">
                  <c:v>1.05</c:v>
                </c:pt>
                <c:pt idx="12">
                  <c:v>1.25</c:v>
                </c:pt>
                <c:pt idx="13">
                  <c:v>0.79</c:v>
                </c:pt>
                <c:pt idx="14">
                  <c:v>1.96</c:v>
                </c:pt>
                <c:pt idx="15">
                  <c:v>1.01</c:v>
                </c:pt>
                <c:pt idx="16">
                  <c:v>0.92</c:v>
                </c:pt>
                <c:pt idx="17">
                  <c:v>1.1100000000000001</c:v>
                </c:pt>
                <c:pt idx="18">
                  <c:v>1</c:v>
                </c:pt>
                <c:pt idx="19">
                  <c:v>1</c:v>
                </c:pt>
              </c:numCache>
            </c:numRef>
          </c:xVal>
          <c:yVal>
            <c:numRef>
              <c:f>Sheet1!$C$3:$C$22</c:f>
              <c:numCache>
                <c:formatCode>General</c:formatCode>
                <c:ptCount val="20"/>
                <c:pt idx="1">
                  <c:v>6</c:v>
                </c:pt>
                <c:pt idx="2">
                  <c:v>6</c:v>
                </c:pt>
                <c:pt idx="4">
                  <c:v>5</c:v>
                </c:pt>
                <c:pt idx="5">
                  <c:v>5</c:v>
                </c:pt>
                <c:pt idx="7">
                  <c:v>4</c:v>
                </c:pt>
                <c:pt idx="8">
                  <c:v>4</c:v>
                </c:pt>
                <c:pt idx="10">
                  <c:v>3</c:v>
                </c:pt>
                <c:pt idx="11">
                  <c:v>3</c:v>
                </c:pt>
                <c:pt idx="13">
                  <c:v>2</c:v>
                </c:pt>
                <c:pt idx="14">
                  <c:v>2</c:v>
                </c:pt>
                <c:pt idx="16">
                  <c:v>1</c:v>
                </c:pt>
                <c:pt idx="17">
                  <c:v>1</c:v>
                </c:pt>
                <c:pt idx="18">
                  <c:v>7</c:v>
                </c:pt>
                <c:pt idx="1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B84C-44BA-90D0-C37FD2830670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3:$B$22</c:f>
              <c:numCache>
                <c:formatCode>General</c:formatCode>
                <c:ptCount val="20"/>
                <c:pt idx="0">
                  <c:v>1.74</c:v>
                </c:pt>
                <c:pt idx="1">
                  <c:v>1.24</c:v>
                </c:pt>
                <c:pt idx="2">
                  <c:v>2.44</c:v>
                </c:pt>
                <c:pt idx="3">
                  <c:v>0.88</c:v>
                </c:pt>
                <c:pt idx="4">
                  <c:v>0.78</c:v>
                </c:pt>
                <c:pt idx="5">
                  <c:v>0.99</c:v>
                </c:pt>
                <c:pt idx="6">
                  <c:v>1.21</c:v>
                </c:pt>
                <c:pt idx="7">
                  <c:v>0.72</c:v>
                </c:pt>
                <c:pt idx="8">
                  <c:v>2.02</c:v>
                </c:pt>
                <c:pt idx="9">
                  <c:v>1</c:v>
                </c:pt>
                <c:pt idx="10">
                  <c:v>0.94</c:v>
                </c:pt>
                <c:pt idx="11">
                  <c:v>1.05</c:v>
                </c:pt>
                <c:pt idx="12">
                  <c:v>1.25</c:v>
                </c:pt>
                <c:pt idx="13">
                  <c:v>0.79</c:v>
                </c:pt>
                <c:pt idx="14">
                  <c:v>1.96</c:v>
                </c:pt>
                <c:pt idx="15">
                  <c:v>1.01</c:v>
                </c:pt>
                <c:pt idx="16">
                  <c:v>0.92</c:v>
                </c:pt>
                <c:pt idx="17">
                  <c:v>1.1100000000000001</c:v>
                </c:pt>
                <c:pt idx="18">
                  <c:v>1</c:v>
                </c:pt>
                <c:pt idx="19">
                  <c:v>1</c:v>
                </c:pt>
              </c:numCache>
            </c:numRef>
          </c:xVal>
          <c:yVal>
            <c:numRef>
              <c:f>Sheet1!$D$3:$D$22</c:f>
              <c:numCache>
                <c:formatCode>General</c:formatCode>
                <c:ptCount val="20"/>
                <c:pt idx="0">
                  <c:v>6</c:v>
                </c:pt>
                <c:pt idx="3">
                  <c:v>5</c:v>
                </c:pt>
                <c:pt idx="6">
                  <c:v>4</c:v>
                </c:pt>
                <c:pt idx="9">
                  <c:v>3</c:v>
                </c:pt>
                <c:pt idx="12">
                  <c:v>2</c:v>
                </c:pt>
                <c:pt idx="15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84C-44BA-90D0-C37FD28306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14823904"/>
        <c:axId val="1614776864"/>
      </c:scatterChart>
      <c:valAx>
        <c:axId val="1614823904"/>
        <c:scaling>
          <c:logBase val="10"/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614776864"/>
        <c:crosses val="autoZero"/>
        <c:crossBetween val="midCat"/>
      </c:valAx>
      <c:valAx>
        <c:axId val="1614776864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6148239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18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3AEC-4B34-B70E-4E4D12E1B2A3}"/>
              </c:ext>
            </c:extLst>
          </c:dPt>
          <c:dPt>
            <c:idx val="19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3AEC-4B34-B70E-4E4D12E1B2A3}"/>
              </c:ext>
            </c:extLst>
          </c:dPt>
          <c:xVal>
            <c:numRef>
              <c:f>Sheet1!$B$26:$B$45</c:f>
              <c:numCache>
                <c:formatCode>General</c:formatCode>
                <c:ptCount val="20"/>
                <c:pt idx="0">
                  <c:v>0.51</c:v>
                </c:pt>
                <c:pt idx="1">
                  <c:v>0.31</c:v>
                </c:pt>
                <c:pt idx="2">
                  <c:v>0.84</c:v>
                </c:pt>
                <c:pt idx="3">
                  <c:v>1.03</c:v>
                </c:pt>
                <c:pt idx="4">
                  <c:v>1.02</c:v>
                </c:pt>
                <c:pt idx="5">
                  <c:v>1.04</c:v>
                </c:pt>
                <c:pt idx="6">
                  <c:v>1.08</c:v>
                </c:pt>
                <c:pt idx="7">
                  <c:v>0.54</c:v>
                </c:pt>
                <c:pt idx="8">
                  <c:v>2.14</c:v>
                </c:pt>
                <c:pt idx="9">
                  <c:v>1</c:v>
                </c:pt>
                <c:pt idx="10">
                  <c:v>0.95</c:v>
                </c:pt>
                <c:pt idx="11">
                  <c:v>1.04</c:v>
                </c:pt>
                <c:pt idx="12">
                  <c:v>0.82</c:v>
                </c:pt>
                <c:pt idx="13">
                  <c:v>0.36</c:v>
                </c:pt>
                <c:pt idx="14">
                  <c:v>1.87</c:v>
                </c:pt>
                <c:pt idx="15">
                  <c:v>0.94</c:v>
                </c:pt>
                <c:pt idx="16">
                  <c:v>0.85</c:v>
                </c:pt>
                <c:pt idx="17">
                  <c:v>1.04</c:v>
                </c:pt>
                <c:pt idx="18">
                  <c:v>1</c:v>
                </c:pt>
                <c:pt idx="19">
                  <c:v>1</c:v>
                </c:pt>
              </c:numCache>
            </c:numRef>
          </c:xVal>
          <c:yVal>
            <c:numRef>
              <c:f>Sheet1!$C$26:$C$45</c:f>
              <c:numCache>
                <c:formatCode>General</c:formatCode>
                <c:ptCount val="20"/>
                <c:pt idx="1">
                  <c:v>6</c:v>
                </c:pt>
                <c:pt idx="2">
                  <c:v>6</c:v>
                </c:pt>
                <c:pt idx="4">
                  <c:v>5</c:v>
                </c:pt>
                <c:pt idx="5">
                  <c:v>5</c:v>
                </c:pt>
                <c:pt idx="7">
                  <c:v>4</c:v>
                </c:pt>
                <c:pt idx="8">
                  <c:v>4</c:v>
                </c:pt>
                <c:pt idx="10">
                  <c:v>3</c:v>
                </c:pt>
                <c:pt idx="11">
                  <c:v>3</c:v>
                </c:pt>
                <c:pt idx="13">
                  <c:v>2</c:v>
                </c:pt>
                <c:pt idx="14">
                  <c:v>2</c:v>
                </c:pt>
                <c:pt idx="16">
                  <c:v>1</c:v>
                </c:pt>
                <c:pt idx="17">
                  <c:v>1</c:v>
                </c:pt>
                <c:pt idx="18">
                  <c:v>7</c:v>
                </c:pt>
                <c:pt idx="1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3AEC-4B34-B70E-4E4D12E1B2A3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26:$B$45</c:f>
              <c:numCache>
                <c:formatCode>General</c:formatCode>
                <c:ptCount val="20"/>
                <c:pt idx="0">
                  <c:v>0.51</c:v>
                </c:pt>
                <c:pt idx="1">
                  <c:v>0.31</c:v>
                </c:pt>
                <c:pt idx="2">
                  <c:v>0.84</c:v>
                </c:pt>
                <c:pt idx="3">
                  <c:v>1.03</c:v>
                </c:pt>
                <c:pt idx="4">
                  <c:v>1.02</c:v>
                </c:pt>
                <c:pt idx="5">
                  <c:v>1.04</c:v>
                </c:pt>
                <c:pt idx="6">
                  <c:v>1.08</c:v>
                </c:pt>
                <c:pt idx="7">
                  <c:v>0.54</c:v>
                </c:pt>
                <c:pt idx="8">
                  <c:v>2.14</c:v>
                </c:pt>
                <c:pt idx="9">
                  <c:v>1</c:v>
                </c:pt>
                <c:pt idx="10">
                  <c:v>0.95</c:v>
                </c:pt>
                <c:pt idx="11">
                  <c:v>1.04</c:v>
                </c:pt>
                <c:pt idx="12">
                  <c:v>0.82</c:v>
                </c:pt>
                <c:pt idx="13">
                  <c:v>0.36</c:v>
                </c:pt>
                <c:pt idx="14">
                  <c:v>1.87</c:v>
                </c:pt>
                <c:pt idx="15">
                  <c:v>0.94</c:v>
                </c:pt>
                <c:pt idx="16">
                  <c:v>0.85</c:v>
                </c:pt>
                <c:pt idx="17">
                  <c:v>1.04</c:v>
                </c:pt>
                <c:pt idx="18">
                  <c:v>1</c:v>
                </c:pt>
                <c:pt idx="19">
                  <c:v>1</c:v>
                </c:pt>
              </c:numCache>
            </c:numRef>
          </c:xVal>
          <c:yVal>
            <c:numRef>
              <c:f>Sheet1!$D$26:$D$45</c:f>
              <c:numCache>
                <c:formatCode>General</c:formatCode>
                <c:ptCount val="20"/>
                <c:pt idx="0">
                  <c:v>6</c:v>
                </c:pt>
                <c:pt idx="3">
                  <c:v>5</c:v>
                </c:pt>
                <c:pt idx="6">
                  <c:v>4</c:v>
                </c:pt>
                <c:pt idx="9">
                  <c:v>3</c:v>
                </c:pt>
                <c:pt idx="12">
                  <c:v>2</c:v>
                </c:pt>
                <c:pt idx="15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AEC-4B34-B70E-4E4D12E1B2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73299856"/>
        <c:axId val="1973285936"/>
      </c:scatterChart>
      <c:valAx>
        <c:axId val="1973299856"/>
        <c:scaling>
          <c:logBase val="10"/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973285936"/>
        <c:crosses val="autoZero"/>
        <c:crossBetween val="midCat"/>
      </c:valAx>
      <c:valAx>
        <c:axId val="1973285936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9732998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1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F0B8-43C1-908B-3C228EE0EE7D}"/>
              </c:ext>
            </c:extLst>
          </c:dPt>
          <c:dPt>
            <c:idx val="22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F0B8-43C1-908B-3C228EE0EE7D}"/>
              </c:ext>
            </c:extLst>
          </c:dPt>
          <c:xVal>
            <c:numRef>
              <c:f>Sheet1!$B$49:$B$71</c:f>
              <c:numCache>
                <c:formatCode>General</c:formatCode>
                <c:ptCount val="23"/>
                <c:pt idx="0">
                  <c:v>1.68</c:v>
                </c:pt>
                <c:pt idx="1">
                  <c:v>1.21</c:v>
                </c:pt>
                <c:pt idx="2">
                  <c:v>2.34</c:v>
                </c:pt>
                <c:pt idx="3">
                  <c:v>1.1100000000000001</c:v>
                </c:pt>
                <c:pt idx="4">
                  <c:v>0.54</c:v>
                </c:pt>
                <c:pt idx="5">
                  <c:v>2.27</c:v>
                </c:pt>
                <c:pt idx="6">
                  <c:v>0.53</c:v>
                </c:pt>
                <c:pt idx="7">
                  <c:v>0.33</c:v>
                </c:pt>
                <c:pt idx="8">
                  <c:v>0.86</c:v>
                </c:pt>
                <c:pt idx="9">
                  <c:v>0.99</c:v>
                </c:pt>
                <c:pt idx="10">
                  <c:v>0.59</c:v>
                </c:pt>
                <c:pt idx="11">
                  <c:v>1.67</c:v>
                </c:pt>
                <c:pt idx="12">
                  <c:v>1</c:v>
                </c:pt>
                <c:pt idx="13">
                  <c:v>0.95</c:v>
                </c:pt>
                <c:pt idx="14">
                  <c:v>1.06</c:v>
                </c:pt>
                <c:pt idx="15">
                  <c:v>1.49</c:v>
                </c:pt>
                <c:pt idx="16">
                  <c:v>0.99</c:v>
                </c:pt>
                <c:pt idx="17">
                  <c:v>2.2400000000000002</c:v>
                </c:pt>
                <c:pt idx="18">
                  <c:v>1.03</c:v>
                </c:pt>
                <c:pt idx="19">
                  <c:v>0.93</c:v>
                </c:pt>
                <c:pt idx="20">
                  <c:v>1.1299999999999999</c:v>
                </c:pt>
                <c:pt idx="21">
                  <c:v>1</c:v>
                </c:pt>
                <c:pt idx="22">
                  <c:v>1</c:v>
                </c:pt>
              </c:numCache>
            </c:numRef>
          </c:xVal>
          <c:yVal>
            <c:numRef>
              <c:f>Sheet1!$C$49:$C$71</c:f>
              <c:numCache>
                <c:formatCode>General</c:formatCode>
                <c:ptCount val="23"/>
                <c:pt idx="1">
                  <c:v>7</c:v>
                </c:pt>
                <c:pt idx="2">
                  <c:v>7</c:v>
                </c:pt>
                <c:pt idx="4">
                  <c:v>6</c:v>
                </c:pt>
                <c:pt idx="5">
                  <c:v>6</c:v>
                </c:pt>
                <c:pt idx="7">
                  <c:v>5</c:v>
                </c:pt>
                <c:pt idx="8">
                  <c:v>5</c:v>
                </c:pt>
                <c:pt idx="10">
                  <c:v>4</c:v>
                </c:pt>
                <c:pt idx="11">
                  <c:v>4</c:v>
                </c:pt>
                <c:pt idx="13">
                  <c:v>3</c:v>
                </c:pt>
                <c:pt idx="14">
                  <c:v>3</c:v>
                </c:pt>
                <c:pt idx="16">
                  <c:v>2</c:v>
                </c:pt>
                <c:pt idx="17">
                  <c:v>2</c:v>
                </c:pt>
                <c:pt idx="19">
                  <c:v>1</c:v>
                </c:pt>
                <c:pt idx="20">
                  <c:v>1</c:v>
                </c:pt>
                <c:pt idx="21">
                  <c:v>8</c:v>
                </c:pt>
                <c:pt idx="2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F0B8-43C1-908B-3C228EE0EE7D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49:$B$71</c:f>
              <c:numCache>
                <c:formatCode>General</c:formatCode>
                <c:ptCount val="23"/>
                <c:pt idx="0">
                  <c:v>1.68</c:v>
                </c:pt>
                <c:pt idx="1">
                  <c:v>1.21</c:v>
                </c:pt>
                <c:pt idx="2">
                  <c:v>2.34</c:v>
                </c:pt>
                <c:pt idx="3">
                  <c:v>1.1100000000000001</c:v>
                </c:pt>
                <c:pt idx="4">
                  <c:v>0.54</c:v>
                </c:pt>
                <c:pt idx="5">
                  <c:v>2.27</c:v>
                </c:pt>
                <c:pt idx="6">
                  <c:v>0.53</c:v>
                </c:pt>
                <c:pt idx="7">
                  <c:v>0.33</c:v>
                </c:pt>
                <c:pt idx="8">
                  <c:v>0.86</c:v>
                </c:pt>
                <c:pt idx="9">
                  <c:v>0.99</c:v>
                </c:pt>
                <c:pt idx="10">
                  <c:v>0.59</c:v>
                </c:pt>
                <c:pt idx="11">
                  <c:v>1.67</c:v>
                </c:pt>
                <c:pt idx="12">
                  <c:v>1</c:v>
                </c:pt>
                <c:pt idx="13">
                  <c:v>0.95</c:v>
                </c:pt>
                <c:pt idx="14">
                  <c:v>1.06</c:v>
                </c:pt>
                <c:pt idx="15">
                  <c:v>1.49</c:v>
                </c:pt>
                <c:pt idx="16">
                  <c:v>0.99</c:v>
                </c:pt>
                <c:pt idx="17">
                  <c:v>2.2400000000000002</c:v>
                </c:pt>
                <c:pt idx="18">
                  <c:v>1.03</c:v>
                </c:pt>
                <c:pt idx="19">
                  <c:v>0.93</c:v>
                </c:pt>
                <c:pt idx="20">
                  <c:v>1.1299999999999999</c:v>
                </c:pt>
                <c:pt idx="21">
                  <c:v>1</c:v>
                </c:pt>
                <c:pt idx="22">
                  <c:v>1</c:v>
                </c:pt>
              </c:numCache>
            </c:numRef>
          </c:xVal>
          <c:yVal>
            <c:numRef>
              <c:f>Sheet1!$D$49:$D$71</c:f>
              <c:numCache>
                <c:formatCode>General</c:formatCode>
                <c:ptCount val="23"/>
                <c:pt idx="0">
                  <c:v>7</c:v>
                </c:pt>
                <c:pt idx="3">
                  <c:v>6</c:v>
                </c:pt>
                <c:pt idx="6">
                  <c:v>5</c:v>
                </c:pt>
                <c:pt idx="9">
                  <c:v>4</c:v>
                </c:pt>
                <c:pt idx="12">
                  <c:v>3</c:v>
                </c:pt>
                <c:pt idx="15">
                  <c:v>2</c:v>
                </c:pt>
                <c:pt idx="18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F0B8-43C1-908B-3C228EE0EE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73313296"/>
        <c:axId val="1973310416"/>
      </c:scatterChart>
      <c:valAx>
        <c:axId val="1973313296"/>
        <c:scaling>
          <c:logBase val="10"/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973310416"/>
        <c:crosses val="autoZero"/>
        <c:crossBetween val="midCat"/>
      </c:valAx>
      <c:valAx>
        <c:axId val="1973310416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9733132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1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26F6-4CE6-897F-A5BBFD1A3497}"/>
              </c:ext>
            </c:extLst>
          </c:dPt>
          <c:dPt>
            <c:idx val="22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26F6-4CE6-897F-A5BBFD1A3497}"/>
              </c:ext>
            </c:extLst>
          </c:dPt>
          <c:xVal>
            <c:numRef>
              <c:f>Sheet1!$B$74:$B$96</c:f>
              <c:numCache>
                <c:formatCode>General</c:formatCode>
                <c:ptCount val="23"/>
                <c:pt idx="0">
                  <c:v>0.59</c:v>
                </c:pt>
                <c:pt idx="1">
                  <c:v>0.37</c:v>
                </c:pt>
                <c:pt idx="2">
                  <c:v>0.93</c:v>
                </c:pt>
                <c:pt idx="3">
                  <c:v>0.91</c:v>
                </c:pt>
                <c:pt idx="4">
                  <c:v>0.52</c:v>
                </c:pt>
                <c:pt idx="5">
                  <c:v>1.6</c:v>
                </c:pt>
                <c:pt idx="6">
                  <c:v>2.19</c:v>
                </c:pt>
                <c:pt idx="7">
                  <c:v>1.52</c:v>
                </c:pt>
                <c:pt idx="8">
                  <c:v>3.17</c:v>
                </c:pt>
                <c:pt idx="9">
                  <c:v>1.41</c:v>
                </c:pt>
                <c:pt idx="10">
                  <c:v>0.82</c:v>
                </c:pt>
                <c:pt idx="11">
                  <c:v>2.4</c:v>
                </c:pt>
                <c:pt idx="12">
                  <c:v>1.01</c:v>
                </c:pt>
                <c:pt idx="13">
                  <c:v>0.96</c:v>
                </c:pt>
                <c:pt idx="14">
                  <c:v>1.05</c:v>
                </c:pt>
                <c:pt idx="15">
                  <c:v>0.69</c:v>
                </c:pt>
                <c:pt idx="16">
                  <c:v>0.32</c:v>
                </c:pt>
                <c:pt idx="17">
                  <c:v>1.46</c:v>
                </c:pt>
                <c:pt idx="18">
                  <c:v>0.96</c:v>
                </c:pt>
                <c:pt idx="19">
                  <c:v>0.88</c:v>
                </c:pt>
                <c:pt idx="20">
                  <c:v>1.05</c:v>
                </c:pt>
                <c:pt idx="21">
                  <c:v>1</c:v>
                </c:pt>
                <c:pt idx="22">
                  <c:v>1</c:v>
                </c:pt>
              </c:numCache>
            </c:numRef>
          </c:xVal>
          <c:yVal>
            <c:numRef>
              <c:f>Sheet1!$C$74:$C$96</c:f>
              <c:numCache>
                <c:formatCode>General</c:formatCode>
                <c:ptCount val="23"/>
                <c:pt idx="1">
                  <c:v>7</c:v>
                </c:pt>
                <c:pt idx="2">
                  <c:v>7</c:v>
                </c:pt>
                <c:pt idx="4">
                  <c:v>6</c:v>
                </c:pt>
                <c:pt idx="5">
                  <c:v>6</c:v>
                </c:pt>
                <c:pt idx="7">
                  <c:v>5</c:v>
                </c:pt>
                <c:pt idx="8">
                  <c:v>5</c:v>
                </c:pt>
                <c:pt idx="10">
                  <c:v>4</c:v>
                </c:pt>
                <c:pt idx="11">
                  <c:v>4</c:v>
                </c:pt>
                <c:pt idx="13">
                  <c:v>3</c:v>
                </c:pt>
                <c:pt idx="14">
                  <c:v>3</c:v>
                </c:pt>
                <c:pt idx="16">
                  <c:v>2</c:v>
                </c:pt>
                <c:pt idx="17">
                  <c:v>2</c:v>
                </c:pt>
                <c:pt idx="19">
                  <c:v>1</c:v>
                </c:pt>
                <c:pt idx="20">
                  <c:v>1</c:v>
                </c:pt>
                <c:pt idx="21">
                  <c:v>8</c:v>
                </c:pt>
                <c:pt idx="22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6F6-4CE6-897F-A5BBFD1A3497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74:$B$96</c:f>
              <c:numCache>
                <c:formatCode>General</c:formatCode>
                <c:ptCount val="23"/>
                <c:pt idx="0">
                  <c:v>0.59</c:v>
                </c:pt>
                <c:pt idx="1">
                  <c:v>0.37</c:v>
                </c:pt>
                <c:pt idx="2">
                  <c:v>0.93</c:v>
                </c:pt>
                <c:pt idx="3">
                  <c:v>0.91</c:v>
                </c:pt>
                <c:pt idx="4">
                  <c:v>0.52</c:v>
                </c:pt>
                <c:pt idx="5">
                  <c:v>1.6</c:v>
                </c:pt>
                <c:pt idx="6">
                  <c:v>2.19</c:v>
                </c:pt>
                <c:pt idx="7">
                  <c:v>1.52</c:v>
                </c:pt>
                <c:pt idx="8">
                  <c:v>3.17</c:v>
                </c:pt>
                <c:pt idx="9">
                  <c:v>1.41</c:v>
                </c:pt>
                <c:pt idx="10">
                  <c:v>0.82</c:v>
                </c:pt>
                <c:pt idx="11">
                  <c:v>2.4</c:v>
                </c:pt>
                <c:pt idx="12">
                  <c:v>1.01</c:v>
                </c:pt>
                <c:pt idx="13">
                  <c:v>0.96</c:v>
                </c:pt>
                <c:pt idx="14">
                  <c:v>1.05</c:v>
                </c:pt>
                <c:pt idx="15">
                  <c:v>0.69</c:v>
                </c:pt>
                <c:pt idx="16">
                  <c:v>0.32</c:v>
                </c:pt>
                <c:pt idx="17">
                  <c:v>1.46</c:v>
                </c:pt>
                <c:pt idx="18">
                  <c:v>0.96</c:v>
                </c:pt>
                <c:pt idx="19">
                  <c:v>0.88</c:v>
                </c:pt>
                <c:pt idx="20">
                  <c:v>1.05</c:v>
                </c:pt>
                <c:pt idx="21">
                  <c:v>1</c:v>
                </c:pt>
                <c:pt idx="22">
                  <c:v>1</c:v>
                </c:pt>
              </c:numCache>
            </c:numRef>
          </c:xVal>
          <c:yVal>
            <c:numRef>
              <c:f>Sheet1!$D$74:$D$96</c:f>
              <c:numCache>
                <c:formatCode>General</c:formatCode>
                <c:ptCount val="23"/>
                <c:pt idx="0">
                  <c:v>7</c:v>
                </c:pt>
                <c:pt idx="3">
                  <c:v>6</c:v>
                </c:pt>
                <c:pt idx="6">
                  <c:v>5</c:v>
                </c:pt>
                <c:pt idx="9">
                  <c:v>4</c:v>
                </c:pt>
                <c:pt idx="12">
                  <c:v>3</c:v>
                </c:pt>
                <c:pt idx="15">
                  <c:v>2</c:v>
                </c:pt>
                <c:pt idx="18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26F6-4CE6-897F-A5BBFD1A34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73309936"/>
        <c:axId val="1973332496"/>
      </c:scatterChart>
      <c:valAx>
        <c:axId val="1973309936"/>
        <c:scaling>
          <c:logBase val="10"/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973332496"/>
        <c:crosses val="autoZero"/>
        <c:crossBetween val="midCat"/>
      </c:valAx>
      <c:valAx>
        <c:axId val="1973332496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9733099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4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2536-4185-8257-A7E754FE9C83}"/>
              </c:ext>
            </c:extLst>
          </c:dPt>
          <c:dPt>
            <c:idx val="25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2536-4185-8257-A7E754FE9C83}"/>
              </c:ext>
            </c:extLst>
          </c:dPt>
          <c:xVal>
            <c:numRef>
              <c:f>Sheet1!$C$61:$C$86</c:f>
              <c:numCache>
                <c:formatCode>General</c:formatCode>
                <c:ptCount val="26"/>
                <c:pt idx="0">
                  <c:v>1.77</c:v>
                </c:pt>
                <c:pt idx="1">
                  <c:v>1.29</c:v>
                </c:pt>
                <c:pt idx="2">
                  <c:v>2.4300000000000002</c:v>
                </c:pt>
                <c:pt idx="3">
                  <c:v>1.1100000000000001</c:v>
                </c:pt>
                <c:pt idx="4">
                  <c:v>0.56000000000000005</c:v>
                </c:pt>
                <c:pt idx="5">
                  <c:v>2.23</c:v>
                </c:pt>
                <c:pt idx="6">
                  <c:v>0.89</c:v>
                </c:pt>
                <c:pt idx="7">
                  <c:v>0.79</c:v>
                </c:pt>
                <c:pt idx="8">
                  <c:v>0.98</c:v>
                </c:pt>
                <c:pt idx="9">
                  <c:v>1.26</c:v>
                </c:pt>
                <c:pt idx="10">
                  <c:v>0.75</c:v>
                </c:pt>
                <c:pt idx="11">
                  <c:v>2.13</c:v>
                </c:pt>
                <c:pt idx="12">
                  <c:v>1</c:v>
                </c:pt>
                <c:pt idx="13">
                  <c:v>0.95</c:v>
                </c:pt>
                <c:pt idx="14">
                  <c:v>1.06</c:v>
                </c:pt>
                <c:pt idx="15">
                  <c:v>1.35</c:v>
                </c:pt>
                <c:pt idx="16">
                  <c:v>0.88</c:v>
                </c:pt>
                <c:pt idx="17">
                  <c:v>2.09</c:v>
                </c:pt>
                <c:pt idx="18">
                  <c:v>1.03</c:v>
                </c:pt>
                <c:pt idx="19">
                  <c:v>0.95</c:v>
                </c:pt>
                <c:pt idx="20">
                  <c:v>1.1200000000000001</c:v>
                </c:pt>
                <c:pt idx="21">
                  <c:v>0.38</c:v>
                </c:pt>
                <c:pt idx="22">
                  <c:v>0.16</c:v>
                </c:pt>
                <c:pt idx="23">
                  <c:v>0.92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Sheet1!$D$61:$D$86</c:f>
              <c:numCache>
                <c:formatCode>General</c:formatCode>
                <c:ptCount val="26"/>
                <c:pt idx="1">
                  <c:v>8</c:v>
                </c:pt>
                <c:pt idx="2">
                  <c:v>8</c:v>
                </c:pt>
                <c:pt idx="4">
                  <c:v>7</c:v>
                </c:pt>
                <c:pt idx="5">
                  <c:v>7</c:v>
                </c:pt>
                <c:pt idx="7">
                  <c:v>6</c:v>
                </c:pt>
                <c:pt idx="8">
                  <c:v>6</c:v>
                </c:pt>
                <c:pt idx="10">
                  <c:v>5</c:v>
                </c:pt>
                <c:pt idx="11">
                  <c:v>5</c:v>
                </c:pt>
                <c:pt idx="13">
                  <c:v>4</c:v>
                </c:pt>
                <c:pt idx="14">
                  <c:v>4</c:v>
                </c:pt>
                <c:pt idx="16">
                  <c:v>3</c:v>
                </c:pt>
                <c:pt idx="17">
                  <c:v>3</c:v>
                </c:pt>
                <c:pt idx="19">
                  <c:v>2</c:v>
                </c:pt>
                <c:pt idx="20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9</c:v>
                </c:pt>
                <c:pt idx="2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536-4185-8257-A7E754FE9C83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C$61:$C$86</c:f>
              <c:numCache>
                <c:formatCode>General</c:formatCode>
                <c:ptCount val="26"/>
                <c:pt idx="0">
                  <c:v>1.77</c:v>
                </c:pt>
                <c:pt idx="1">
                  <c:v>1.29</c:v>
                </c:pt>
                <c:pt idx="2">
                  <c:v>2.4300000000000002</c:v>
                </c:pt>
                <c:pt idx="3">
                  <c:v>1.1100000000000001</c:v>
                </c:pt>
                <c:pt idx="4">
                  <c:v>0.56000000000000005</c:v>
                </c:pt>
                <c:pt idx="5">
                  <c:v>2.23</c:v>
                </c:pt>
                <c:pt idx="6">
                  <c:v>0.89</c:v>
                </c:pt>
                <c:pt idx="7">
                  <c:v>0.79</c:v>
                </c:pt>
                <c:pt idx="8">
                  <c:v>0.98</c:v>
                </c:pt>
                <c:pt idx="9">
                  <c:v>1.26</c:v>
                </c:pt>
                <c:pt idx="10">
                  <c:v>0.75</c:v>
                </c:pt>
                <c:pt idx="11">
                  <c:v>2.13</c:v>
                </c:pt>
                <c:pt idx="12">
                  <c:v>1</c:v>
                </c:pt>
                <c:pt idx="13">
                  <c:v>0.95</c:v>
                </c:pt>
                <c:pt idx="14">
                  <c:v>1.06</c:v>
                </c:pt>
                <c:pt idx="15">
                  <c:v>1.35</c:v>
                </c:pt>
                <c:pt idx="16">
                  <c:v>0.88</c:v>
                </c:pt>
                <c:pt idx="17">
                  <c:v>2.09</c:v>
                </c:pt>
                <c:pt idx="18">
                  <c:v>1.03</c:v>
                </c:pt>
                <c:pt idx="19">
                  <c:v>0.95</c:v>
                </c:pt>
                <c:pt idx="20">
                  <c:v>1.1200000000000001</c:v>
                </c:pt>
                <c:pt idx="21">
                  <c:v>0.38</c:v>
                </c:pt>
                <c:pt idx="22">
                  <c:v>0.16</c:v>
                </c:pt>
                <c:pt idx="23">
                  <c:v>0.92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Sheet1!$E$61:$E$86</c:f>
              <c:numCache>
                <c:formatCode>General</c:formatCode>
                <c:ptCount val="26"/>
                <c:pt idx="0">
                  <c:v>8</c:v>
                </c:pt>
                <c:pt idx="3">
                  <c:v>7</c:v>
                </c:pt>
                <c:pt idx="6">
                  <c:v>6</c:v>
                </c:pt>
                <c:pt idx="9">
                  <c:v>5</c:v>
                </c:pt>
                <c:pt idx="12">
                  <c:v>4</c:v>
                </c:pt>
                <c:pt idx="15">
                  <c:v>3</c:v>
                </c:pt>
                <c:pt idx="18">
                  <c:v>2</c:v>
                </c:pt>
                <c:pt idx="2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2536-4185-8257-A7E754FE9C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8111823"/>
        <c:axId val="688114223"/>
      </c:scatterChart>
      <c:valAx>
        <c:axId val="688111823"/>
        <c:scaling>
          <c:logBase val="10"/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88114223"/>
        <c:crosses val="autoZero"/>
        <c:crossBetween val="midCat"/>
      </c:valAx>
      <c:valAx>
        <c:axId val="688114223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68811182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4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AD41-4BC1-9820-995F27DDBB46}"/>
              </c:ext>
            </c:extLst>
          </c:dPt>
          <c:dPt>
            <c:idx val="25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AD41-4BC1-9820-995F27DDBB46}"/>
              </c:ext>
            </c:extLst>
          </c:dPt>
          <c:xVal>
            <c:numRef>
              <c:f>Sheet1!$C$89:$C$114</c:f>
              <c:numCache>
                <c:formatCode>General</c:formatCode>
                <c:ptCount val="26"/>
                <c:pt idx="0">
                  <c:v>0.47</c:v>
                </c:pt>
                <c:pt idx="1">
                  <c:v>0.28999999999999998</c:v>
                </c:pt>
                <c:pt idx="2">
                  <c:v>0.75</c:v>
                </c:pt>
                <c:pt idx="3">
                  <c:v>1</c:v>
                </c:pt>
                <c:pt idx="4">
                  <c:v>0.59</c:v>
                </c:pt>
                <c:pt idx="5">
                  <c:v>1.72</c:v>
                </c:pt>
                <c:pt idx="6">
                  <c:v>1.02</c:v>
                </c:pt>
                <c:pt idx="7">
                  <c:v>1.01</c:v>
                </c:pt>
                <c:pt idx="8">
                  <c:v>1.03</c:v>
                </c:pt>
                <c:pt idx="9">
                  <c:v>1.02</c:v>
                </c:pt>
                <c:pt idx="10">
                  <c:v>0.56000000000000005</c:v>
                </c:pt>
                <c:pt idx="11">
                  <c:v>1.85</c:v>
                </c:pt>
                <c:pt idx="12">
                  <c:v>0.99</c:v>
                </c:pt>
                <c:pt idx="13">
                  <c:v>0.95</c:v>
                </c:pt>
                <c:pt idx="14">
                  <c:v>1.03</c:v>
                </c:pt>
                <c:pt idx="15">
                  <c:v>0.85</c:v>
                </c:pt>
                <c:pt idx="16">
                  <c:v>0.4</c:v>
                </c:pt>
                <c:pt idx="17">
                  <c:v>1.84</c:v>
                </c:pt>
                <c:pt idx="18">
                  <c:v>0.93</c:v>
                </c:pt>
                <c:pt idx="19">
                  <c:v>0.84</c:v>
                </c:pt>
                <c:pt idx="20">
                  <c:v>1.02</c:v>
                </c:pt>
                <c:pt idx="21">
                  <c:v>4.1399999999999997</c:v>
                </c:pt>
                <c:pt idx="22">
                  <c:v>3.01</c:v>
                </c:pt>
                <c:pt idx="23">
                  <c:v>5.7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Sheet1!$D$89:$D$114</c:f>
              <c:numCache>
                <c:formatCode>General</c:formatCode>
                <c:ptCount val="26"/>
                <c:pt idx="1">
                  <c:v>8</c:v>
                </c:pt>
                <c:pt idx="2">
                  <c:v>8</c:v>
                </c:pt>
                <c:pt idx="4">
                  <c:v>7</c:v>
                </c:pt>
                <c:pt idx="5">
                  <c:v>7</c:v>
                </c:pt>
                <c:pt idx="7">
                  <c:v>6</c:v>
                </c:pt>
                <c:pt idx="8">
                  <c:v>6</c:v>
                </c:pt>
                <c:pt idx="10">
                  <c:v>5</c:v>
                </c:pt>
                <c:pt idx="11">
                  <c:v>5</c:v>
                </c:pt>
                <c:pt idx="13">
                  <c:v>4</c:v>
                </c:pt>
                <c:pt idx="14">
                  <c:v>4</c:v>
                </c:pt>
                <c:pt idx="16">
                  <c:v>3</c:v>
                </c:pt>
                <c:pt idx="17">
                  <c:v>3</c:v>
                </c:pt>
                <c:pt idx="19">
                  <c:v>2</c:v>
                </c:pt>
                <c:pt idx="20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9</c:v>
                </c:pt>
                <c:pt idx="2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D41-4BC1-9820-995F27DDBB46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C$89:$C$114</c:f>
              <c:numCache>
                <c:formatCode>General</c:formatCode>
                <c:ptCount val="26"/>
                <c:pt idx="0">
                  <c:v>0.47</c:v>
                </c:pt>
                <c:pt idx="1">
                  <c:v>0.28999999999999998</c:v>
                </c:pt>
                <c:pt idx="2">
                  <c:v>0.75</c:v>
                </c:pt>
                <c:pt idx="3">
                  <c:v>1</c:v>
                </c:pt>
                <c:pt idx="4">
                  <c:v>0.59</c:v>
                </c:pt>
                <c:pt idx="5">
                  <c:v>1.72</c:v>
                </c:pt>
                <c:pt idx="6">
                  <c:v>1.02</c:v>
                </c:pt>
                <c:pt idx="7">
                  <c:v>1.01</c:v>
                </c:pt>
                <c:pt idx="8">
                  <c:v>1.03</c:v>
                </c:pt>
                <c:pt idx="9">
                  <c:v>1.02</c:v>
                </c:pt>
                <c:pt idx="10">
                  <c:v>0.56000000000000005</c:v>
                </c:pt>
                <c:pt idx="11">
                  <c:v>1.85</c:v>
                </c:pt>
                <c:pt idx="12">
                  <c:v>0.99</c:v>
                </c:pt>
                <c:pt idx="13">
                  <c:v>0.95</c:v>
                </c:pt>
                <c:pt idx="14">
                  <c:v>1.03</c:v>
                </c:pt>
                <c:pt idx="15">
                  <c:v>0.85</c:v>
                </c:pt>
                <c:pt idx="16">
                  <c:v>0.4</c:v>
                </c:pt>
                <c:pt idx="17">
                  <c:v>1.84</c:v>
                </c:pt>
                <c:pt idx="18">
                  <c:v>0.93</c:v>
                </c:pt>
                <c:pt idx="19">
                  <c:v>0.84</c:v>
                </c:pt>
                <c:pt idx="20">
                  <c:v>1.02</c:v>
                </c:pt>
                <c:pt idx="21">
                  <c:v>4.1399999999999997</c:v>
                </c:pt>
                <c:pt idx="22">
                  <c:v>3.01</c:v>
                </c:pt>
                <c:pt idx="23">
                  <c:v>5.7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Sheet1!$E$89:$E$114</c:f>
              <c:numCache>
                <c:formatCode>General</c:formatCode>
                <c:ptCount val="26"/>
                <c:pt idx="0">
                  <c:v>8</c:v>
                </c:pt>
                <c:pt idx="3">
                  <c:v>7</c:v>
                </c:pt>
                <c:pt idx="6">
                  <c:v>6</c:v>
                </c:pt>
                <c:pt idx="9">
                  <c:v>5</c:v>
                </c:pt>
                <c:pt idx="12">
                  <c:v>4</c:v>
                </c:pt>
                <c:pt idx="15">
                  <c:v>3</c:v>
                </c:pt>
                <c:pt idx="18">
                  <c:v>2</c:v>
                </c:pt>
                <c:pt idx="2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D41-4BC1-9820-995F27DDBB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8143023"/>
        <c:axId val="688137263"/>
      </c:scatterChart>
      <c:valAx>
        <c:axId val="688143023"/>
        <c:scaling>
          <c:logBase val="10"/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88137263"/>
        <c:crosses val="autoZero"/>
        <c:crossBetween val="midCat"/>
      </c:valAx>
      <c:valAx>
        <c:axId val="688137263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68814302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4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C44F-4DDC-9B34-FF802955E1F7}"/>
              </c:ext>
            </c:extLst>
          </c:dPt>
          <c:dPt>
            <c:idx val="25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C44F-4DDC-9B34-FF802955E1F7}"/>
              </c:ext>
            </c:extLst>
          </c:dPt>
          <c:xVal>
            <c:numRef>
              <c:f>Sheet1!$C$5:$C$30</c:f>
              <c:numCache>
                <c:formatCode>General</c:formatCode>
                <c:ptCount val="26"/>
                <c:pt idx="0">
                  <c:v>1.66</c:v>
                </c:pt>
                <c:pt idx="1">
                  <c:v>1.19</c:v>
                </c:pt>
                <c:pt idx="2">
                  <c:v>2.31</c:v>
                </c:pt>
                <c:pt idx="3">
                  <c:v>0.91</c:v>
                </c:pt>
                <c:pt idx="4">
                  <c:v>0.69</c:v>
                </c:pt>
                <c:pt idx="5">
                  <c:v>1.21</c:v>
                </c:pt>
                <c:pt idx="6">
                  <c:v>1.0900000000000001</c:v>
                </c:pt>
                <c:pt idx="7">
                  <c:v>0.53</c:v>
                </c:pt>
                <c:pt idx="8">
                  <c:v>2.23</c:v>
                </c:pt>
                <c:pt idx="9">
                  <c:v>0.89</c:v>
                </c:pt>
                <c:pt idx="10">
                  <c:v>0.79</c:v>
                </c:pt>
                <c:pt idx="11">
                  <c:v>0.99</c:v>
                </c:pt>
                <c:pt idx="12">
                  <c:v>1.08</c:v>
                </c:pt>
                <c:pt idx="13">
                  <c:v>0.61</c:v>
                </c:pt>
                <c:pt idx="14">
                  <c:v>1.91</c:v>
                </c:pt>
                <c:pt idx="15">
                  <c:v>1</c:v>
                </c:pt>
                <c:pt idx="16">
                  <c:v>0.95</c:v>
                </c:pt>
                <c:pt idx="17">
                  <c:v>1.05</c:v>
                </c:pt>
                <c:pt idx="18">
                  <c:v>1.43</c:v>
                </c:pt>
                <c:pt idx="19">
                  <c:v>0.9</c:v>
                </c:pt>
                <c:pt idx="20">
                  <c:v>2.2799999999999998</c:v>
                </c:pt>
                <c:pt idx="21">
                  <c:v>1.03</c:v>
                </c:pt>
                <c:pt idx="22">
                  <c:v>0.94</c:v>
                </c:pt>
                <c:pt idx="23">
                  <c:v>1.1200000000000001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Sheet1!$D$5:$D$30</c:f>
              <c:numCache>
                <c:formatCode>General</c:formatCode>
                <c:ptCount val="26"/>
                <c:pt idx="1">
                  <c:v>8</c:v>
                </c:pt>
                <c:pt idx="2">
                  <c:v>8</c:v>
                </c:pt>
                <c:pt idx="4">
                  <c:v>7</c:v>
                </c:pt>
                <c:pt idx="5">
                  <c:v>7</c:v>
                </c:pt>
                <c:pt idx="7">
                  <c:v>6</c:v>
                </c:pt>
                <c:pt idx="8">
                  <c:v>6</c:v>
                </c:pt>
                <c:pt idx="10">
                  <c:v>5</c:v>
                </c:pt>
                <c:pt idx="11">
                  <c:v>5</c:v>
                </c:pt>
                <c:pt idx="13">
                  <c:v>4</c:v>
                </c:pt>
                <c:pt idx="14">
                  <c:v>4</c:v>
                </c:pt>
                <c:pt idx="16">
                  <c:v>3</c:v>
                </c:pt>
                <c:pt idx="17">
                  <c:v>3</c:v>
                </c:pt>
                <c:pt idx="19">
                  <c:v>2</c:v>
                </c:pt>
                <c:pt idx="20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9</c:v>
                </c:pt>
                <c:pt idx="2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44F-4DDC-9B34-FF802955E1F7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C$5:$C$30</c:f>
              <c:numCache>
                <c:formatCode>General</c:formatCode>
                <c:ptCount val="26"/>
                <c:pt idx="0">
                  <c:v>1.66</c:v>
                </c:pt>
                <c:pt idx="1">
                  <c:v>1.19</c:v>
                </c:pt>
                <c:pt idx="2">
                  <c:v>2.31</c:v>
                </c:pt>
                <c:pt idx="3">
                  <c:v>0.91</c:v>
                </c:pt>
                <c:pt idx="4">
                  <c:v>0.69</c:v>
                </c:pt>
                <c:pt idx="5">
                  <c:v>1.21</c:v>
                </c:pt>
                <c:pt idx="6">
                  <c:v>1.0900000000000001</c:v>
                </c:pt>
                <c:pt idx="7">
                  <c:v>0.53</c:v>
                </c:pt>
                <c:pt idx="8">
                  <c:v>2.23</c:v>
                </c:pt>
                <c:pt idx="9">
                  <c:v>0.89</c:v>
                </c:pt>
                <c:pt idx="10">
                  <c:v>0.79</c:v>
                </c:pt>
                <c:pt idx="11">
                  <c:v>0.99</c:v>
                </c:pt>
                <c:pt idx="12">
                  <c:v>1.08</c:v>
                </c:pt>
                <c:pt idx="13">
                  <c:v>0.61</c:v>
                </c:pt>
                <c:pt idx="14">
                  <c:v>1.91</c:v>
                </c:pt>
                <c:pt idx="15">
                  <c:v>1</c:v>
                </c:pt>
                <c:pt idx="16">
                  <c:v>0.95</c:v>
                </c:pt>
                <c:pt idx="17">
                  <c:v>1.05</c:v>
                </c:pt>
                <c:pt idx="18">
                  <c:v>1.43</c:v>
                </c:pt>
                <c:pt idx="19">
                  <c:v>0.9</c:v>
                </c:pt>
                <c:pt idx="20">
                  <c:v>2.2799999999999998</c:v>
                </c:pt>
                <c:pt idx="21">
                  <c:v>1.03</c:v>
                </c:pt>
                <c:pt idx="22">
                  <c:v>0.94</c:v>
                </c:pt>
                <c:pt idx="23">
                  <c:v>1.1200000000000001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Sheet1!$E$5:$E$30</c:f>
              <c:numCache>
                <c:formatCode>General</c:formatCode>
                <c:ptCount val="26"/>
                <c:pt idx="0">
                  <c:v>8</c:v>
                </c:pt>
                <c:pt idx="3">
                  <c:v>7</c:v>
                </c:pt>
                <c:pt idx="6">
                  <c:v>6</c:v>
                </c:pt>
                <c:pt idx="9">
                  <c:v>5</c:v>
                </c:pt>
                <c:pt idx="12">
                  <c:v>4</c:v>
                </c:pt>
                <c:pt idx="15">
                  <c:v>3</c:v>
                </c:pt>
                <c:pt idx="18">
                  <c:v>2</c:v>
                </c:pt>
                <c:pt idx="2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44F-4DDC-9B34-FF802955E1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5743439"/>
        <c:axId val="1945749679"/>
      </c:scatterChart>
      <c:valAx>
        <c:axId val="1945743439"/>
        <c:scaling>
          <c:logBase val="10"/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945749679"/>
        <c:crosses val="autoZero"/>
        <c:crossBetween val="midCat"/>
      </c:valAx>
      <c:valAx>
        <c:axId val="1945749679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94574343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24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7738-4DFA-B6B6-6BC878CC0434}"/>
              </c:ext>
            </c:extLst>
          </c:dPt>
          <c:dPt>
            <c:idx val="25"/>
            <c:marker>
              <c:symbol val="none"/>
            </c:marker>
            <c:bubble3D val="0"/>
            <c:spPr>
              <a:ln w="2540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7738-4DFA-B6B6-6BC878CC0434}"/>
              </c:ext>
            </c:extLst>
          </c:dPt>
          <c:xVal>
            <c:numRef>
              <c:f>Sheet1!$C$33:$C$58</c:f>
              <c:numCache>
                <c:formatCode>General</c:formatCode>
                <c:ptCount val="26"/>
                <c:pt idx="0">
                  <c:v>0.54</c:v>
                </c:pt>
                <c:pt idx="1">
                  <c:v>0.33</c:v>
                </c:pt>
                <c:pt idx="2">
                  <c:v>0.88</c:v>
                </c:pt>
                <c:pt idx="3">
                  <c:v>1.19</c:v>
                </c:pt>
                <c:pt idx="4">
                  <c:v>0.89</c:v>
                </c:pt>
                <c:pt idx="5">
                  <c:v>1.59</c:v>
                </c:pt>
                <c:pt idx="6">
                  <c:v>1.01</c:v>
                </c:pt>
                <c:pt idx="7">
                  <c:v>0.56000000000000005</c:v>
                </c:pt>
                <c:pt idx="8">
                  <c:v>1.84</c:v>
                </c:pt>
                <c:pt idx="9">
                  <c:v>1.03</c:v>
                </c:pt>
                <c:pt idx="10">
                  <c:v>1.01</c:v>
                </c:pt>
                <c:pt idx="11">
                  <c:v>1.04</c:v>
                </c:pt>
                <c:pt idx="12">
                  <c:v>1.19</c:v>
                </c:pt>
                <c:pt idx="13">
                  <c:v>0.63</c:v>
                </c:pt>
                <c:pt idx="14">
                  <c:v>2.25</c:v>
                </c:pt>
                <c:pt idx="15">
                  <c:v>0.99</c:v>
                </c:pt>
                <c:pt idx="16">
                  <c:v>0.95</c:v>
                </c:pt>
                <c:pt idx="17">
                  <c:v>1.04</c:v>
                </c:pt>
                <c:pt idx="18">
                  <c:v>0.76</c:v>
                </c:pt>
                <c:pt idx="19">
                  <c:v>0.36</c:v>
                </c:pt>
                <c:pt idx="20">
                  <c:v>1.61</c:v>
                </c:pt>
                <c:pt idx="21">
                  <c:v>0.95</c:v>
                </c:pt>
                <c:pt idx="22">
                  <c:v>0.86</c:v>
                </c:pt>
                <c:pt idx="23">
                  <c:v>1.04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Sheet1!$D$33:$D$58</c:f>
              <c:numCache>
                <c:formatCode>General</c:formatCode>
                <c:ptCount val="26"/>
                <c:pt idx="1">
                  <c:v>8</c:v>
                </c:pt>
                <c:pt idx="2">
                  <c:v>8</c:v>
                </c:pt>
                <c:pt idx="4">
                  <c:v>7</c:v>
                </c:pt>
                <c:pt idx="5">
                  <c:v>7</c:v>
                </c:pt>
                <c:pt idx="7">
                  <c:v>6</c:v>
                </c:pt>
                <c:pt idx="8">
                  <c:v>6</c:v>
                </c:pt>
                <c:pt idx="10">
                  <c:v>5</c:v>
                </c:pt>
                <c:pt idx="11">
                  <c:v>5</c:v>
                </c:pt>
                <c:pt idx="13">
                  <c:v>4</c:v>
                </c:pt>
                <c:pt idx="14">
                  <c:v>4</c:v>
                </c:pt>
                <c:pt idx="16">
                  <c:v>3</c:v>
                </c:pt>
                <c:pt idx="17">
                  <c:v>3</c:v>
                </c:pt>
                <c:pt idx="19">
                  <c:v>2</c:v>
                </c:pt>
                <c:pt idx="20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9</c:v>
                </c:pt>
                <c:pt idx="2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738-4DFA-B6B6-6BC878CC0434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C$33:$C$58</c:f>
              <c:numCache>
                <c:formatCode>General</c:formatCode>
                <c:ptCount val="26"/>
                <c:pt idx="0">
                  <c:v>0.54</c:v>
                </c:pt>
                <c:pt idx="1">
                  <c:v>0.33</c:v>
                </c:pt>
                <c:pt idx="2">
                  <c:v>0.88</c:v>
                </c:pt>
                <c:pt idx="3">
                  <c:v>1.19</c:v>
                </c:pt>
                <c:pt idx="4">
                  <c:v>0.89</c:v>
                </c:pt>
                <c:pt idx="5">
                  <c:v>1.59</c:v>
                </c:pt>
                <c:pt idx="6">
                  <c:v>1.01</c:v>
                </c:pt>
                <c:pt idx="7">
                  <c:v>0.56000000000000005</c:v>
                </c:pt>
                <c:pt idx="8">
                  <c:v>1.84</c:v>
                </c:pt>
                <c:pt idx="9">
                  <c:v>1.03</c:v>
                </c:pt>
                <c:pt idx="10">
                  <c:v>1.01</c:v>
                </c:pt>
                <c:pt idx="11">
                  <c:v>1.04</c:v>
                </c:pt>
                <c:pt idx="12">
                  <c:v>1.19</c:v>
                </c:pt>
                <c:pt idx="13">
                  <c:v>0.63</c:v>
                </c:pt>
                <c:pt idx="14">
                  <c:v>2.25</c:v>
                </c:pt>
                <c:pt idx="15">
                  <c:v>0.99</c:v>
                </c:pt>
                <c:pt idx="16">
                  <c:v>0.95</c:v>
                </c:pt>
                <c:pt idx="17">
                  <c:v>1.04</c:v>
                </c:pt>
                <c:pt idx="18">
                  <c:v>0.76</c:v>
                </c:pt>
                <c:pt idx="19">
                  <c:v>0.36</c:v>
                </c:pt>
                <c:pt idx="20">
                  <c:v>1.61</c:v>
                </c:pt>
                <c:pt idx="21">
                  <c:v>0.95</c:v>
                </c:pt>
                <c:pt idx="22">
                  <c:v>0.86</c:v>
                </c:pt>
                <c:pt idx="23">
                  <c:v>1.04</c:v>
                </c:pt>
                <c:pt idx="24">
                  <c:v>1</c:v>
                </c:pt>
                <c:pt idx="25">
                  <c:v>1</c:v>
                </c:pt>
              </c:numCache>
            </c:numRef>
          </c:xVal>
          <c:yVal>
            <c:numRef>
              <c:f>Sheet1!$E$33:$E$58</c:f>
              <c:numCache>
                <c:formatCode>General</c:formatCode>
                <c:ptCount val="26"/>
                <c:pt idx="0">
                  <c:v>8</c:v>
                </c:pt>
                <c:pt idx="3">
                  <c:v>7</c:v>
                </c:pt>
                <c:pt idx="6">
                  <c:v>6</c:v>
                </c:pt>
                <c:pt idx="9">
                  <c:v>5</c:v>
                </c:pt>
                <c:pt idx="12">
                  <c:v>4</c:v>
                </c:pt>
                <c:pt idx="15">
                  <c:v>3</c:v>
                </c:pt>
                <c:pt idx="18">
                  <c:v>2</c:v>
                </c:pt>
                <c:pt idx="2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738-4DFA-B6B6-6BC878CC04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5539807"/>
        <c:axId val="688117103"/>
      </c:scatterChart>
      <c:valAx>
        <c:axId val="1825539807"/>
        <c:scaling>
          <c:logBase val="10"/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88117103"/>
        <c:crosses val="autoZero"/>
        <c:crossBetween val="midCat"/>
      </c:valAx>
      <c:valAx>
        <c:axId val="688117103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82553980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63E980-496A-964C-8488-555CA70A8328}" type="datetimeFigureOut">
              <a:rPr kumimoji="1" lang="ja-JP" altLang="en-US" smtClean="0"/>
              <a:t>2025/7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69E6C9-754E-EC45-9080-FD7AB2AA96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629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3718108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36273A-1B29-1A35-7372-3D3D532FBF6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526B694E-A10B-7AD1-E1AD-DBDF18819F0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636B8D60-9E78-5B51-1257-B91B82ECFF5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8F29BCC-020F-6357-71C2-B37E7C5687B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0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8168727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CADAC07-8881-52C2-0D7D-A538BA58CDA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9B5C72AC-5C78-D17D-D3AC-614A0518E27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AB5CE447-2D44-F700-AF6B-145B0740D8B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32ACEAB-9618-A0AE-2166-8140D1BA4A9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02688925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C93E100-E011-54D2-5F4C-2F6E3AC100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A5A51728-3096-746B-C11E-90EE44EFF89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B2612D7C-18E1-D02A-00D4-4860AB04DB8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E0F6FFB-CE20-5D23-64A4-0A5F252DE60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3155858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3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573231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573231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B0823F-C96F-8604-B02B-9E2F43AE45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C627259E-9B9E-82FB-A077-CCB2676E67C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C5F5EA72-4625-AA9B-01CA-C0B938C30F0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601567B-E048-E9A6-4664-4D0BE32D4B4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736458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CA4FD51-F134-F703-FCDE-E584FD4EB7C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C29543F6-A77C-2D1F-461F-1CEAC1BCC25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59402EEF-B43C-DFBC-E792-53DD5B2251F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C60ED57-33A4-0B64-0026-D8DAFB895F4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6997020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3867CF7-E490-8966-D98F-5159047181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A8FBF8A6-20AE-828E-E047-05D679F5172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9F4F8533-8768-3FAC-3754-545B1637DB4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94DFDB1-EC1C-65AD-7481-BB2DE80B030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8026361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AAF6AF9-3589-C148-6939-733B0324E5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0C935AC3-552E-3D0C-AF20-CE6927676B3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199EE9C0-A313-B8FA-8461-1CA83277E8A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256378F-532A-1DE3-568A-8CD8538A283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506020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4BC71C7-5D4A-5B70-A099-2E8303FA99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777405D4-F22E-8CA5-672B-78ACA810597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6DA17484-88A9-4525-6EE6-2CE6BFC1583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B4BEFCA-07E7-CE95-D7AD-676BC1846A6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4362788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BB408EF-CB22-430F-9B71-B91E197F93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3B8AB3FD-7F1E-74AC-B43F-8B1D6BFB1D4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6C200659-6917-BB00-0B74-3A220C6F584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469C688-9599-F3E8-6203-425DA7ED89C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1773897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6AFE899-5750-BDC6-9433-7DD11D989C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BFE2824D-C1AB-B135-05B9-A19D6FAF131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E4B4CDAA-AF3B-944A-D8FB-70B9AD382FC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FI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2B1AA27-835F-6C06-D999-87585591D72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76F10EE-F677-6E46-ABE9-3AE12360A85B}" type="slidenum">
              <a:rPr kumimoji="1" lang="ja-FI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1" lang="ja-FI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567281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7E3FFA-E566-1149-5CF6-ADDE330A1D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C666574-CCE3-4485-C56B-77FCFA3578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  <a:endParaRPr kumimoji="1" lang="ja-FI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EAC2FFE-810D-CE45-9822-7336BF090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864933-2059-4D6F-46EC-C036F984B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4E3567-81E4-D102-79D3-C81E4897E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2665078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284D07-67EA-8246-71F1-E0A80E31D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1FFAD77-86C0-4635-7CAA-90B0841E51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FI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95E85D-C694-7A2E-7A38-F56BB8540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520B0F-4EC2-306C-02CF-481623566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21CAC3-89CD-7038-569D-EF16CABF1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1241158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51CE88E-7A4B-E446-987B-1449A7D8FB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1CDA0AF-DE1E-7A15-3B4F-D568EC9D4D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FI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AFFC96F-FDEC-A573-5B9C-24F8D16C1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A4C526-07F6-A69F-A994-849CBF77A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C12876-F4CC-9A38-59CA-765616890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3828184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5A7477-90B9-33A3-8C42-162C14C2AC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5631EC-1945-7135-A1F9-F06ACBC7B1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FI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75FF5A-8FCB-9463-1ABE-2CF564498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23DCAC-9D84-A923-F33E-7593E2E86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8EC425-ED94-FC2C-A2DF-C9B4E015A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2014342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8E0CCB-B736-8EE1-55DC-1A304BA78E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358ED9-0758-FB0D-94F0-AFFC63D8C2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6D8006-FB05-232C-F79D-B8733AB76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5502C6-9C95-6523-56E2-EB1D75E62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555CA3-2EFA-DF8A-0F40-DEA9D5CC7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3855163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AB0B22-6005-91E2-E34B-FD79A4C7A5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CC1C6DE-13A5-289C-D966-72297FA746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FI" alt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8D7D180-9574-843A-818B-46346DDF14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FI" alt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A7C1BA-41EE-6DC0-4B74-43D4F01BA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C61DF08-97B1-DA68-F2A9-3B3B618FB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C0D669-6EBF-1D76-F2E4-8B43E7CE6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3354442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EBE55A-19AC-F855-EEAD-2FA17A26AC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3C2E99-F69F-A547-ACDC-E4330F30B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542905A-562D-5F93-BA7E-390454D3E3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FI" alt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67D868F-4653-17A8-B042-1269E93B64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9F2D981-E784-1A72-76ED-A6075245AD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FI" alt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82CEA35-247D-7638-6E3F-39190CC97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3B54805-1DC9-EFBF-E387-BF470EF29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95BBBDD-A574-8F31-7E2C-771995797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1412867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68560A-C70C-11C4-3E9C-495D33D1B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0242D66-CF10-3BC2-89B7-2F8B469D08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10C3052-D95F-4C83-72B0-409B069E8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C705106-127C-460A-704D-EE090C085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2396344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0AF5460-FA60-F92F-C8D3-D4F474BC5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C4CC072-BEC2-155A-F2B2-E4036B775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C5257B0-6D67-2901-7129-7783281EAA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536718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DA1C0D-7B20-1FB2-1EEA-09F2B1CA24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BD6EB6D-A154-75FB-F001-2472B9B959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FI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5C722CC-4EF0-0D0F-D81A-F1BEAC127E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8F0DD2-82CE-90F5-6CD8-F0FE0791D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9968407-E1DF-8EEB-933B-A5469F038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D610B23-9911-82F6-7B10-A1173B333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3609403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C3AEB3-CA3D-276A-6409-CE3BD8BC4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F586695-97B4-C018-7999-A41B2AD30C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FI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B66AED7-14CA-3092-FA9B-CB50B2016D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87A06D-915D-BD3A-DF2F-50F37544A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7AE8BA8-48D0-7980-103B-C02441667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FI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699E0EC-971E-5054-5E99-05EC08E9B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3654922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E046FDA-8787-74C6-99A8-5B3EC68119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  <a:endParaRPr kumimoji="1" lang="ja-FI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E7C37A6-641B-5373-57D4-B7A6985096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FI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566AC3-EFFA-7FF0-A6D3-4502CFA436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09A7EB-11C6-CF40-94EE-B6F37DB3986A}" type="datetimeFigureOut">
              <a:rPr kumimoji="1" lang="ja-FI" altLang="en-US" smtClean="0"/>
              <a:t>07/19/2025</a:t>
            </a:fld>
            <a:endParaRPr kumimoji="1" lang="ja-FI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0481F1F-473C-2468-E7E0-F47CD9EBD9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FI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6D6052-A359-C8AE-A290-32A6CA50B4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E10546-10A7-834F-927D-8DE900D30C86}" type="slidenum">
              <a:rPr kumimoji="1" lang="ja-FI" altLang="en-US" smtClean="0"/>
              <a:t>‹#›</a:t>
            </a:fld>
            <a:endParaRPr kumimoji="1" lang="ja-FI" altLang="en-US"/>
          </a:p>
        </p:txBody>
      </p:sp>
    </p:spTree>
    <p:extLst>
      <p:ext uri="{BB962C8B-B14F-4D97-AF65-F5344CB8AC3E}">
        <p14:creationId xmlns:p14="http://schemas.microsoft.com/office/powerpoint/2010/main" val="4029952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9472CCAD-A229-F03E-D627-0B3E9E971E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6279889"/>
              </p:ext>
            </p:extLst>
          </p:nvPr>
        </p:nvGraphicFramePr>
        <p:xfrm>
          <a:off x="2341638" y="1507835"/>
          <a:ext cx="7508724" cy="48456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168CE7D-7391-B83B-D02B-9F54973C9DDC}"/>
              </a:ext>
            </a:extLst>
          </p:cNvPr>
          <p:cNvSpPr txBox="1"/>
          <p:nvPr/>
        </p:nvSpPr>
        <p:spPr>
          <a:xfrm>
            <a:off x="128229" y="48995"/>
            <a:ext cx="119418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 </a:t>
            </a:r>
            <a:r>
              <a:rPr lang="en-US" altLang="ja-JP" sz="2000" dirty="0">
                <a:latin typeface="Calibri" panose="020F0502020204030204"/>
                <a:ea typeface="游ゴシック" panose="020B0400000000000000" pitchFamily="50" charset="-128"/>
              </a:rPr>
              <a:t>3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. Comparison of change in PVL grades between the ACURATE neo2 and ACURATE neo groups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5B46706-78C0-2D2D-15BF-15CFFDAC006D}"/>
              </a:ext>
            </a:extLst>
          </p:cNvPr>
          <p:cNvSpPr txBox="1"/>
          <p:nvPr/>
        </p:nvSpPr>
        <p:spPr>
          <a:xfrm>
            <a:off x="3491578" y="6201511"/>
            <a:ext cx="24649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CURATE neo2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sz="1600" dirty="0">
                <a:latin typeface="Calibri" panose="020F0502020204030204"/>
              </a:rPr>
              <a:t>(n = 134)</a:t>
            </a:r>
            <a:endParaRPr kumimoji="1" lang="ja-FI" altLang="en-US" sz="16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B0FE6D4-7DDC-29FA-1345-BA94B24F8BB7}"/>
              </a:ext>
            </a:extLst>
          </p:cNvPr>
          <p:cNvSpPr txBox="1"/>
          <p:nvPr/>
        </p:nvSpPr>
        <p:spPr>
          <a:xfrm>
            <a:off x="3890373" y="4061152"/>
            <a:ext cx="16791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9.7% 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(n = 92)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DFB3274-DA3E-FE1B-E481-D5FD3FFFC17E}"/>
              </a:ext>
            </a:extLst>
          </p:cNvPr>
          <p:cNvSpPr txBox="1"/>
          <p:nvPr/>
        </p:nvSpPr>
        <p:spPr>
          <a:xfrm>
            <a:off x="4017047" y="1287308"/>
            <a:ext cx="1425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%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 (n = 2)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BF70351-09A6-1CCB-31C8-56ECD042D86E}"/>
              </a:ext>
            </a:extLst>
          </p:cNvPr>
          <p:cNvSpPr txBox="1"/>
          <p:nvPr/>
        </p:nvSpPr>
        <p:spPr>
          <a:xfrm>
            <a:off x="7140150" y="3784202"/>
            <a:ext cx="18242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71.7</a:t>
            </a: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%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 (n = 193)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A6E9A164-0A5F-05DE-FD83-028D792926CC}"/>
              </a:ext>
            </a:extLst>
          </p:cNvPr>
          <p:cNvGrpSpPr/>
          <p:nvPr/>
        </p:nvGrpSpPr>
        <p:grpSpPr>
          <a:xfrm>
            <a:off x="4729959" y="993865"/>
            <a:ext cx="3322303" cy="234356"/>
            <a:chOff x="6332376" y="1816360"/>
            <a:chExt cx="2245567" cy="382554"/>
          </a:xfrm>
        </p:grpSpPr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E46F6CBA-AD5D-5EA9-7364-DE0615FF80EC}"/>
                </a:ext>
              </a:extLst>
            </p:cNvPr>
            <p:cNvCxnSpPr/>
            <p:nvPr/>
          </p:nvCxnSpPr>
          <p:spPr>
            <a:xfrm>
              <a:off x="6332376" y="1822580"/>
              <a:ext cx="224556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52D876CE-4783-3DB6-CCB0-2A1825ADBFDB}"/>
                </a:ext>
              </a:extLst>
            </p:cNvPr>
            <p:cNvCxnSpPr>
              <a:cxnSpLocks/>
            </p:cNvCxnSpPr>
            <p:nvPr/>
          </p:nvCxnSpPr>
          <p:spPr>
            <a:xfrm>
              <a:off x="6332376" y="1816360"/>
              <a:ext cx="0" cy="37633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A9CB0C27-1697-B5B1-37BE-C6D1F087E30D}"/>
                </a:ext>
              </a:extLst>
            </p:cNvPr>
            <p:cNvCxnSpPr>
              <a:cxnSpLocks/>
            </p:cNvCxnSpPr>
            <p:nvPr/>
          </p:nvCxnSpPr>
          <p:spPr>
            <a:xfrm>
              <a:off x="8577943" y="1822580"/>
              <a:ext cx="0" cy="37633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9F73DAF-6EE5-FD48-F16C-665F4F10F7A3}"/>
              </a:ext>
            </a:extLst>
          </p:cNvPr>
          <p:cNvSpPr txBox="1"/>
          <p:nvPr/>
        </p:nvSpPr>
        <p:spPr>
          <a:xfrm>
            <a:off x="5712988" y="539608"/>
            <a:ext cx="13562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 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= 0.0428</a:t>
            </a:r>
            <a:endParaRPr kumimoji="1" lang="ja-FI" altLang="en-US" sz="2000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F075195-74C3-5167-D72E-CB724EFB9A6B}"/>
              </a:ext>
            </a:extLst>
          </p:cNvPr>
          <p:cNvSpPr txBox="1"/>
          <p:nvPr/>
        </p:nvSpPr>
        <p:spPr>
          <a:xfrm>
            <a:off x="2484460" y="1154048"/>
            <a:ext cx="343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%</a:t>
            </a:r>
            <a:endParaRPr kumimoji="1" lang="ja-FI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3BEF991-1D79-BA7C-A651-950A674FC4AA}"/>
              </a:ext>
            </a:extLst>
          </p:cNvPr>
          <p:cNvSpPr txBox="1"/>
          <p:nvPr/>
        </p:nvSpPr>
        <p:spPr>
          <a:xfrm>
            <a:off x="3890374" y="2032383"/>
            <a:ext cx="16791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2.0%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 (n = 29)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A5C710F-AE7E-A1DA-266D-D73D424C4247}"/>
              </a:ext>
            </a:extLst>
          </p:cNvPr>
          <p:cNvSpPr txBox="1"/>
          <p:nvPr/>
        </p:nvSpPr>
        <p:spPr>
          <a:xfrm>
            <a:off x="7212677" y="1839048"/>
            <a:ext cx="16791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4.5%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 (n = 39)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4C1E6EC-0314-E504-5167-210F7089208B}"/>
              </a:ext>
            </a:extLst>
          </p:cNvPr>
          <p:cNvSpPr txBox="1"/>
          <p:nvPr/>
        </p:nvSpPr>
        <p:spPr>
          <a:xfrm>
            <a:off x="7339349" y="1291302"/>
            <a:ext cx="1425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0.4</a:t>
            </a: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%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 (n = 1)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8697D9E-CBA8-D314-3F36-49DD37C063B4}"/>
              </a:ext>
            </a:extLst>
          </p:cNvPr>
          <p:cNvSpPr txBox="1"/>
          <p:nvPr/>
        </p:nvSpPr>
        <p:spPr>
          <a:xfrm>
            <a:off x="6819772" y="6201512"/>
            <a:ext cx="24649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CURATE neo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sz="1600" dirty="0">
                <a:latin typeface="Calibri" panose="020F0502020204030204"/>
              </a:rPr>
              <a:t>(n = 269)</a:t>
            </a:r>
            <a:endParaRPr kumimoji="1" lang="ja-FI" altLang="en-US" sz="16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71A9F3D-0E66-4221-1985-BC58A8ACAC5F}"/>
              </a:ext>
            </a:extLst>
          </p:cNvPr>
          <p:cNvSpPr txBox="1"/>
          <p:nvPr/>
        </p:nvSpPr>
        <p:spPr>
          <a:xfrm>
            <a:off x="4017047" y="5775220"/>
            <a:ext cx="1425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6.8</a:t>
            </a: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%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 (n = 9)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7847C81-0C13-2FB8-4BE2-540A3B416C9B}"/>
              </a:ext>
            </a:extLst>
          </p:cNvPr>
          <p:cNvSpPr txBox="1"/>
          <p:nvPr/>
        </p:nvSpPr>
        <p:spPr>
          <a:xfrm>
            <a:off x="7212675" y="5619093"/>
            <a:ext cx="16791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11.9</a:t>
            </a: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%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 (n = 32)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021D6DC-D15E-C8DD-6600-8B9E4887501A}"/>
              </a:ext>
            </a:extLst>
          </p:cNvPr>
          <p:cNvSpPr txBox="1"/>
          <p:nvPr/>
        </p:nvSpPr>
        <p:spPr>
          <a:xfrm>
            <a:off x="9112990" y="5927620"/>
            <a:ext cx="1425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.5%</a:t>
            </a:r>
            <a:r>
              <a:rPr lang="en-US" altLang="en-US" sz="2000" b="1" dirty="0">
                <a:solidFill>
                  <a:prstClr val="black"/>
                </a:solidFill>
                <a:latin typeface="Calibri" panose="020F0502020204030204"/>
              </a:rPr>
              <a:t> (n = 4)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C6DC7CED-02EC-5AC4-F449-304806E01621}"/>
              </a:ext>
            </a:extLst>
          </p:cNvPr>
          <p:cNvGrpSpPr/>
          <p:nvPr/>
        </p:nvGrpSpPr>
        <p:grpSpPr>
          <a:xfrm>
            <a:off x="230078" y="524362"/>
            <a:ext cx="2343402" cy="1169551"/>
            <a:chOff x="968562" y="503973"/>
            <a:chExt cx="2343402" cy="1169551"/>
          </a:xfrm>
        </p:grpSpPr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4389E9D7-F04A-E680-9DC3-393E3BA0787C}"/>
                </a:ext>
              </a:extLst>
            </p:cNvPr>
            <p:cNvSpPr txBox="1"/>
            <p:nvPr/>
          </p:nvSpPr>
          <p:spPr>
            <a:xfrm>
              <a:off x="1099051" y="503973"/>
              <a:ext cx="2212913" cy="11695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4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rPr>
                <a:t>Improvement of two grades</a:t>
              </a:r>
              <a:endPara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4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rPr>
                <a:t>Improvement of one grade</a:t>
              </a:r>
              <a:endPara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4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rPr>
                <a:t>No change</a:t>
              </a:r>
              <a:endPara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4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rPr>
                <a:t>Worsening of one grade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Worsening of two grades</a:t>
              </a:r>
              <a:endPara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D042DC2D-144E-69E8-95EB-2C512E2BDC7E}"/>
                </a:ext>
              </a:extLst>
            </p:cNvPr>
            <p:cNvSpPr/>
            <p:nvPr/>
          </p:nvSpPr>
          <p:spPr>
            <a:xfrm>
              <a:off x="971670" y="620630"/>
              <a:ext cx="97903" cy="97903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59B93B70-40F0-0F33-753D-5DE33FF580E2}"/>
                </a:ext>
              </a:extLst>
            </p:cNvPr>
            <p:cNvSpPr/>
            <p:nvPr/>
          </p:nvSpPr>
          <p:spPr>
            <a:xfrm>
              <a:off x="968564" y="822790"/>
              <a:ext cx="97903" cy="97903"/>
            </a:xfrm>
            <a:prstGeom prst="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22FFE595-31E0-A92A-33DC-BCBE23EA29E9}"/>
                </a:ext>
              </a:extLst>
            </p:cNvPr>
            <p:cNvSpPr/>
            <p:nvPr/>
          </p:nvSpPr>
          <p:spPr>
            <a:xfrm>
              <a:off x="968564" y="1037729"/>
              <a:ext cx="97903" cy="97903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B1AD50D0-827C-CF8F-AFF1-143599C85EA4}"/>
                </a:ext>
              </a:extLst>
            </p:cNvPr>
            <p:cNvSpPr/>
            <p:nvPr/>
          </p:nvSpPr>
          <p:spPr>
            <a:xfrm>
              <a:off x="968563" y="1257088"/>
              <a:ext cx="97903" cy="97903"/>
            </a:xfrm>
            <a:prstGeom prst="rect">
              <a:avLst/>
            </a:prstGeom>
            <a:solidFill>
              <a:srgbClr val="2081E0"/>
            </a:solidFill>
            <a:ln>
              <a:solidFill>
                <a:srgbClr val="2081E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B9710CF5-1E07-0CAD-E6E8-A7881FDE2335}"/>
                </a:ext>
              </a:extLst>
            </p:cNvPr>
            <p:cNvSpPr/>
            <p:nvPr/>
          </p:nvSpPr>
          <p:spPr>
            <a:xfrm>
              <a:off x="968562" y="1460189"/>
              <a:ext cx="97903" cy="97903"/>
            </a:xfrm>
            <a:prstGeom prst="rect">
              <a:avLst/>
            </a:prstGeom>
            <a:solidFill>
              <a:srgbClr val="2E538F"/>
            </a:solidFill>
            <a:ln>
              <a:solidFill>
                <a:srgbClr val="2E538F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D4F7FC6-68A4-B2F0-9E73-8BCD5B8D0F89}"/>
              </a:ext>
            </a:extLst>
          </p:cNvPr>
          <p:cNvSpPr txBox="1"/>
          <p:nvPr/>
        </p:nvSpPr>
        <p:spPr>
          <a:xfrm>
            <a:off x="9238978" y="6427319"/>
            <a:ext cx="31024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PVL = paravalvular leakage.</a:t>
            </a:r>
          </a:p>
        </p:txBody>
      </p:sp>
    </p:spTree>
    <p:extLst>
      <p:ext uri="{BB962C8B-B14F-4D97-AF65-F5344CB8AC3E}">
        <p14:creationId xmlns:p14="http://schemas.microsoft.com/office/powerpoint/2010/main" val="4381122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4AE4CF-7287-5978-6CE1-8D609C83075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3EE1E1A3-EF36-F3DF-CC54-A068D2473E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7942724"/>
              </p:ext>
            </p:extLst>
          </p:nvPr>
        </p:nvGraphicFramePr>
        <p:xfrm>
          <a:off x="3169918" y="149635"/>
          <a:ext cx="5199692" cy="56291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id="{ED340F86-A3B3-947F-0441-176904A7BD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6880893"/>
              </p:ext>
            </p:extLst>
          </p:nvPr>
        </p:nvGraphicFramePr>
        <p:xfrm>
          <a:off x="8209869" y="568858"/>
          <a:ext cx="3848650" cy="4798337"/>
        </p:xfrm>
        <a:graphic>
          <a:graphicData uri="http://schemas.openxmlformats.org/drawingml/2006/table">
            <a:tbl>
              <a:tblPr firstRow="1" bandRow="1"/>
              <a:tblGrid>
                <a:gridCol w="877285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  <a:gridCol w="1594085">
                  <a:extLst>
                    <a:ext uri="{9D8B030D-6E8A-4147-A177-3AD203B41FA5}">
                      <a16:colId xmlns:a16="http://schemas.microsoft.com/office/drawing/2014/main" val="1579887003"/>
                    </a:ext>
                  </a:extLst>
                </a:gridCol>
                <a:gridCol w="1377280">
                  <a:extLst>
                    <a:ext uri="{9D8B030D-6E8A-4147-A177-3AD203B41FA5}">
                      <a16:colId xmlns:a16="http://schemas.microsoft.com/office/drawing/2014/main" val="3773613209"/>
                    </a:ext>
                  </a:extLst>
                </a:gridCol>
              </a:tblGrid>
              <a:tr h="5052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R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95%CI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i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-value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4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29 – 0.7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1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9 – 1.7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88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1 – 1.0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8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6 – 1.8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54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5 – 1.0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665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40 – 1.8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687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4 – 1.0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140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6229845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4.1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3.01 – 5.7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&lt;0.0001</a:t>
                      </a:r>
                      <a:endParaRPr lang="ja-JP" sz="18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9317665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DFF99DF4-664D-CC5F-21B6-9CCD3992F6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8801584"/>
              </p:ext>
            </p:extLst>
          </p:nvPr>
        </p:nvGraphicFramePr>
        <p:xfrm>
          <a:off x="326969" y="671899"/>
          <a:ext cx="2956731" cy="4816629"/>
        </p:xfrm>
        <a:graphic>
          <a:graphicData uri="http://schemas.openxmlformats.org/drawingml/2006/table">
            <a:tbl>
              <a:tblPr firstRow="1" bandRow="1"/>
              <a:tblGrid>
                <a:gridCol w="2956731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</a:tblGrid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URATE neo2 (vs. neo)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icuspid aortic valve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585518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V</a:t>
                      </a:r>
                      <a:r>
                        <a:rPr lang="en-US" sz="1800" kern="0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</a:t>
                      </a: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, per 100 mm</a:t>
                      </a:r>
                      <a:r>
                        <a:rPr lang="en-US" sz="1800" kern="0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vere LVOT calcific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altLang="ja-JP" sz="1800" kern="100" dirty="0">
                          <a:solidFill>
                            <a:schemeClr val="dk1"/>
                          </a:solidFill>
                          <a:effectLst/>
                          <a:latin typeface="Calibri" panose="020F0502020204030204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versizing index, per 1 % 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ost-dilat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mplantation depth, per 1 mm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VL ≥moderate at discharge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410382"/>
                  </a:ext>
                </a:extLst>
              </a:tr>
            </a:tbl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7DDBE94E-48CE-A18D-1D9F-D979B0FDBF96}"/>
              </a:ext>
            </a:extLst>
          </p:cNvPr>
          <p:cNvCxnSpPr>
            <a:cxnSpLocks/>
          </p:cNvCxnSpPr>
          <p:nvPr/>
        </p:nvCxnSpPr>
        <p:spPr>
          <a:xfrm>
            <a:off x="404553" y="5635934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C2970C21-D072-13CF-E45A-715AD7411A67}"/>
              </a:ext>
            </a:extLst>
          </p:cNvPr>
          <p:cNvCxnSpPr>
            <a:cxnSpLocks/>
          </p:cNvCxnSpPr>
          <p:nvPr/>
        </p:nvCxnSpPr>
        <p:spPr>
          <a:xfrm>
            <a:off x="404553" y="529151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27A6E11-708E-4C6D-0C60-3574DAAE8B97}"/>
              </a:ext>
            </a:extLst>
          </p:cNvPr>
          <p:cNvSpPr txBox="1"/>
          <p:nvPr/>
        </p:nvSpPr>
        <p:spPr>
          <a:xfrm>
            <a:off x="3034222" y="5595474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0.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7A4B5A0-4F17-F587-925F-0A3B689465C2}"/>
              </a:ext>
            </a:extLst>
          </p:cNvPr>
          <p:cNvSpPr txBox="1"/>
          <p:nvPr/>
        </p:nvSpPr>
        <p:spPr>
          <a:xfrm>
            <a:off x="5159735" y="5907071"/>
            <a:ext cx="1224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Risk</a:t>
            </a:r>
            <a:r>
              <a:rPr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ratio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2A7524B5-1F11-9817-4795-4CA37724D4E6}"/>
              </a:ext>
            </a:extLst>
          </p:cNvPr>
          <p:cNvSpPr txBox="1"/>
          <p:nvPr/>
        </p:nvSpPr>
        <p:spPr>
          <a:xfrm>
            <a:off x="5510159" y="5595239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B5DF669E-04AB-99CF-FCCD-73D8B0E4668F}"/>
              </a:ext>
            </a:extLst>
          </p:cNvPr>
          <p:cNvSpPr txBox="1"/>
          <p:nvPr/>
        </p:nvSpPr>
        <p:spPr>
          <a:xfrm>
            <a:off x="7949978" y="5600226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988B8640-8455-D982-5E2F-BF54BCC6E401}"/>
              </a:ext>
            </a:extLst>
          </p:cNvPr>
          <p:cNvCxnSpPr>
            <a:cxnSpLocks/>
          </p:cNvCxnSpPr>
          <p:nvPr/>
        </p:nvCxnSpPr>
        <p:spPr>
          <a:xfrm flipV="1">
            <a:off x="4242429" y="5979431"/>
            <a:ext cx="3003665" cy="672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4285446E-0A74-53AE-62E8-AB4D2BD192E4}"/>
              </a:ext>
            </a:extLst>
          </p:cNvPr>
          <p:cNvSpPr txBox="1"/>
          <p:nvPr/>
        </p:nvSpPr>
        <p:spPr>
          <a:xfrm>
            <a:off x="7375350" y="5790864"/>
            <a:ext cx="1702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Worse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2A80EFD-5A01-8E9D-ED7F-A7FE99FBC1AA}"/>
              </a:ext>
            </a:extLst>
          </p:cNvPr>
          <p:cNvSpPr txBox="1"/>
          <p:nvPr/>
        </p:nvSpPr>
        <p:spPr>
          <a:xfrm>
            <a:off x="2439500" y="5786671"/>
            <a:ext cx="171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Better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D09167D-FA83-8A6F-F645-5F8D09B6675C}"/>
              </a:ext>
            </a:extLst>
          </p:cNvPr>
          <p:cNvSpPr/>
          <p:nvPr/>
        </p:nvSpPr>
        <p:spPr>
          <a:xfrm>
            <a:off x="3169918" y="127467"/>
            <a:ext cx="5131726" cy="3895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3D6161B-33E2-1297-DF50-E96A2761F686}"/>
              </a:ext>
            </a:extLst>
          </p:cNvPr>
          <p:cNvSpPr txBox="1"/>
          <p:nvPr/>
        </p:nvSpPr>
        <p:spPr>
          <a:xfrm>
            <a:off x="128229" y="6098144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CI = confidence interval;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LVOT = left ventricular outflow tract; PVL = paravalvular leakage; RR = risk ratio. 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996DF35E-728B-6E83-F876-0F4C5430A0A4}"/>
              </a:ext>
            </a:extLst>
          </p:cNvPr>
          <p:cNvSpPr txBox="1"/>
          <p:nvPr/>
        </p:nvSpPr>
        <p:spPr>
          <a:xfrm>
            <a:off x="326969" y="54535"/>
            <a:ext cx="104250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9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B. </a:t>
            </a:r>
            <a:r>
              <a:rPr lang="en-US" altLang="ja-JP" sz="2000" dirty="0">
                <a:solidFill>
                  <a:prstClr val="black"/>
                </a:solidFill>
              </a:rPr>
              <a:t>Subanalysis for residual PVL at 3 months including PVL severity at discharge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207667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0F5E57F-8C22-ADAB-A8C1-7A7D038B533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8658D83B-7B05-DA65-10CE-50F695F647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3605774"/>
              </p:ext>
            </p:extLst>
          </p:nvPr>
        </p:nvGraphicFramePr>
        <p:xfrm>
          <a:off x="3169918" y="127467"/>
          <a:ext cx="5199693" cy="5653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id="{DC3EB2B8-6A0E-6FCB-0BFF-EB4F53A4C6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0131504"/>
              </p:ext>
            </p:extLst>
          </p:nvPr>
        </p:nvGraphicFramePr>
        <p:xfrm>
          <a:off x="8209869" y="568858"/>
          <a:ext cx="3848650" cy="4798337"/>
        </p:xfrm>
        <a:graphic>
          <a:graphicData uri="http://schemas.openxmlformats.org/drawingml/2006/table">
            <a:tbl>
              <a:tblPr firstRow="1" bandRow="1"/>
              <a:tblGrid>
                <a:gridCol w="877285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  <a:gridCol w="1594085">
                  <a:extLst>
                    <a:ext uri="{9D8B030D-6E8A-4147-A177-3AD203B41FA5}">
                      <a16:colId xmlns:a16="http://schemas.microsoft.com/office/drawing/2014/main" val="1579887003"/>
                    </a:ext>
                  </a:extLst>
                </a:gridCol>
                <a:gridCol w="1377280">
                  <a:extLst>
                    <a:ext uri="{9D8B030D-6E8A-4147-A177-3AD203B41FA5}">
                      <a16:colId xmlns:a16="http://schemas.microsoft.com/office/drawing/2014/main" val="3773613209"/>
                    </a:ext>
                  </a:extLst>
                </a:gridCol>
              </a:tblGrid>
              <a:tr h="5052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R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95%CI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i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-value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6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19 – 2.3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2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69 – 1.2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150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22890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3 – 2.2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24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9 – 0.9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35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61 – 1.9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00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5 – 1.0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30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4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0 – 2.2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128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4 – 1.1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60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6229845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0CAD9592-E11B-D13F-5253-3DE9161F25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7051230"/>
              </p:ext>
            </p:extLst>
          </p:nvPr>
        </p:nvGraphicFramePr>
        <p:xfrm>
          <a:off x="326969" y="671899"/>
          <a:ext cx="2956731" cy="4816629"/>
        </p:xfrm>
        <a:graphic>
          <a:graphicData uri="http://schemas.openxmlformats.org/drawingml/2006/table">
            <a:tbl>
              <a:tblPr firstRow="1" bandRow="1"/>
              <a:tblGrid>
                <a:gridCol w="2956731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</a:tblGrid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URATE neo2 (vs. neo)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GB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V</a:t>
                      </a:r>
                      <a:r>
                        <a:rPr lang="en-GB" sz="1800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x</a:t>
                      </a:r>
                      <a:r>
                        <a:rPr lang="en-GB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t baseline, per 1 m/s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585518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icuspid aortic valve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V</a:t>
                      </a:r>
                      <a:r>
                        <a:rPr lang="en-US" sz="1800" kern="0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</a:t>
                      </a: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, per 100 mm</a:t>
                      </a:r>
                      <a:r>
                        <a:rPr lang="en-US" sz="1800" kern="0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vere LVOT calcific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altLang="ja-JP" sz="1800" kern="100" dirty="0">
                          <a:solidFill>
                            <a:schemeClr val="dk1"/>
                          </a:solidFill>
                          <a:effectLst/>
                          <a:latin typeface="Calibri" panose="020F0502020204030204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versizing index, per 1 % 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ost-dilat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mplantation depth, per 1 mm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410382"/>
                  </a:ext>
                </a:extLst>
              </a:tr>
            </a:tbl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FE57E22C-0A5B-4D4F-200F-8E686D703E73}"/>
              </a:ext>
            </a:extLst>
          </p:cNvPr>
          <p:cNvCxnSpPr>
            <a:cxnSpLocks/>
          </p:cNvCxnSpPr>
          <p:nvPr/>
        </p:nvCxnSpPr>
        <p:spPr>
          <a:xfrm>
            <a:off x="404553" y="5635934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5FE152BE-2113-4CB7-B1F2-947F5708B696}"/>
              </a:ext>
            </a:extLst>
          </p:cNvPr>
          <p:cNvCxnSpPr>
            <a:cxnSpLocks/>
          </p:cNvCxnSpPr>
          <p:nvPr/>
        </p:nvCxnSpPr>
        <p:spPr>
          <a:xfrm>
            <a:off x="404553" y="529151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1C8000C-50B0-9192-9205-E8810C6A3D1A}"/>
              </a:ext>
            </a:extLst>
          </p:cNvPr>
          <p:cNvSpPr txBox="1"/>
          <p:nvPr/>
        </p:nvSpPr>
        <p:spPr>
          <a:xfrm>
            <a:off x="3034222" y="5595474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0.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AE050B9-779C-4861-02E0-AE57FA2C956C}"/>
              </a:ext>
            </a:extLst>
          </p:cNvPr>
          <p:cNvSpPr txBox="1"/>
          <p:nvPr/>
        </p:nvSpPr>
        <p:spPr>
          <a:xfrm>
            <a:off x="5159735" y="5907071"/>
            <a:ext cx="1224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Risk</a:t>
            </a:r>
            <a:r>
              <a:rPr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ratio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B1C008DB-9ECB-869E-8519-04216A0B84AE}"/>
              </a:ext>
            </a:extLst>
          </p:cNvPr>
          <p:cNvSpPr txBox="1"/>
          <p:nvPr/>
        </p:nvSpPr>
        <p:spPr>
          <a:xfrm>
            <a:off x="5510159" y="5595239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DDCE7A5-3082-7BDF-424A-40D97F3B184B}"/>
              </a:ext>
            </a:extLst>
          </p:cNvPr>
          <p:cNvSpPr txBox="1"/>
          <p:nvPr/>
        </p:nvSpPr>
        <p:spPr>
          <a:xfrm>
            <a:off x="7949978" y="5600226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9C9A0F30-1C38-6B73-8154-97D331D55C59}"/>
              </a:ext>
            </a:extLst>
          </p:cNvPr>
          <p:cNvCxnSpPr>
            <a:cxnSpLocks/>
          </p:cNvCxnSpPr>
          <p:nvPr/>
        </p:nvCxnSpPr>
        <p:spPr>
          <a:xfrm flipV="1">
            <a:off x="4242429" y="5979431"/>
            <a:ext cx="3003665" cy="672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9391D366-27AD-7311-A6C8-35A8B45CD7F2}"/>
              </a:ext>
            </a:extLst>
          </p:cNvPr>
          <p:cNvSpPr txBox="1"/>
          <p:nvPr/>
        </p:nvSpPr>
        <p:spPr>
          <a:xfrm>
            <a:off x="7391977" y="5790864"/>
            <a:ext cx="1650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Better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7EF76F08-90BF-897C-82F1-F53CAC317AF3}"/>
              </a:ext>
            </a:extLst>
          </p:cNvPr>
          <p:cNvSpPr txBox="1"/>
          <p:nvPr/>
        </p:nvSpPr>
        <p:spPr>
          <a:xfrm>
            <a:off x="2439500" y="5786671"/>
            <a:ext cx="171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Worse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C1127E17-C7D1-C023-324B-D3E85A65E528}"/>
              </a:ext>
            </a:extLst>
          </p:cNvPr>
          <p:cNvSpPr/>
          <p:nvPr/>
        </p:nvSpPr>
        <p:spPr>
          <a:xfrm>
            <a:off x="3169918" y="127467"/>
            <a:ext cx="5131726" cy="3895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5035583-B443-FF7E-00E8-9935CC44DA8E}"/>
              </a:ext>
            </a:extLst>
          </p:cNvPr>
          <p:cNvSpPr txBox="1"/>
          <p:nvPr/>
        </p:nvSpPr>
        <p:spPr>
          <a:xfrm>
            <a:off x="128229" y="6098144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max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maximum aortic valve velocity; CI = confidence interval;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LVOT = left ventricular outflow tract; PVL = paravalvular leakage; RR = risk ratio. 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80EB4DA-0B24-14A3-D73C-CE2D39486A24}"/>
              </a:ext>
            </a:extLst>
          </p:cNvPr>
          <p:cNvSpPr txBox="1"/>
          <p:nvPr/>
        </p:nvSpPr>
        <p:spPr>
          <a:xfrm>
            <a:off x="326969" y="54535"/>
            <a:ext cx="87662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10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</a:t>
            </a:r>
            <a:r>
              <a:rPr lang="en-US" altLang="ja-JP" sz="2000" dirty="0">
                <a:solidFill>
                  <a:prstClr val="black"/>
                </a:solidFill>
              </a:rPr>
              <a:t>. Subanalysis for PVL improvement including AV</a:t>
            </a:r>
            <a:r>
              <a:rPr lang="en-US" altLang="ja-JP" sz="2000" baseline="-25000" dirty="0">
                <a:solidFill>
                  <a:prstClr val="black"/>
                </a:solidFill>
              </a:rPr>
              <a:t>max</a:t>
            </a:r>
            <a:r>
              <a:rPr lang="en-US" altLang="ja-JP" sz="2000" dirty="0">
                <a:solidFill>
                  <a:prstClr val="black"/>
                </a:solidFill>
              </a:rPr>
              <a:t> at baseline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468117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C0F3F4B-6141-11A7-8FA6-B28A4D04FE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F54C05B1-552F-12C7-2A0A-21A7D2B1D5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3177021"/>
              </p:ext>
            </p:extLst>
          </p:nvPr>
        </p:nvGraphicFramePr>
        <p:xfrm>
          <a:off x="3169918" y="133009"/>
          <a:ext cx="5199692" cy="5644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id="{5403C63C-0EF7-8E54-79B5-77BE74EC91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5327379"/>
              </p:ext>
            </p:extLst>
          </p:nvPr>
        </p:nvGraphicFramePr>
        <p:xfrm>
          <a:off x="8209869" y="568858"/>
          <a:ext cx="3848650" cy="4798337"/>
        </p:xfrm>
        <a:graphic>
          <a:graphicData uri="http://schemas.openxmlformats.org/drawingml/2006/table">
            <a:tbl>
              <a:tblPr firstRow="1" bandRow="1"/>
              <a:tblGrid>
                <a:gridCol w="877285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  <a:gridCol w="1594085">
                  <a:extLst>
                    <a:ext uri="{9D8B030D-6E8A-4147-A177-3AD203B41FA5}">
                      <a16:colId xmlns:a16="http://schemas.microsoft.com/office/drawing/2014/main" val="1579887003"/>
                    </a:ext>
                  </a:extLst>
                </a:gridCol>
                <a:gridCol w="1377280">
                  <a:extLst>
                    <a:ext uri="{9D8B030D-6E8A-4147-A177-3AD203B41FA5}">
                      <a16:colId xmlns:a16="http://schemas.microsoft.com/office/drawing/2014/main" val="3773613209"/>
                    </a:ext>
                  </a:extLst>
                </a:gridCol>
              </a:tblGrid>
              <a:tr h="5052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R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95%CI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i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-value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3 – 0.8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13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1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9 – 1.5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2500</a:t>
                      </a:r>
                      <a:endParaRPr lang="ja-JP" sz="1800" b="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22890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6 – 1.8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70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1 – 1.0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&lt;0.000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1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63 – 2.2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83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5 – 1.0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78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6 – 1.6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471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6 – 1.0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247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6229845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BBA34FA2-72AE-E164-41C3-ACB7F65BD3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1844020"/>
              </p:ext>
            </p:extLst>
          </p:nvPr>
        </p:nvGraphicFramePr>
        <p:xfrm>
          <a:off x="326969" y="671899"/>
          <a:ext cx="2956731" cy="4816629"/>
        </p:xfrm>
        <a:graphic>
          <a:graphicData uri="http://schemas.openxmlformats.org/drawingml/2006/table">
            <a:tbl>
              <a:tblPr firstRow="1" bandRow="1"/>
              <a:tblGrid>
                <a:gridCol w="2956731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</a:tblGrid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URATE neo2 (vs. neo)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GB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V</a:t>
                      </a:r>
                      <a:r>
                        <a:rPr lang="en-GB" sz="1800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x</a:t>
                      </a:r>
                      <a:r>
                        <a:rPr lang="en-GB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t baseline, per 1 m/s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585518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icuspid aortic valve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V</a:t>
                      </a:r>
                      <a:r>
                        <a:rPr lang="en-US" sz="1800" kern="0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</a:t>
                      </a: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, per 100 mm</a:t>
                      </a:r>
                      <a:r>
                        <a:rPr lang="en-US" sz="1800" kern="0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vere LVOT calcific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altLang="ja-JP" sz="1800" kern="100" dirty="0">
                          <a:solidFill>
                            <a:schemeClr val="dk1"/>
                          </a:solidFill>
                          <a:effectLst/>
                          <a:latin typeface="Calibri" panose="020F0502020204030204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versizing index, per 1 % 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ost-dilat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mplantation depth, per 1 mm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410382"/>
                  </a:ext>
                </a:extLst>
              </a:tr>
            </a:tbl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E57FDFD-1DF7-DF97-28E9-DA48E30DD362}"/>
              </a:ext>
            </a:extLst>
          </p:cNvPr>
          <p:cNvCxnSpPr>
            <a:cxnSpLocks/>
          </p:cNvCxnSpPr>
          <p:nvPr/>
        </p:nvCxnSpPr>
        <p:spPr>
          <a:xfrm>
            <a:off x="404553" y="5635934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D9FC432F-61EF-8497-0934-F12DB5554C9E}"/>
              </a:ext>
            </a:extLst>
          </p:cNvPr>
          <p:cNvCxnSpPr>
            <a:cxnSpLocks/>
          </p:cNvCxnSpPr>
          <p:nvPr/>
        </p:nvCxnSpPr>
        <p:spPr>
          <a:xfrm>
            <a:off x="404553" y="529151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70ABDB2-0A70-2EC0-0970-FD4A5CBC1612}"/>
              </a:ext>
            </a:extLst>
          </p:cNvPr>
          <p:cNvSpPr txBox="1"/>
          <p:nvPr/>
        </p:nvSpPr>
        <p:spPr>
          <a:xfrm>
            <a:off x="3034222" y="5595474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0.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F7B76EE-C0B6-7CD7-96EE-D848155533F7}"/>
              </a:ext>
            </a:extLst>
          </p:cNvPr>
          <p:cNvSpPr txBox="1"/>
          <p:nvPr/>
        </p:nvSpPr>
        <p:spPr>
          <a:xfrm>
            <a:off x="5159735" y="5907071"/>
            <a:ext cx="1224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Risk</a:t>
            </a:r>
            <a:r>
              <a:rPr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ratio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70F42A8F-6C3B-0120-FB34-359DAC3B179F}"/>
              </a:ext>
            </a:extLst>
          </p:cNvPr>
          <p:cNvSpPr txBox="1"/>
          <p:nvPr/>
        </p:nvSpPr>
        <p:spPr>
          <a:xfrm>
            <a:off x="5510159" y="5595239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05088897-667B-7B58-7B23-E0447E103306}"/>
              </a:ext>
            </a:extLst>
          </p:cNvPr>
          <p:cNvSpPr txBox="1"/>
          <p:nvPr/>
        </p:nvSpPr>
        <p:spPr>
          <a:xfrm>
            <a:off x="7949978" y="5600226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02F702D8-49BA-EA8E-C506-E2D324A0FBBD}"/>
              </a:ext>
            </a:extLst>
          </p:cNvPr>
          <p:cNvCxnSpPr>
            <a:cxnSpLocks/>
          </p:cNvCxnSpPr>
          <p:nvPr/>
        </p:nvCxnSpPr>
        <p:spPr>
          <a:xfrm flipV="1">
            <a:off x="4242429" y="5979431"/>
            <a:ext cx="3003665" cy="672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A7D3D18F-012B-D902-94B3-5BBF1D3AE0FF}"/>
              </a:ext>
            </a:extLst>
          </p:cNvPr>
          <p:cNvSpPr txBox="1"/>
          <p:nvPr/>
        </p:nvSpPr>
        <p:spPr>
          <a:xfrm>
            <a:off x="7375350" y="5790864"/>
            <a:ext cx="1702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Worse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0295B1E8-F50A-DF5F-90A1-3B750F15317E}"/>
              </a:ext>
            </a:extLst>
          </p:cNvPr>
          <p:cNvSpPr txBox="1"/>
          <p:nvPr/>
        </p:nvSpPr>
        <p:spPr>
          <a:xfrm>
            <a:off x="2439500" y="5786671"/>
            <a:ext cx="171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Better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C6175B71-0D61-3EA0-BA03-0A7826F2B7F4}"/>
              </a:ext>
            </a:extLst>
          </p:cNvPr>
          <p:cNvSpPr/>
          <p:nvPr/>
        </p:nvSpPr>
        <p:spPr>
          <a:xfrm>
            <a:off x="3169918" y="127467"/>
            <a:ext cx="5131726" cy="3895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A7E99F2-1387-32A0-6308-A378B8FC0A4B}"/>
              </a:ext>
            </a:extLst>
          </p:cNvPr>
          <p:cNvSpPr txBox="1"/>
          <p:nvPr/>
        </p:nvSpPr>
        <p:spPr>
          <a:xfrm>
            <a:off x="128229" y="6098144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2000" dirty="0">
                <a:solidFill>
                  <a:prstClr val="black"/>
                </a:solidFill>
              </a:rPr>
              <a:t>AV</a:t>
            </a:r>
            <a:r>
              <a:rPr lang="en-US" altLang="ja-JP" sz="2000" baseline="-25000" dirty="0">
                <a:solidFill>
                  <a:prstClr val="black"/>
                </a:solidFill>
              </a:rPr>
              <a:t>max</a:t>
            </a:r>
            <a:r>
              <a:rPr lang="en-US" altLang="ja-JP" sz="2000" dirty="0">
                <a:solidFill>
                  <a:prstClr val="black"/>
                </a:solidFill>
              </a:rPr>
              <a:t> = maximum aortic valve velocity; CI 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= confidence interval;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LVOT = left ventricular outflow tract; PVL = paravalvular leakage; RR = risk ratio. 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0A380A3-4CED-5790-63A7-776F59E07D19}"/>
              </a:ext>
            </a:extLst>
          </p:cNvPr>
          <p:cNvSpPr txBox="1"/>
          <p:nvPr/>
        </p:nvSpPr>
        <p:spPr>
          <a:xfrm>
            <a:off x="326969" y="48993"/>
            <a:ext cx="94752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10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B. </a:t>
            </a:r>
            <a:r>
              <a:rPr lang="en-US" altLang="ja-JP" sz="2000" dirty="0">
                <a:solidFill>
                  <a:prstClr val="black"/>
                </a:solidFill>
              </a:rPr>
              <a:t>Subanalysis for residual PVL at 3 months including AV</a:t>
            </a:r>
            <a:r>
              <a:rPr lang="en-US" altLang="ja-JP" sz="2000" baseline="-25000" dirty="0">
                <a:solidFill>
                  <a:prstClr val="black"/>
                </a:solidFill>
              </a:rPr>
              <a:t>max</a:t>
            </a:r>
            <a:r>
              <a:rPr lang="en-US" altLang="ja-JP" sz="2000" dirty="0">
                <a:solidFill>
                  <a:prstClr val="black"/>
                </a:solidFill>
              </a:rPr>
              <a:t> at baseline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8092919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7D842AB-29EE-240B-D940-5DB328AB820D}"/>
              </a:ext>
            </a:extLst>
          </p:cNvPr>
          <p:cNvSpPr txBox="1"/>
          <p:nvPr/>
        </p:nvSpPr>
        <p:spPr>
          <a:xfrm>
            <a:off x="128229" y="6098144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Kaplan-Meier curve shows no significant difference in the composite clinical outcome at 1 year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HF = heart failure; PVL = paravalvular leakage.</a:t>
            </a: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51096F71-9B4E-981E-FBB7-21F65D2641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6085" y="678225"/>
            <a:ext cx="6404737" cy="4398556"/>
          </a:xfrm>
          <a:prstGeom prst="rect">
            <a:avLst/>
          </a:prstGeom>
        </p:spPr>
      </p:pic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1F0CCFA-5168-0467-2A1F-2DC7B3312109}"/>
              </a:ext>
            </a:extLst>
          </p:cNvPr>
          <p:cNvSpPr txBox="1"/>
          <p:nvPr/>
        </p:nvSpPr>
        <p:spPr>
          <a:xfrm>
            <a:off x="8951065" y="3249141"/>
            <a:ext cx="9887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FI" sz="2000" b="1" dirty="0">
                <a:solidFill>
                  <a:srgbClr val="FF0000"/>
                </a:solidFill>
                <a:latin typeface="Calibri" panose="020F0502020204030204"/>
                <a:ea typeface="游ゴシック" panose="020B0400000000000000" pitchFamily="50" charset="-128"/>
              </a:rPr>
              <a:t>16.0</a:t>
            </a:r>
            <a:r>
              <a:rPr kumimoji="1" lang="en-US" altLang="ja-FI" sz="20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%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2A5DE49-29B1-D77D-0906-B3A01DF078EA}"/>
              </a:ext>
            </a:extLst>
          </p:cNvPr>
          <p:cNvSpPr txBox="1"/>
          <p:nvPr/>
        </p:nvSpPr>
        <p:spPr>
          <a:xfrm rot="16200000">
            <a:off x="-749783" y="2292303"/>
            <a:ext cx="528689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ll-cause death and/or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HF rehospitalisation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(%)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1697335-6F7A-0654-4F96-772F24EBBA29}"/>
              </a:ext>
            </a:extLst>
          </p:cNvPr>
          <p:cNvSpPr txBox="1"/>
          <p:nvPr/>
        </p:nvSpPr>
        <p:spPr>
          <a:xfrm>
            <a:off x="4990915" y="4996334"/>
            <a:ext cx="22101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Follow-up (months)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D9AF7A1-9F7F-FECC-EE73-EBB413136549}"/>
              </a:ext>
            </a:extLst>
          </p:cNvPr>
          <p:cNvSpPr txBox="1"/>
          <p:nvPr/>
        </p:nvSpPr>
        <p:spPr>
          <a:xfrm>
            <a:off x="2699629" y="4339504"/>
            <a:ext cx="48784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0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A809183-D278-9553-689B-4C14DB308A6C}"/>
              </a:ext>
            </a:extLst>
          </p:cNvPr>
          <p:cNvSpPr txBox="1"/>
          <p:nvPr/>
        </p:nvSpPr>
        <p:spPr>
          <a:xfrm>
            <a:off x="2642947" y="3122061"/>
            <a:ext cx="48784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2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0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FA3149FD-7156-0697-8A53-05D529BEA099}"/>
              </a:ext>
            </a:extLst>
          </p:cNvPr>
          <p:cNvSpPr txBox="1"/>
          <p:nvPr/>
        </p:nvSpPr>
        <p:spPr>
          <a:xfrm>
            <a:off x="2662215" y="672453"/>
            <a:ext cx="48784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6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0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B840622-AB9D-99EC-0866-13950591601E}"/>
              </a:ext>
            </a:extLst>
          </p:cNvPr>
          <p:cNvSpPr txBox="1"/>
          <p:nvPr/>
        </p:nvSpPr>
        <p:spPr>
          <a:xfrm>
            <a:off x="2602878" y="1877694"/>
            <a:ext cx="54718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4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0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5D92033-05D8-4BA6-C477-9FC2BEE9EA97}"/>
              </a:ext>
            </a:extLst>
          </p:cNvPr>
          <p:cNvSpPr txBox="1"/>
          <p:nvPr/>
        </p:nvSpPr>
        <p:spPr>
          <a:xfrm>
            <a:off x="2049519" y="5035696"/>
            <a:ext cx="22143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1800" b="0" i="0" u="sng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Number at risk</a:t>
            </a:r>
            <a:endParaRPr kumimoji="1" lang="ja-FI" altLang="en-US" sz="1800" b="0" i="0" u="sng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02DADC20-5500-6129-A0F9-C8A117010B7A}"/>
              </a:ext>
            </a:extLst>
          </p:cNvPr>
          <p:cNvSpPr txBox="1"/>
          <p:nvPr/>
        </p:nvSpPr>
        <p:spPr>
          <a:xfrm>
            <a:off x="3029070" y="5403126"/>
            <a:ext cx="425343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FI" dirty="0">
                <a:latin typeface="Calibri" panose="020F0502020204030204"/>
                <a:ea typeface="游ゴシック" panose="020B0400000000000000" pitchFamily="50" charset="-128"/>
              </a:rPr>
              <a:t>7</a:t>
            </a:r>
            <a:r>
              <a:rPr kumimoji="1" lang="en-US" altLang="ja-FI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1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F28A414A-D4B2-A807-5DC8-6A56A6F4996F}"/>
              </a:ext>
            </a:extLst>
          </p:cNvPr>
          <p:cNvSpPr txBox="1"/>
          <p:nvPr/>
        </p:nvSpPr>
        <p:spPr>
          <a:xfrm>
            <a:off x="4219681" y="5403126"/>
            <a:ext cx="882278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dirty="0">
                <a:latin typeface="Calibri" panose="020F0502020204030204"/>
                <a:ea typeface="游ゴシック" panose="020B0400000000000000" pitchFamily="50" charset="-128"/>
              </a:rPr>
              <a:t>69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DF95EDAC-55EA-CDCD-6906-D43519170FB8}"/>
              </a:ext>
            </a:extLst>
          </p:cNvPr>
          <p:cNvSpPr txBox="1"/>
          <p:nvPr/>
        </p:nvSpPr>
        <p:spPr>
          <a:xfrm>
            <a:off x="5635707" y="5405701"/>
            <a:ext cx="882278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dirty="0">
                <a:latin typeface="Calibri" panose="020F0502020204030204"/>
                <a:ea typeface="游ゴシック" panose="020B0400000000000000" pitchFamily="50" charset="-128"/>
              </a:rPr>
              <a:t>65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38910618-E93A-6568-955E-531161CC562B}"/>
              </a:ext>
            </a:extLst>
          </p:cNvPr>
          <p:cNvSpPr txBox="1"/>
          <p:nvPr/>
        </p:nvSpPr>
        <p:spPr>
          <a:xfrm>
            <a:off x="8468212" y="5403127"/>
            <a:ext cx="882278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dirty="0">
                <a:latin typeface="Calibri" panose="020F0502020204030204"/>
                <a:ea typeface="游ゴシック" panose="020B0400000000000000" pitchFamily="50" charset="-128"/>
              </a:rPr>
              <a:t>54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AE6C2523-CEBA-7FBE-58CB-0BF6782E7BEE}"/>
              </a:ext>
            </a:extLst>
          </p:cNvPr>
          <p:cNvCxnSpPr/>
          <p:nvPr/>
        </p:nvCxnSpPr>
        <p:spPr>
          <a:xfrm>
            <a:off x="3735339" y="1289838"/>
            <a:ext cx="456898" cy="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F909E1B3-7E75-F4BD-63BA-8E6EB941E61E}"/>
              </a:ext>
            </a:extLst>
          </p:cNvPr>
          <p:cNvCxnSpPr/>
          <p:nvPr/>
        </p:nvCxnSpPr>
        <p:spPr>
          <a:xfrm>
            <a:off x="3735339" y="1558823"/>
            <a:ext cx="45689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A27CD9D-BF16-ED3B-08B2-0F25AE5F3321}"/>
              </a:ext>
            </a:extLst>
          </p:cNvPr>
          <p:cNvSpPr txBox="1"/>
          <p:nvPr/>
        </p:nvSpPr>
        <p:spPr>
          <a:xfrm>
            <a:off x="4245031" y="1076544"/>
            <a:ext cx="26589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Improvement of PVL</a:t>
            </a:r>
            <a:endParaRPr kumimoji="1" lang="en-US" altLang="ja-FI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sz="2000" dirty="0">
                <a:solidFill>
                  <a:prstClr val="black"/>
                </a:solidFill>
                <a:latin typeface="Calibri" panose="020F0502020204030204"/>
              </a:rPr>
              <a:t>No improvement of PVL</a:t>
            </a:r>
            <a:endParaRPr kumimoji="1" lang="ja-FI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52DA1D2A-B6DB-03E5-354E-F00E5198F8CC}"/>
              </a:ext>
            </a:extLst>
          </p:cNvPr>
          <p:cNvCxnSpPr/>
          <p:nvPr/>
        </p:nvCxnSpPr>
        <p:spPr>
          <a:xfrm>
            <a:off x="2282223" y="5576060"/>
            <a:ext cx="456898" cy="0"/>
          </a:xfrm>
          <a:prstGeom prst="line">
            <a:avLst/>
          </a:prstGeom>
          <a:ln w="285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E358FFF9-96FF-264F-D6C2-2943C4449C43}"/>
              </a:ext>
            </a:extLst>
          </p:cNvPr>
          <p:cNvCxnSpPr/>
          <p:nvPr/>
        </p:nvCxnSpPr>
        <p:spPr>
          <a:xfrm>
            <a:off x="2275671" y="5925910"/>
            <a:ext cx="45689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FFCC5FB-1CDB-64DB-90ED-C5EB0373CCD9}"/>
              </a:ext>
            </a:extLst>
          </p:cNvPr>
          <p:cNvSpPr txBox="1"/>
          <p:nvPr/>
        </p:nvSpPr>
        <p:spPr>
          <a:xfrm>
            <a:off x="3022348" y="5743531"/>
            <a:ext cx="432065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dirty="0">
                <a:latin typeface="Calibri" panose="020F0502020204030204"/>
              </a:rPr>
              <a:t>89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E80C080-8326-95D8-335E-63374ADA70D6}"/>
              </a:ext>
            </a:extLst>
          </p:cNvPr>
          <p:cNvSpPr txBox="1"/>
          <p:nvPr/>
        </p:nvSpPr>
        <p:spPr>
          <a:xfrm>
            <a:off x="4288140" y="5743530"/>
            <a:ext cx="728663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dirty="0">
                <a:latin typeface="Calibri" panose="020F0502020204030204"/>
              </a:rPr>
              <a:t>81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E7E5D65-8E15-219B-66E0-41B3D83B1AD0}"/>
              </a:ext>
            </a:extLst>
          </p:cNvPr>
          <p:cNvSpPr txBox="1"/>
          <p:nvPr/>
        </p:nvSpPr>
        <p:spPr>
          <a:xfrm>
            <a:off x="5708020" y="5743529"/>
            <a:ext cx="728663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dirty="0">
                <a:latin typeface="Calibri" panose="020F0502020204030204"/>
                <a:ea typeface="游ゴシック" panose="020B0400000000000000" pitchFamily="50" charset="-128"/>
              </a:rPr>
              <a:t>78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16A1EB8-9D23-B31E-6F1B-8FE0E47D2956}"/>
              </a:ext>
            </a:extLst>
          </p:cNvPr>
          <p:cNvSpPr txBox="1"/>
          <p:nvPr/>
        </p:nvSpPr>
        <p:spPr>
          <a:xfrm>
            <a:off x="8550225" y="5743722"/>
            <a:ext cx="728663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dirty="0">
                <a:latin typeface="Calibri" panose="020F0502020204030204"/>
                <a:ea typeface="游ゴシック" panose="020B0400000000000000" pitchFamily="50" charset="-128"/>
              </a:rPr>
              <a:t>69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47984EB-9C94-4215-C246-FCA41AC3EC24}"/>
              </a:ext>
            </a:extLst>
          </p:cNvPr>
          <p:cNvSpPr txBox="1"/>
          <p:nvPr/>
        </p:nvSpPr>
        <p:spPr>
          <a:xfrm>
            <a:off x="8951065" y="3726044"/>
            <a:ext cx="9887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FI" sz="2000" b="1" dirty="0">
                <a:solidFill>
                  <a:srgbClr val="4472C4"/>
                </a:solidFill>
                <a:latin typeface="Calibri" panose="020F0502020204030204"/>
                <a:ea typeface="游ゴシック" panose="020B0400000000000000" pitchFamily="50" charset="-128"/>
              </a:rPr>
              <a:t>14.8</a:t>
            </a:r>
            <a:r>
              <a:rPr kumimoji="1" lang="en-US" altLang="ja-FI" sz="2000" b="1" i="0" u="none" strike="noStrike" kern="1200" cap="none" spc="0" normalizeH="0" baseline="0" noProof="0" dirty="0">
                <a:ln>
                  <a:noFill/>
                </a:ln>
                <a:solidFill>
                  <a:srgbClr val="4472C4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%</a:t>
            </a:r>
            <a:endParaRPr kumimoji="1" lang="ja-FI" altLang="en-US" sz="2000" b="1" i="0" u="none" strike="noStrike" kern="1200" cap="none" spc="0" normalizeH="0" baseline="0" noProof="0" dirty="0">
              <a:ln>
                <a:noFill/>
              </a:ln>
              <a:solidFill>
                <a:srgbClr val="4472C4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9036182-64CE-45AA-6D99-965B725AEB70}"/>
              </a:ext>
            </a:extLst>
          </p:cNvPr>
          <p:cNvSpPr txBox="1"/>
          <p:nvPr/>
        </p:nvSpPr>
        <p:spPr>
          <a:xfrm>
            <a:off x="3735339" y="1953926"/>
            <a:ext cx="22905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Log-rank:</a:t>
            </a:r>
            <a:r>
              <a:rPr kumimoji="1" lang="en-US" altLang="ja-FI" sz="20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p 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= 0.5544</a:t>
            </a:r>
            <a:endParaRPr kumimoji="1" lang="ja-FI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60F03CA-3BCB-19CD-9DEA-145C6888D2E7}"/>
              </a:ext>
            </a:extLst>
          </p:cNvPr>
          <p:cNvSpPr txBox="1"/>
          <p:nvPr/>
        </p:nvSpPr>
        <p:spPr>
          <a:xfrm>
            <a:off x="3010887" y="4712435"/>
            <a:ext cx="48784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0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68EAC21-A60E-2F17-8747-1AE432619DF3}"/>
              </a:ext>
            </a:extLst>
          </p:cNvPr>
          <p:cNvSpPr txBox="1"/>
          <p:nvPr/>
        </p:nvSpPr>
        <p:spPr>
          <a:xfrm>
            <a:off x="4432273" y="4712435"/>
            <a:ext cx="48784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3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F30B11C-1B4A-D0D9-5F91-6FA6AEF19D14}"/>
              </a:ext>
            </a:extLst>
          </p:cNvPr>
          <p:cNvSpPr txBox="1"/>
          <p:nvPr/>
        </p:nvSpPr>
        <p:spPr>
          <a:xfrm>
            <a:off x="5843760" y="4703851"/>
            <a:ext cx="48784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6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0A705A7-70DB-37AB-6060-EE746A97CB3B}"/>
              </a:ext>
            </a:extLst>
          </p:cNvPr>
          <p:cNvSpPr txBox="1"/>
          <p:nvPr/>
        </p:nvSpPr>
        <p:spPr>
          <a:xfrm>
            <a:off x="7153669" y="4703851"/>
            <a:ext cx="680299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9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8723F55-73AF-7213-5B96-30B42EAEAF88}"/>
              </a:ext>
            </a:extLst>
          </p:cNvPr>
          <p:cNvSpPr txBox="1"/>
          <p:nvPr/>
        </p:nvSpPr>
        <p:spPr>
          <a:xfrm>
            <a:off x="8569009" y="4703851"/>
            <a:ext cx="680299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12</a:t>
            </a:r>
            <a:endParaRPr kumimoji="1" lang="en-US" altLang="ja-FI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F92DF7-5028-A98E-3F69-0A2CAB4921CF}"/>
              </a:ext>
            </a:extLst>
          </p:cNvPr>
          <p:cNvSpPr txBox="1"/>
          <p:nvPr/>
        </p:nvSpPr>
        <p:spPr>
          <a:xfrm>
            <a:off x="7040646" y="5403126"/>
            <a:ext cx="882278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dirty="0">
                <a:latin typeface="Calibri" panose="020F0502020204030204"/>
                <a:ea typeface="游ゴシック" panose="020B0400000000000000" pitchFamily="50" charset="-128"/>
              </a:rPr>
              <a:t>62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EC48CD5-2A4E-2615-95E1-2D449FF48D05}"/>
              </a:ext>
            </a:extLst>
          </p:cNvPr>
          <p:cNvSpPr txBox="1"/>
          <p:nvPr/>
        </p:nvSpPr>
        <p:spPr>
          <a:xfrm>
            <a:off x="7122659" y="5743721"/>
            <a:ext cx="728663" cy="380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dirty="0">
                <a:latin typeface="Calibri" panose="020F0502020204030204"/>
                <a:ea typeface="游ゴシック" panose="020B0400000000000000" pitchFamily="50" charset="-128"/>
              </a:rPr>
              <a:t>75</a:t>
            </a:r>
            <a:endParaRPr kumimoji="1" lang="ja-FI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4FC7235-6276-57BC-898E-CBE9A9A213CD}"/>
              </a:ext>
            </a:extLst>
          </p:cNvPr>
          <p:cNvSpPr txBox="1"/>
          <p:nvPr/>
        </p:nvSpPr>
        <p:spPr>
          <a:xfrm>
            <a:off x="128229" y="48995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 </a:t>
            </a:r>
            <a:r>
              <a:rPr lang="en-US" altLang="ja-JP" sz="2000" dirty="0">
                <a:latin typeface="Calibri" panose="020F0502020204030204"/>
                <a:ea typeface="游ゴシック" panose="020B0400000000000000" pitchFamily="50" charset="-128"/>
              </a:rPr>
              <a:t>11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. Comparison of all-cause death and/or heart failure rehospitalisation between patients with improvement of 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paravalvular leakage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and those without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09064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E4ADBA4-2FF2-3910-95D9-C9A2E4779AA3}"/>
              </a:ext>
            </a:extLst>
          </p:cNvPr>
          <p:cNvSpPr txBox="1"/>
          <p:nvPr/>
        </p:nvSpPr>
        <p:spPr>
          <a:xfrm>
            <a:off x="128229" y="5793342"/>
            <a:ext cx="1194185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The ROC curve shows that the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cut-off value is 358.6 mm</a:t>
            </a:r>
            <a:r>
              <a:rPr lang="en-US" altLang="ja-JP" sz="2000" baseline="30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3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with a sensitivity of 46.7% and specificity of 78.0%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UC = area under the curve; </a:t>
            </a:r>
            <a:r>
              <a:rPr lang="en-US" altLang="ja-JP" sz="2000" dirty="0">
                <a:latin typeface="Calibri" panose="020F0502020204030204"/>
                <a:ea typeface="游ゴシック" panose="020B0400000000000000" pitchFamily="50" charset="-128"/>
              </a:rPr>
              <a:t>CI = confidence interval; 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PVL = paravalvular leakage; ROC curve = receiver operating characteristic curve.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D3B957A8-394D-2289-310B-384BDA2070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3263" y="756881"/>
            <a:ext cx="4965469" cy="5040637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2A5DE49-29B1-D77D-0906-B3A01DF078EA}"/>
              </a:ext>
            </a:extLst>
          </p:cNvPr>
          <p:cNvSpPr txBox="1"/>
          <p:nvPr/>
        </p:nvSpPr>
        <p:spPr>
          <a:xfrm rot="16200000">
            <a:off x="2581959" y="2946861"/>
            <a:ext cx="14901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ensitivity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1697335-6F7A-0654-4F96-772F24EBBA29}"/>
              </a:ext>
            </a:extLst>
          </p:cNvPr>
          <p:cNvSpPr txBox="1"/>
          <p:nvPr/>
        </p:nvSpPr>
        <p:spPr>
          <a:xfrm>
            <a:off x="5184731" y="5208567"/>
            <a:ext cx="18225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1 - Specificity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AF8428D-C349-9018-D11D-D6CC60FD92A7}"/>
              </a:ext>
            </a:extLst>
          </p:cNvPr>
          <p:cNvSpPr txBox="1"/>
          <p:nvPr/>
        </p:nvSpPr>
        <p:spPr>
          <a:xfrm>
            <a:off x="5929718" y="3005900"/>
            <a:ext cx="2275678" cy="163121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UC: 0.66</a:t>
            </a: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;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95% CI: 0.59</a:t>
            </a:r>
            <a:r>
              <a:rPr kumimoji="1" lang="fr-FR" alt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0.72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Cut-off = 358.6 mm</a:t>
            </a:r>
            <a:r>
              <a:rPr kumimoji="1" lang="en-US" altLang="ja-FI" sz="20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3</a:t>
            </a:r>
            <a:endParaRPr kumimoji="1" lang="en-US" altLang="ja-FI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ensitivity: 46.7%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pecificity: </a:t>
            </a: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78.0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%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34C3932-8452-626B-6CE5-B6D9CFCD6703}"/>
              </a:ext>
            </a:extLst>
          </p:cNvPr>
          <p:cNvSpPr txBox="1"/>
          <p:nvPr/>
        </p:nvSpPr>
        <p:spPr>
          <a:xfrm>
            <a:off x="128229" y="48995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 </a:t>
            </a:r>
            <a:r>
              <a:rPr lang="en-US" altLang="ja-JP" sz="2000" dirty="0">
                <a:latin typeface="Calibri" panose="020F0502020204030204"/>
                <a:ea typeface="游ゴシック" panose="020B0400000000000000" pitchFamily="50" charset="-128"/>
              </a:rPr>
              <a:t>5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. Receiver operating characteristic curve evaluating the calcium volume of the aortic leaflets threshold for predicting mild grade or higher paravalvular leakage at 3 months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503315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E3BA74-33A6-3205-8D29-F15061FFE8E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0C22D622-CF83-1B69-BF89-18E1E5B708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3262" y="756881"/>
            <a:ext cx="4965469" cy="503646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33CB1CC-8708-F6FA-0A83-9BC0BF44427C}"/>
              </a:ext>
            </a:extLst>
          </p:cNvPr>
          <p:cNvSpPr txBox="1"/>
          <p:nvPr/>
        </p:nvSpPr>
        <p:spPr>
          <a:xfrm>
            <a:off x="128229" y="5793342"/>
            <a:ext cx="1194185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The ROC curve shows that the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cut-off value is 331.7 mm</a:t>
            </a:r>
            <a:r>
              <a:rPr lang="en-US" altLang="ja-JP" sz="2000" baseline="30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3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with a sensitivity of 52.4% and specificity of 80.5%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UC = area under the curve; </a:t>
            </a:r>
            <a:r>
              <a:rPr lang="en-US" altLang="ja-JP" sz="2000" dirty="0">
                <a:latin typeface="Calibri" panose="020F0502020204030204"/>
                <a:ea typeface="游ゴシック" panose="020B0400000000000000" pitchFamily="50" charset="-128"/>
              </a:rPr>
              <a:t>CI = confidence interval; 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PVL = paravalvular leakage; ROC curve = receiver operating characteristic curve.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7040780-C0A5-6DB9-43BE-D2BC2A8CB855}"/>
              </a:ext>
            </a:extLst>
          </p:cNvPr>
          <p:cNvSpPr txBox="1"/>
          <p:nvPr/>
        </p:nvSpPr>
        <p:spPr>
          <a:xfrm rot="16200000">
            <a:off x="2581959" y="2946861"/>
            <a:ext cx="14901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ensitivity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6C6E9A4-90EE-7189-03C0-5A2F2507B76F}"/>
              </a:ext>
            </a:extLst>
          </p:cNvPr>
          <p:cNvSpPr txBox="1"/>
          <p:nvPr/>
        </p:nvSpPr>
        <p:spPr>
          <a:xfrm>
            <a:off x="5184731" y="5208567"/>
            <a:ext cx="18225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1 - Specificity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78FD074-9DC1-9BED-842F-75176339C690}"/>
              </a:ext>
            </a:extLst>
          </p:cNvPr>
          <p:cNvSpPr txBox="1"/>
          <p:nvPr/>
        </p:nvSpPr>
        <p:spPr>
          <a:xfrm>
            <a:off x="5929718" y="3005900"/>
            <a:ext cx="2275678" cy="163121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UC: 0.69</a:t>
            </a: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;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95% CI: 0.56</a:t>
            </a:r>
            <a:r>
              <a:rPr kumimoji="1" lang="fr-FR" alt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0.82</a:t>
            </a:r>
            <a:endParaRPr kumimoji="1" lang="en-US" altLang="ja-FI" sz="2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Cut-off = 331.7 mm</a:t>
            </a:r>
            <a:r>
              <a:rPr kumimoji="1" lang="en-US" altLang="ja-FI" sz="20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3</a:t>
            </a:r>
            <a:endParaRPr kumimoji="1" lang="en-US" altLang="ja-FI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ensitivity: </a:t>
            </a: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52.4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%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pecificity: 80.5%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BE2EB5B-848A-4628-B46E-98610BFA611F}"/>
              </a:ext>
            </a:extLst>
          </p:cNvPr>
          <p:cNvSpPr txBox="1"/>
          <p:nvPr/>
        </p:nvSpPr>
        <p:spPr>
          <a:xfrm>
            <a:off x="128229" y="48995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 </a:t>
            </a:r>
            <a:r>
              <a:rPr lang="en-US" altLang="ja-JP" sz="2000" dirty="0">
                <a:latin typeface="Calibri" panose="020F0502020204030204"/>
                <a:ea typeface="游ゴシック" panose="020B0400000000000000" pitchFamily="50" charset="-128"/>
              </a:rPr>
              <a:t>6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. Receiver operating characteristic curve evaluating the calcium volume of the aortic leaflets threshold for predicting mild grade or higher paravalvular leakage at 3 months in ACURATE neo2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517594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014A5EC-B3AD-359E-3D1F-B9902EBD0A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9C8324F-0035-B293-6BDE-0D864F390F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3263" y="756881"/>
            <a:ext cx="4965470" cy="503646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8FCA60-F192-5553-1C0D-DC10F1F684F9}"/>
              </a:ext>
            </a:extLst>
          </p:cNvPr>
          <p:cNvSpPr txBox="1"/>
          <p:nvPr/>
        </p:nvSpPr>
        <p:spPr>
          <a:xfrm>
            <a:off x="128229" y="5793342"/>
            <a:ext cx="1194185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The ROC curve shows that the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cut-off value is 464.0 mm</a:t>
            </a:r>
            <a:r>
              <a:rPr lang="en-US" altLang="ja-JP" sz="2000" baseline="30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3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with a sensitivity of 36.2% and specificity of 86.2%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UC = area under the curve; </a:t>
            </a:r>
            <a:r>
              <a:rPr lang="en-US" altLang="ja-JP" sz="2000" dirty="0">
                <a:latin typeface="Calibri" panose="020F0502020204030204"/>
                <a:ea typeface="游ゴシック" panose="020B0400000000000000" pitchFamily="50" charset="-128"/>
              </a:rPr>
              <a:t>CI = confidence interval; 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PVL = paravalvular leakage; ROC curve = receiver operating characteristic curve.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76F6E8E4-4F50-B10A-B31C-324AE1D5B74B}"/>
              </a:ext>
            </a:extLst>
          </p:cNvPr>
          <p:cNvSpPr txBox="1"/>
          <p:nvPr/>
        </p:nvSpPr>
        <p:spPr>
          <a:xfrm rot="16200000">
            <a:off x="2581959" y="2946861"/>
            <a:ext cx="14901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ensitivity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AF9B095-F4A9-49EA-13EB-B2F72169F54A}"/>
              </a:ext>
            </a:extLst>
          </p:cNvPr>
          <p:cNvSpPr txBox="1"/>
          <p:nvPr/>
        </p:nvSpPr>
        <p:spPr>
          <a:xfrm>
            <a:off x="5184731" y="5208567"/>
            <a:ext cx="18225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1 - Specificity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91510FE-5FCD-8FC3-BE7D-3418133809C0}"/>
              </a:ext>
            </a:extLst>
          </p:cNvPr>
          <p:cNvSpPr txBox="1"/>
          <p:nvPr/>
        </p:nvSpPr>
        <p:spPr>
          <a:xfrm>
            <a:off x="5929718" y="3005900"/>
            <a:ext cx="2275678" cy="1631216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UC: 0.63</a:t>
            </a: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;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95% CI: 0.56</a:t>
            </a:r>
            <a:r>
              <a:rPr kumimoji="1" lang="fr-FR" alt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0.71</a:t>
            </a:r>
            <a:endParaRPr kumimoji="1" lang="en-US" altLang="ja-FI" sz="2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Cut-off = </a:t>
            </a: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464.0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mm</a:t>
            </a:r>
            <a:r>
              <a:rPr kumimoji="1" lang="en-US" altLang="ja-FI" sz="20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3</a:t>
            </a:r>
            <a:endParaRPr kumimoji="1" lang="en-US" altLang="ja-FI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ensitivity: </a:t>
            </a:r>
            <a:r>
              <a:rPr lang="en-US" altLang="ja-FI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36.2</a:t>
            </a: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%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FI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Specificity: 86.2%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AD07477-FEE6-5E15-3384-071D2F405A85}"/>
              </a:ext>
            </a:extLst>
          </p:cNvPr>
          <p:cNvSpPr txBox="1"/>
          <p:nvPr/>
        </p:nvSpPr>
        <p:spPr>
          <a:xfrm>
            <a:off x="128229" y="48995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 </a:t>
            </a:r>
            <a:r>
              <a:rPr lang="en-US" altLang="ja-JP" sz="2000" dirty="0">
                <a:latin typeface="Calibri" panose="020F0502020204030204"/>
                <a:ea typeface="游ゴシック" panose="020B0400000000000000" pitchFamily="50" charset="-128"/>
              </a:rPr>
              <a:t>6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B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. Receiver operating characteristic curve evaluating the calcium volume of the aortic leaflets threshold for predicting mild grade or higher paravalvular leakage at 3 months in ACURATE neo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440475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933184B-3D6D-294E-3B45-03A51DBC36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id="{691C1CB5-6FA4-A73E-B759-EC3F14FD8C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3747398"/>
              </p:ext>
            </p:extLst>
          </p:nvPr>
        </p:nvGraphicFramePr>
        <p:xfrm>
          <a:off x="8209869" y="1626133"/>
          <a:ext cx="3848650" cy="3725073"/>
        </p:xfrm>
        <a:graphic>
          <a:graphicData uri="http://schemas.openxmlformats.org/drawingml/2006/table">
            <a:tbl>
              <a:tblPr firstRow="1" bandRow="1"/>
              <a:tblGrid>
                <a:gridCol w="877285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  <a:gridCol w="1594085">
                  <a:extLst>
                    <a:ext uri="{9D8B030D-6E8A-4147-A177-3AD203B41FA5}">
                      <a16:colId xmlns:a16="http://schemas.microsoft.com/office/drawing/2014/main" val="1579887003"/>
                    </a:ext>
                  </a:extLst>
                </a:gridCol>
                <a:gridCol w="1377280">
                  <a:extLst>
                    <a:ext uri="{9D8B030D-6E8A-4147-A177-3AD203B41FA5}">
                      <a16:colId xmlns:a16="http://schemas.microsoft.com/office/drawing/2014/main" val="3773613209"/>
                    </a:ext>
                  </a:extLst>
                </a:gridCol>
              </a:tblGrid>
              <a:tr h="5052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R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95%CI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i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-value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7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24 – 2.4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1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8 – 0.9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28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2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2 – 2.0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477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4 – 1.0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63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2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9 – 1.9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36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2 – 1.1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22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6229845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3FC842F5-F896-0202-27ED-20218F8C4D8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2266629"/>
              </p:ext>
            </p:extLst>
          </p:nvPr>
        </p:nvGraphicFramePr>
        <p:xfrm>
          <a:off x="326969" y="1729174"/>
          <a:ext cx="2956731" cy="3746267"/>
        </p:xfrm>
        <a:graphic>
          <a:graphicData uri="http://schemas.openxmlformats.org/drawingml/2006/table">
            <a:tbl>
              <a:tblPr firstRow="1" bandRow="1"/>
              <a:tblGrid>
                <a:gridCol w="2956731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</a:tblGrid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URATE neo2 (vs. neo)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V</a:t>
                      </a:r>
                      <a:r>
                        <a:rPr lang="en-US" sz="1800" kern="0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</a:t>
                      </a: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, per 100 mm</a:t>
                      </a:r>
                      <a:r>
                        <a:rPr lang="en-US" sz="1800" kern="0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vere LVOT calcific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altLang="ja-JP" sz="1800" kern="100" dirty="0">
                          <a:solidFill>
                            <a:schemeClr val="dk1"/>
                          </a:solidFill>
                          <a:effectLst/>
                          <a:latin typeface="Calibri" panose="020F0502020204030204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versizing index, per 1 % 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ost-dilat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mplantation depth, per 1 mm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410382"/>
                  </a:ext>
                </a:extLst>
              </a:tr>
            </a:tbl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F653604B-E660-8B0E-E2E3-EA0079DA6CD4}"/>
              </a:ext>
            </a:extLst>
          </p:cNvPr>
          <p:cNvCxnSpPr>
            <a:cxnSpLocks/>
          </p:cNvCxnSpPr>
          <p:nvPr/>
        </p:nvCxnSpPr>
        <p:spPr>
          <a:xfrm>
            <a:off x="404553" y="5635934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88338AFE-3CD3-795F-58BC-0EE375936046}"/>
              </a:ext>
            </a:extLst>
          </p:cNvPr>
          <p:cNvCxnSpPr>
            <a:cxnSpLocks/>
          </p:cNvCxnSpPr>
          <p:nvPr/>
        </p:nvCxnSpPr>
        <p:spPr>
          <a:xfrm>
            <a:off x="404553" y="1310551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F567584-D066-72BF-00BF-32AAEB3AED60}"/>
              </a:ext>
            </a:extLst>
          </p:cNvPr>
          <p:cNvSpPr txBox="1"/>
          <p:nvPr/>
        </p:nvSpPr>
        <p:spPr>
          <a:xfrm>
            <a:off x="326969" y="54535"/>
            <a:ext cx="117315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7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. Subanalysis for PVL improvement in patients with tricuspid aortic valve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D1CEFE4-526B-5F6C-CEBA-6F5DEB71D6C6}"/>
              </a:ext>
            </a:extLst>
          </p:cNvPr>
          <p:cNvSpPr txBox="1"/>
          <p:nvPr/>
        </p:nvSpPr>
        <p:spPr>
          <a:xfrm>
            <a:off x="3034222" y="5595474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0.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9B9777D-0FDE-C23C-FA4F-1832A61EFDF2}"/>
              </a:ext>
            </a:extLst>
          </p:cNvPr>
          <p:cNvSpPr txBox="1"/>
          <p:nvPr/>
        </p:nvSpPr>
        <p:spPr>
          <a:xfrm>
            <a:off x="5159735" y="5907071"/>
            <a:ext cx="1224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Risk</a:t>
            </a:r>
            <a:r>
              <a:rPr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ratio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C23B4B4-988D-317C-963D-480C4B170834}"/>
              </a:ext>
            </a:extLst>
          </p:cNvPr>
          <p:cNvSpPr txBox="1"/>
          <p:nvPr/>
        </p:nvSpPr>
        <p:spPr>
          <a:xfrm>
            <a:off x="5510159" y="5595239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DAA8ED1-A53C-457E-BF33-93FAD0EA56AB}"/>
              </a:ext>
            </a:extLst>
          </p:cNvPr>
          <p:cNvSpPr txBox="1"/>
          <p:nvPr/>
        </p:nvSpPr>
        <p:spPr>
          <a:xfrm>
            <a:off x="7949978" y="5600226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5231905B-3690-5526-6892-348EDF1FF4B6}"/>
              </a:ext>
            </a:extLst>
          </p:cNvPr>
          <p:cNvCxnSpPr>
            <a:cxnSpLocks/>
          </p:cNvCxnSpPr>
          <p:nvPr/>
        </p:nvCxnSpPr>
        <p:spPr>
          <a:xfrm flipV="1">
            <a:off x="4242429" y="5979431"/>
            <a:ext cx="3003665" cy="672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DDD6057B-9AD1-0293-FCC7-ECC5EE2BEE07}"/>
              </a:ext>
            </a:extLst>
          </p:cNvPr>
          <p:cNvSpPr txBox="1"/>
          <p:nvPr/>
        </p:nvSpPr>
        <p:spPr>
          <a:xfrm>
            <a:off x="7391977" y="5790864"/>
            <a:ext cx="1650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Better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3B087268-226C-896B-83D4-59E005D41ABC}"/>
              </a:ext>
            </a:extLst>
          </p:cNvPr>
          <p:cNvSpPr txBox="1"/>
          <p:nvPr/>
        </p:nvSpPr>
        <p:spPr>
          <a:xfrm>
            <a:off x="2439500" y="5786671"/>
            <a:ext cx="171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Worse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FAC78B70-A426-BC32-EC4E-9AA9B52AFF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6987299"/>
              </p:ext>
            </p:extLst>
          </p:nvPr>
        </p:nvGraphicFramePr>
        <p:xfrm>
          <a:off x="3169916" y="1180409"/>
          <a:ext cx="5199696" cy="4592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598D386-CB10-BD60-1F13-D1AA905AD4CA}"/>
              </a:ext>
            </a:extLst>
          </p:cNvPr>
          <p:cNvSpPr txBox="1"/>
          <p:nvPr/>
        </p:nvSpPr>
        <p:spPr>
          <a:xfrm>
            <a:off x="128229" y="6098144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CI = confidence interval;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LVOT = left ventricular outflow tract; PVL = paravalvular leakage; RR = risk ratio. </a:t>
            </a:r>
          </a:p>
        </p:txBody>
      </p:sp>
    </p:spTree>
    <p:extLst>
      <p:ext uri="{BB962C8B-B14F-4D97-AF65-F5344CB8AC3E}">
        <p14:creationId xmlns:p14="http://schemas.microsoft.com/office/powerpoint/2010/main" val="16036266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F47147-6958-EBE1-894C-A7EC4CCB798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id="{B8BF43EF-12A7-DC09-5193-6F04C0FBF2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4155305"/>
              </p:ext>
            </p:extLst>
          </p:nvPr>
        </p:nvGraphicFramePr>
        <p:xfrm>
          <a:off x="8209869" y="1626133"/>
          <a:ext cx="3848650" cy="3725073"/>
        </p:xfrm>
        <a:graphic>
          <a:graphicData uri="http://schemas.openxmlformats.org/drawingml/2006/table">
            <a:tbl>
              <a:tblPr firstRow="1" bandRow="1"/>
              <a:tblGrid>
                <a:gridCol w="877285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  <a:gridCol w="1594085">
                  <a:extLst>
                    <a:ext uri="{9D8B030D-6E8A-4147-A177-3AD203B41FA5}">
                      <a16:colId xmlns:a16="http://schemas.microsoft.com/office/drawing/2014/main" val="1579887003"/>
                    </a:ext>
                  </a:extLst>
                </a:gridCol>
                <a:gridCol w="1377280">
                  <a:extLst>
                    <a:ext uri="{9D8B030D-6E8A-4147-A177-3AD203B41FA5}">
                      <a16:colId xmlns:a16="http://schemas.microsoft.com/office/drawing/2014/main" val="3773613209"/>
                    </a:ext>
                  </a:extLst>
                </a:gridCol>
              </a:tblGrid>
              <a:tr h="5052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R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95%CI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i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-value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1 – 0.8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8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2 – 1.0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&lt;0.000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4 – 2.1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30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5 – 1.0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44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6 – 1.8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641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5 – 1.0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245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6229845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85CE2C1C-8B7A-E0C4-5E54-E24DA5E5A7C6}"/>
              </a:ext>
            </a:extLst>
          </p:cNvPr>
          <p:cNvGraphicFramePr>
            <a:graphicFrameLocks noGrp="1"/>
          </p:cNvGraphicFramePr>
          <p:nvPr/>
        </p:nvGraphicFramePr>
        <p:xfrm>
          <a:off x="326969" y="1729174"/>
          <a:ext cx="2956731" cy="3746267"/>
        </p:xfrm>
        <a:graphic>
          <a:graphicData uri="http://schemas.openxmlformats.org/drawingml/2006/table">
            <a:tbl>
              <a:tblPr firstRow="1" bandRow="1"/>
              <a:tblGrid>
                <a:gridCol w="2956731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</a:tblGrid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URATE neo2 (vs. neo)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V</a:t>
                      </a:r>
                      <a:r>
                        <a:rPr lang="en-US" sz="1800" kern="0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</a:t>
                      </a: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, per 100 mm</a:t>
                      </a:r>
                      <a:r>
                        <a:rPr lang="en-US" sz="1800" kern="0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vere LVOT calcific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altLang="ja-JP" sz="1800" kern="100" dirty="0">
                          <a:solidFill>
                            <a:schemeClr val="dk1"/>
                          </a:solidFill>
                          <a:effectLst/>
                          <a:latin typeface="Calibri" panose="020F0502020204030204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versizing index, per 1 % 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ost-dilat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mplantation depth, per 1 mm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410382"/>
                  </a:ext>
                </a:extLst>
              </a:tr>
            </a:tbl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7765186A-C24B-0A76-8082-480BD1C6053A}"/>
              </a:ext>
            </a:extLst>
          </p:cNvPr>
          <p:cNvCxnSpPr>
            <a:cxnSpLocks/>
          </p:cNvCxnSpPr>
          <p:nvPr/>
        </p:nvCxnSpPr>
        <p:spPr>
          <a:xfrm>
            <a:off x="404553" y="5635934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336F3340-F6DF-0848-DC8B-B46A292DE0B4}"/>
              </a:ext>
            </a:extLst>
          </p:cNvPr>
          <p:cNvCxnSpPr>
            <a:cxnSpLocks/>
          </p:cNvCxnSpPr>
          <p:nvPr/>
        </p:nvCxnSpPr>
        <p:spPr>
          <a:xfrm>
            <a:off x="404553" y="1310549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8EFE6B26-2365-6D24-50EB-56BA8D64B4E7}"/>
              </a:ext>
            </a:extLst>
          </p:cNvPr>
          <p:cNvSpPr txBox="1"/>
          <p:nvPr/>
        </p:nvSpPr>
        <p:spPr>
          <a:xfrm>
            <a:off x="326969" y="54535"/>
            <a:ext cx="104250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7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B. </a:t>
            </a:r>
            <a:r>
              <a:rPr lang="en-US" altLang="ja-JP" sz="2000" dirty="0">
                <a:solidFill>
                  <a:prstClr val="black"/>
                </a:solidFill>
              </a:rPr>
              <a:t>Subanalysis for residual PVL at 3 months in patients with tricuspid aortic valve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5AB72E8-C811-B9ED-4A6B-37B13966B725}"/>
              </a:ext>
            </a:extLst>
          </p:cNvPr>
          <p:cNvSpPr txBox="1"/>
          <p:nvPr/>
        </p:nvSpPr>
        <p:spPr>
          <a:xfrm>
            <a:off x="3034222" y="5595474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0.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5A16381-B8F0-7735-81E3-00964AA3D509}"/>
              </a:ext>
            </a:extLst>
          </p:cNvPr>
          <p:cNvSpPr txBox="1"/>
          <p:nvPr/>
        </p:nvSpPr>
        <p:spPr>
          <a:xfrm>
            <a:off x="5159735" y="5907071"/>
            <a:ext cx="1224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Risk</a:t>
            </a:r>
            <a:r>
              <a:rPr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ratio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D1352D45-57D8-C5F1-0A0E-93CDADD53E21}"/>
              </a:ext>
            </a:extLst>
          </p:cNvPr>
          <p:cNvSpPr txBox="1"/>
          <p:nvPr/>
        </p:nvSpPr>
        <p:spPr>
          <a:xfrm>
            <a:off x="5510159" y="5595239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C09C6C32-CF74-6365-DDFC-FB017BB4DFB0}"/>
              </a:ext>
            </a:extLst>
          </p:cNvPr>
          <p:cNvSpPr txBox="1"/>
          <p:nvPr/>
        </p:nvSpPr>
        <p:spPr>
          <a:xfrm>
            <a:off x="7949978" y="5600226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E60D3D54-87D8-97B1-F401-D1191D9B2C92}"/>
              </a:ext>
            </a:extLst>
          </p:cNvPr>
          <p:cNvCxnSpPr>
            <a:cxnSpLocks/>
          </p:cNvCxnSpPr>
          <p:nvPr/>
        </p:nvCxnSpPr>
        <p:spPr>
          <a:xfrm flipV="1">
            <a:off x="4242429" y="5979431"/>
            <a:ext cx="3003665" cy="672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C4FD293-45D1-E0FE-5E2B-DCA47D811363}"/>
              </a:ext>
            </a:extLst>
          </p:cNvPr>
          <p:cNvSpPr txBox="1"/>
          <p:nvPr/>
        </p:nvSpPr>
        <p:spPr>
          <a:xfrm>
            <a:off x="7391976" y="5790864"/>
            <a:ext cx="17658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Worse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37F08EDE-27D1-5E21-E3B6-5F86F614CDCA}"/>
              </a:ext>
            </a:extLst>
          </p:cNvPr>
          <p:cNvSpPr txBox="1"/>
          <p:nvPr/>
        </p:nvSpPr>
        <p:spPr>
          <a:xfrm>
            <a:off x="2439500" y="5786671"/>
            <a:ext cx="171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Better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DBC7FCC1-9212-666B-24C4-F267F123CF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6200191"/>
              </p:ext>
            </p:extLst>
          </p:nvPr>
        </p:nvGraphicFramePr>
        <p:xfrm>
          <a:off x="3169917" y="1180413"/>
          <a:ext cx="5199694" cy="45850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F81EAE0-5C3C-BA32-708E-901F9A3F6DED}"/>
              </a:ext>
            </a:extLst>
          </p:cNvPr>
          <p:cNvSpPr txBox="1"/>
          <p:nvPr/>
        </p:nvSpPr>
        <p:spPr>
          <a:xfrm>
            <a:off x="128229" y="6098144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CI = confidence interval;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LVOT = left ventricular outflow tract; PVL = paravalvular leakage; RR = risk ratio. </a:t>
            </a:r>
          </a:p>
        </p:txBody>
      </p:sp>
    </p:spTree>
    <p:extLst>
      <p:ext uri="{BB962C8B-B14F-4D97-AF65-F5344CB8AC3E}">
        <p14:creationId xmlns:p14="http://schemas.microsoft.com/office/powerpoint/2010/main" val="27472202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696A86-F1D2-C014-BEC0-4AB39AA0E6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id="{16783A7B-E581-2A3E-E7AC-6E32EE9F98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1986474"/>
              </p:ext>
            </p:extLst>
          </p:nvPr>
        </p:nvGraphicFramePr>
        <p:xfrm>
          <a:off x="8209869" y="1092733"/>
          <a:ext cx="3848650" cy="4261705"/>
        </p:xfrm>
        <a:graphic>
          <a:graphicData uri="http://schemas.openxmlformats.org/drawingml/2006/table">
            <a:tbl>
              <a:tblPr firstRow="1" bandRow="1"/>
              <a:tblGrid>
                <a:gridCol w="877285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  <a:gridCol w="1594085">
                  <a:extLst>
                    <a:ext uri="{9D8B030D-6E8A-4147-A177-3AD203B41FA5}">
                      <a16:colId xmlns:a16="http://schemas.microsoft.com/office/drawing/2014/main" val="1579887003"/>
                    </a:ext>
                  </a:extLst>
                </a:gridCol>
                <a:gridCol w="1377280">
                  <a:extLst>
                    <a:ext uri="{9D8B030D-6E8A-4147-A177-3AD203B41FA5}">
                      <a16:colId xmlns:a16="http://schemas.microsoft.com/office/drawing/2014/main" val="3773613209"/>
                    </a:ext>
                  </a:extLst>
                </a:gridCol>
              </a:tblGrid>
              <a:tr h="5052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R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95%CI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i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-value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6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21 – 2.3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2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1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4 – 2.2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82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3 – 0.8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10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9 – 1.6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78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5 – 1.0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38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4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9 – 2.2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55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3 – 1.1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61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6229845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6A900429-5A7A-6E4A-A384-559745094D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8128281"/>
              </p:ext>
            </p:extLst>
          </p:nvPr>
        </p:nvGraphicFramePr>
        <p:xfrm>
          <a:off x="326969" y="1195774"/>
          <a:ext cx="2956731" cy="4281448"/>
        </p:xfrm>
        <a:graphic>
          <a:graphicData uri="http://schemas.openxmlformats.org/drawingml/2006/table">
            <a:tbl>
              <a:tblPr firstRow="1" bandRow="1"/>
              <a:tblGrid>
                <a:gridCol w="2956731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</a:tblGrid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URATE neo2 (vs. neo)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icuspid aortic valve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V</a:t>
                      </a:r>
                      <a:r>
                        <a:rPr lang="en-US" sz="1800" kern="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</a:t>
                      </a:r>
                      <a:r>
                        <a:rPr lang="en-US" sz="1800" kern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≥358.6 mm</a:t>
                      </a:r>
                      <a:r>
                        <a:rPr lang="en-US" sz="1800" kern="0" baseline="30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vere LVOT calcific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altLang="ja-JP" sz="1800" kern="100" dirty="0">
                          <a:solidFill>
                            <a:schemeClr val="dk1"/>
                          </a:solidFill>
                          <a:effectLst/>
                          <a:latin typeface="Calibri" panose="020F0502020204030204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versizing index, per 1 % 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ost-dilat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mplantation depth, per 1 mm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410382"/>
                  </a:ext>
                </a:extLst>
              </a:tr>
            </a:tbl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261EC57-469B-D3CC-F7F5-9B90E5D55748}"/>
              </a:ext>
            </a:extLst>
          </p:cNvPr>
          <p:cNvCxnSpPr>
            <a:cxnSpLocks/>
          </p:cNvCxnSpPr>
          <p:nvPr/>
        </p:nvCxnSpPr>
        <p:spPr>
          <a:xfrm>
            <a:off x="404553" y="5635934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231349EF-4D18-C2C0-CCDB-CC18F10E5FF1}"/>
              </a:ext>
            </a:extLst>
          </p:cNvPr>
          <p:cNvCxnSpPr>
            <a:cxnSpLocks/>
          </p:cNvCxnSpPr>
          <p:nvPr/>
        </p:nvCxnSpPr>
        <p:spPr>
          <a:xfrm>
            <a:off x="404553" y="772991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2C9F7B3-1C65-6226-F009-0682BD3388AD}"/>
              </a:ext>
            </a:extLst>
          </p:cNvPr>
          <p:cNvSpPr txBox="1"/>
          <p:nvPr/>
        </p:nvSpPr>
        <p:spPr>
          <a:xfrm>
            <a:off x="326969" y="54535"/>
            <a:ext cx="76342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8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</a:t>
            </a:r>
            <a:r>
              <a:rPr lang="en-US" altLang="ja-JP" sz="2000" dirty="0">
                <a:solidFill>
                  <a:prstClr val="black"/>
                </a:solidFill>
              </a:rPr>
              <a:t>. Subanalysis for PVL improvement stratified by CV</a:t>
            </a:r>
            <a:r>
              <a:rPr lang="en-US" altLang="ja-JP" sz="2000" baseline="-25000" dirty="0">
                <a:solidFill>
                  <a:prstClr val="black"/>
                </a:solidFill>
              </a:rPr>
              <a:t>AV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BAAB42A-2E3E-8B4F-92E7-501235DF5DB9}"/>
              </a:ext>
            </a:extLst>
          </p:cNvPr>
          <p:cNvSpPr txBox="1"/>
          <p:nvPr/>
        </p:nvSpPr>
        <p:spPr>
          <a:xfrm>
            <a:off x="3034222" y="5595474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0.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8527C81-7743-5AEA-E54D-2BB42DD9F4A1}"/>
              </a:ext>
            </a:extLst>
          </p:cNvPr>
          <p:cNvSpPr txBox="1"/>
          <p:nvPr/>
        </p:nvSpPr>
        <p:spPr>
          <a:xfrm>
            <a:off x="5159735" y="5907071"/>
            <a:ext cx="1224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Risk</a:t>
            </a:r>
            <a:r>
              <a:rPr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ratio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4F919CE9-2513-FCA9-083D-2D0A0C1305C9}"/>
              </a:ext>
            </a:extLst>
          </p:cNvPr>
          <p:cNvSpPr txBox="1"/>
          <p:nvPr/>
        </p:nvSpPr>
        <p:spPr>
          <a:xfrm>
            <a:off x="5510159" y="5595239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90DBE5E3-0C35-8D7B-881C-ECCA88C45EF4}"/>
              </a:ext>
            </a:extLst>
          </p:cNvPr>
          <p:cNvSpPr txBox="1"/>
          <p:nvPr/>
        </p:nvSpPr>
        <p:spPr>
          <a:xfrm>
            <a:off x="7949978" y="5600226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8A0C3270-574C-263E-B0DB-061C753A889B}"/>
              </a:ext>
            </a:extLst>
          </p:cNvPr>
          <p:cNvCxnSpPr>
            <a:cxnSpLocks/>
          </p:cNvCxnSpPr>
          <p:nvPr/>
        </p:nvCxnSpPr>
        <p:spPr>
          <a:xfrm flipV="1">
            <a:off x="4242429" y="5979431"/>
            <a:ext cx="3003665" cy="672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4155FBB-E882-52EB-8A9D-A4EABEC582ED}"/>
              </a:ext>
            </a:extLst>
          </p:cNvPr>
          <p:cNvSpPr txBox="1"/>
          <p:nvPr/>
        </p:nvSpPr>
        <p:spPr>
          <a:xfrm>
            <a:off x="7391977" y="5790864"/>
            <a:ext cx="1650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Better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E147D00B-1C5B-ED73-22CD-3843D966A47B}"/>
              </a:ext>
            </a:extLst>
          </p:cNvPr>
          <p:cNvSpPr txBox="1"/>
          <p:nvPr/>
        </p:nvSpPr>
        <p:spPr>
          <a:xfrm>
            <a:off x="2439500" y="5786671"/>
            <a:ext cx="171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Worse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3DC94918-F17B-3466-6652-4099D4293B6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9690418"/>
              </p:ext>
            </p:extLst>
          </p:nvPr>
        </p:nvGraphicFramePr>
        <p:xfrm>
          <a:off x="3169916" y="648589"/>
          <a:ext cx="5199695" cy="51149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1DC2BBE-2946-684B-3409-86A45A1B4F3D}"/>
              </a:ext>
            </a:extLst>
          </p:cNvPr>
          <p:cNvSpPr txBox="1"/>
          <p:nvPr/>
        </p:nvSpPr>
        <p:spPr>
          <a:xfrm>
            <a:off x="128229" y="6098144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CI = confidence interval;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LVOT = left ventricular outflow tract; PVL = paravalvular leakage; RR = risk ratio. </a:t>
            </a:r>
          </a:p>
        </p:txBody>
      </p:sp>
    </p:spTree>
    <p:extLst>
      <p:ext uri="{BB962C8B-B14F-4D97-AF65-F5344CB8AC3E}">
        <p14:creationId xmlns:p14="http://schemas.microsoft.com/office/powerpoint/2010/main" val="26668350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F99D300-FF11-1FC0-6BA8-67D496CBC9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id="{57F015DB-625E-7D03-4F81-DDDED6F67A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0915274"/>
              </p:ext>
            </p:extLst>
          </p:nvPr>
        </p:nvGraphicFramePr>
        <p:xfrm>
          <a:off x="8209869" y="1092733"/>
          <a:ext cx="3848650" cy="4261705"/>
        </p:xfrm>
        <a:graphic>
          <a:graphicData uri="http://schemas.openxmlformats.org/drawingml/2006/table">
            <a:tbl>
              <a:tblPr firstRow="1" bandRow="1"/>
              <a:tblGrid>
                <a:gridCol w="877285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  <a:gridCol w="1594085">
                  <a:extLst>
                    <a:ext uri="{9D8B030D-6E8A-4147-A177-3AD203B41FA5}">
                      <a16:colId xmlns:a16="http://schemas.microsoft.com/office/drawing/2014/main" val="1579887003"/>
                    </a:ext>
                  </a:extLst>
                </a:gridCol>
                <a:gridCol w="1377280">
                  <a:extLst>
                    <a:ext uri="{9D8B030D-6E8A-4147-A177-3AD203B41FA5}">
                      <a16:colId xmlns:a16="http://schemas.microsoft.com/office/drawing/2014/main" val="3773613209"/>
                    </a:ext>
                  </a:extLst>
                </a:gridCol>
              </a:tblGrid>
              <a:tr h="5052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R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95%CI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i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-value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7 – 0.9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24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2 – 1.6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42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.1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52 – 3.1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&lt;0.000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4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2 – 2.4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210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6 – 1.0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50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6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2 – 1.4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26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8 – 1.0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404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6229845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61F9945E-269D-DE3E-6D3C-0422461477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639334"/>
              </p:ext>
            </p:extLst>
          </p:nvPr>
        </p:nvGraphicFramePr>
        <p:xfrm>
          <a:off x="326969" y="1195774"/>
          <a:ext cx="2956731" cy="4281448"/>
        </p:xfrm>
        <a:graphic>
          <a:graphicData uri="http://schemas.openxmlformats.org/drawingml/2006/table">
            <a:tbl>
              <a:tblPr firstRow="1" bandRow="1"/>
              <a:tblGrid>
                <a:gridCol w="2956731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</a:tblGrid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URATE neo2 (vs. neo)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icuspid aortic valve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V</a:t>
                      </a:r>
                      <a:r>
                        <a:rPr lang="en-US" sz="1800" kern="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</a:t>
                      </a:r>
                      <a:r>
                        <a:rPr lang="en-US" sz="1800" kern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 ≥358.6 mm</a:t>
                      </a:r>
                      <a:r>
                        <a:rPr lang="en-US" sz="1800" kern="0" baseline="30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vere LVOT calcific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altLang="ja-JP" sz="1800" kern="100" dirty="0">
                          <a:solidFill>
                            <a:schemeClr val="dk1"/>
                          </a:solidFill>
                          <a:effectLst/>
                          <a:latin typeface="Calibri" panose="020F0502020204030204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versizing index, per 1 % 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ost-dilat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mplantation depth, per 1 mm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410382"/>
                  </a:ext>
                </a:extLst>
              </a:tr>
            </a:tbl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9DD6B66E-D3B2-AD7B-4CE3-BC3A644EFF07}"/>
              </a:ext>
            </a:extLst>
          </p:cNvPr>
          <p:cNvCxnSpPr>
            <a:cxnSpLocks/>
          </p:cNvCxnSpPr>
          <p:nvPr/>
        </p:nvCxnSpPr>
        <p:spPr>
          <a:xfrm>
            <a:off x="404553" y="5635934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9017504D-3957-F46C-0611-2431DFFBC595}"/>
              </a:ext>
            </a:extLst>
          </p:cNvPr>
          <p:cNvCxnSpPr>
            <a:cxnSpLocks/>
          </p:cNvCxnSpPr>
          <p:nvPr/>
        </p:nvCxnSpPr>
        <p:spPr>
          <a:xfrm>
            <a:off x="404553" y="772992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4E73367C-576E-C059-3C74-4E5BDA9D4E07}"/>
              </a:ext>
            </a:extLst>
          </p:cNvPr>
          <p:cNvSpPr txBox="1"/>
          <p:nvPr/>
        </p:nvSpPr>
        <p:spPr>
          <a:xfrm>
            <a:off x="326969" y="54535"/>
            <a:ext cx="83433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8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B. </a:t>
            </a:r>
            <a:r>
              <a:rPr lang="en-US" altLang="ja-JP" sz="2000" dirty="0">
                <a:solidFill>
                  <a:prstClr val="black"/>
                </a:solidFill>
              </a:rPr>
              <a:t>Subanalysis for residual PVL at 3 months stratified by CV</a:t>
            </a:r>
            <a:r>
              <a:rPr lang="en-US" altLang="ja-JP" sz="2000" baseline="-25000" dirty="0">
                <a:solidFill>
                  <a:prstClr val="black"/>
                </a:solidFill>
              </a:rPr>
              <a:t>AV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2723A2F-D5C3-2724-8253-0B527AB3E167}"/>
              </a:ext>
            </a:extLst>
          </p:cNvPr>
          <p:cNvSpPr txBox="1"/>
          <p:nvPr/>
        </p:nvSpPr>
        <p:spPr>
          <a:xfrm>
            <a:off x="3034222" y="5595474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0.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327A9D5-FD43-9942-B68B-D1C7E97E5912}"/>
              </a:ext>
            </a:extLst>
          </p:cNvPr>
          <p:cNvSpPr txBox="1"/>
          <p:nvPr/>
        </p:nvSpPr>
        <p:spPr>
          <a:xfrm>
            <a:off x="5159735" y="5907071"/>
            <a:ext cx="1224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Risk</a:t>
            </a:r>
            <a:r>
              <a:rPr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ratio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77432D24-EBD6-9010-0200-A1CBEB17B3F2}"/>
              </a:ext>
            </a:extLst>
          </p:cNvPr>
          <p:cNvSpPr txBox="1"/>
          <p:nvPr/>
        </p:nvSpPr>
        <p:spPr>
          <a:xfrm>
            <a:off x="5510159" y="5595239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7122BA55-2B20-09B4-DFF2-7179120F419F}"/>
              </a:ext>
            </a:extLst>
          </p:cNvPr>
          <p:cNvSpPr txBox="1"/>
          <p:nvPr/>
        </p:nvSpPr>
        <p:spPr>
          <a:xfrm>
            <a:off x="7949978" y="5600226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D1FF7153-69E0-16C2-A1DE-D1EDC92D8A88}"/>
              </a:ext>
            </a:extLst>
          </p:cNvPr>
          <p:cNvCxnSpPr>
            <a:cxnSpLocks/>
          </p:cNvCxnSpPr>
          <p:nvPr/>
        </p:nvCxnSpPr>
        <p:spPr>
          <a:xfrm flipV="1">
            <a:off x="4242429" y="5979431"/>
            <a:ext cx="3003665" cy="672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8DD241FB-F5A8-52F5-DCF4-176569A89E5D}"/>
              </a:ext>
            </a:extLst>
          </p:cNvPr>
          <p:cNvSpPr txBox="1"/>
          <p:nvPr/>
        </p:nvSpPr>
        <p:spPr>
          <a:xfrm>
            <a:off x="7363401" y="5790864"/>
            <a:ext cx="17658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Worse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AE297F39-5F6A-309B-2D03-C22BB1A4C70F}"/>
              </a:ext>
            </a:extLst>
          </p:cNvPr>
          <p:cNvSpPr txBox="1"/>
          <p:nvPr/>
        </p:nvSpPr>
        <p:spPr>
          <a:xfrm>
            <a:off x="2439500" y="5786671"/>
            <a:ext cx="171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Better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41C4FECB-34AD-7633-9CFA-5DF0AD6DD0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9560694"/>
              </p:ext>
            </p:extLst>
          </p:nvPr>
        </p:nvGraphicFramePr>
        <p:xfrm>
          <a:off x="3169917" y="647404"/>
          <a:ext cx="5199694" cy="5119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0E09046-3B98-1581-3B36-1DAFA9EBA986}"/>
              </a:ext>
            </a:extLst>
          </p:cNvPr>
          <p:cNvSpPr txBox="1"/>
          <p:nvPr/>
        </p:nvSpPr>
        <p:spPr>
          <a:xfrm>
            <a:off x="128229" y="6098144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CI = confidence interval;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LVOT = left ventricular outflow tract; PVL = paravalvular leakage; RR = risk ratio. </a:t>
            </a:r>
          </a:p>
        </p:txBody>
      </p:sp>
    </p:spTree>
    <p:extLst>
      <p:ext uri="{BB962C8B-B14F-4D97-AF65-F5344CB8AC3E}">
        <p14:creationId xmlns:p14="http://schemas.microsoft.com/office/powerpoint/2010/main" val="33422790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448B096-97DA-02D2-C35E-693697123AD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D54F5374-3382-C979-C1D8-CBD315AE199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7582606"/>
              </p:ext>
            </p:extLst>
          </p:nvPr>
        </p:nvGraphicFramePr>
        <p:xfrm>
          <a:off x="3169917" y="138551"/>
          <a:ext cx="5199694" cy="56346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2" name="表 21">
            <a:extLst>
              <a:ext uri="{FF2B5EF4-FFF2-40B4-BE49-F238E27FC236}">
                <a16:creationId xmlns:a16="http://schemas.microsoft.com/office/drawing/2014/main" id="{B8503D99-3265-2E8C-A58E-F2E18419F2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9069368"/>
              </p:ext>
            </p:extLst>
          </p:nvPr>
        </p:nvGraphicFramePr>
        <p:xfrm>
          <a:off x="8209869" y="568858"/>
          <a:ext cx="3848650" cy="4798337"/>
        </p:xfrm>
        <a:graphic>
          <a:graphicData uri="http://schemas.openxmlformats.org/drawingml/2006/table">
            <a:tbl>
              <a:tblPr firstRow="1" bandRow="1"/>
              <a:tblGrid>
                <a:gridCol w="877285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  <a:gridCol w="1594085">
                  <a:extLst>
                    <a:ext uri="{9D8B030D-6E8A-4147-A177-3AD203B41FA5}">
                      <a16:colId xmlns:a16="http://schemas.microsoft.com/office/drawing/2014/main" val="1579887003"/>
                    </a:ext>
                  </a:extLst>
                </a:gridCol>
                <a:gridCol w="1377280">
                  <a:extLst>
                    <a:ext uri="{9D8B030D-6E8A-4147-A177-3AD203B41FA5}">
                      <a16:colId xmlns:a16="http://schemas.microsoft.com/office/drawing/2014/main" val="3773613209"/>
                    </a:ext>
                  </a:extLst>
                </a:gridCol>
              </a:tblGrid>
              <a:tr h="5052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RR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95%CI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b="1" i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800" b="1" u="sng" dirty="0">
                          <a:solidFill>
                            <a:schemeClr val="tx1"/>
                          </a:solidFill>
                          <a:latin typeface="+mn-lt"/>
                          <a:cs typeface="Times New Roman" panose="02020603050405020304" pitchFamily="18" charset="0"/>
                        </a:rPr>
                        <a:t>-value</a:t>
                      </a:r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7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29 – 2.4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00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11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56 – 2.2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62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9 – 0.9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227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2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75 – 2.1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77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5 – 1.06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694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663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3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88 – 2.09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1715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.03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95 – 1.1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497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6229845"/>
                  </a:ext>
                </a:extLst>
              </a:tr>
              <a:tr h="53663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38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16 – 0.92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r>
                        <a:rPr lang="en-US" altLang="ja-JP" sz="1800" b="1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0.0321</a:t>
                      </a:r>
                      <a:endParaRPr lang="ja-JP" sz="1800" b="1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4283796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0E8AE783-B289-045C-B548-7DC0798ED3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8952699"/>
              </p:ext>
            </p:extLst>
          </p:nvPr>
        </p:nvGraphicFramePr>
        <p:xfrm>
          <a:off x="326969" y="671899"/>
          <a:ext cx="2956731" cy="4816629"/>
        </p:xfrm>
        <a:graphic>
          <a:graphicData uri="http://schemas.openxmlformats.org/drawingml/2006/table">
            <a:tbl>
              <a:tblPr firstRow="1" bandRow="1"/>
              <a:tblGrid>
                <a:gridCol w="2956731">
                  <a:extLst>
                    <a:ext uri="{9D8B030D-6E8A-4147-A177-3AD203B41FA5}">
                      <a16:colId xmlns:a16="http://schemas.microsoft.com/office/drawing/2014/main" val="1547973548"/>
                    </a:ext>
                  </a:extLst>
                </a:gridCol>
              </a:tblGrid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1800" b="1" u="sng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620215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URATE neo2 (vs. neo)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405456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icuspid aortic valve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238497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V</a:t>
                      </a:r>
                      <a:r>
                        <a:rPr lang="en-US" sz="1800" kern="0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</a:t>
                      </a:r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, per 100 mm</a:t>
                      </a:r>
                      <a:r>
                        <a:rPr lang="en-US" sz="1800" kern="0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19098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vere LVOT calcific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295793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altLang="ja-JP" sz="1800" kern="100" dirty="0">
                          <a:solidFill>
                            <a:schemeClr val="dk1"/>
                          </a:solidFill>
                          <a:effectLst/>
                          <a:latin typeface="Calibri" panose="020F0502020204030204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versizing index, per 1 % 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952334"/>
                  </a:ext>
                </a:extLst>
              </a:tr>
              <a:tr h="53518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/>
                      <a:r>
                        <a:rPr lang="en-US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ost-dilatation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55268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mplantation depth, per 1 mm</a:t>
                      </a:r>
                      <a:endParaRPr lang="ja-JP" sz="1800" kern="100" dirty="0"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410382"/>
                  </a:ext>
                </a:extLst>
              </a:tr>
              <a:tr h="535181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800" kern="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VL ≥moderate at discharge</a:t>
                      </a:r>
                      <a:endParaRPr lang="ja-JP" sz="1800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002009"/>
                  </a:ext>
                </a:extLst>
              </a:tr>
            </a:tbl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8069A7A0-284C-FDD7-3E65-E6FC7D7089AE}"/>
              </a:ext>
            </a:extLst>
          </p:cNvPr>
          <p:cNvCxnSpPr>
            <a:cxnSpLocks/>
          </p:cNvCxnSpPr>
          <p:nvPr/>
        </p:nvCxnSpPr>
        <p:spPr>
          <a:xfrm>
            <a:off x="404553" y="5635934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A19140D0-473A-E1AD-3E99-ED17E7654012}"/>
              </a:ext>
            </a:extLst>
          </p:cNvPr>
          <p:cNvCxnSpPr>
            <a:cxnSpLocks/>
          </p:cNvCxnSpPr>
          <p:nvPr/>
        </p:nvCxnSpPr>
        <p:spPr>
          <a:xfrm>
            <a:off x="404553" y="529151"/>
            <a:ext cx="1151035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3389626-1EE1-B17E-4296-14395FA6E09E}"/>
              </a:ext>
            </a:extLst>
          </p:cNvPr>
          <p:cNvSpPr txBox="1"/>
          <p:nvPr/>
        </p:nvSpPr>
        <p:spPr>
          <a:xfrm>
            <a:off x="3034222" y="5595474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0.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6DB73F7-CAA1-1B98-ED90-5385EE8EA9A0}"/>
              </a:ext>
            </a:extLst>
          </p:cNvPr>
          <p:cNvSpPr txBox="1"/>
          <p:nvPr/>
        </p:nvSpPr>
        <p:spPr>
          <a:xfrm>
            <a:off x="5159735" y="5907071"/>
            <a:ext cx="1224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Risk</a:t>
            </a:r>
            <a:r>
              <a:rPr lang="en-US" altLang="ja-JP" dirty="0"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ratio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6D54FF83-6402-0B17-A572-AD54FA3BED05}"/>
              </a:ext>
            </a:extLst>
          </p:cNvPr>
          <p:cNvSpPr txBox="1"/>
          <p:nvPr/>
        </p:nvSpPr>
        <p:spPr>
          <a:xfrm>
            <a:off x="5510159" y="5595239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0C6EC8D4-BC44-FC3A-A138-F511AD17DC6E}"/>
              </a:ext>
            </a:extLst>
          </p:cNvPr>
          <p:cNvSpPr txBox="1"/>
          <p:nvPr/>
        </p:nvSpPr>
        <p:spPr>
          <a:xfrm>
            <a:off x="7949978" y="5600226"/>
            <a:ext cx="52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10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210B39E5-43B9-5731-5B12-FC4339BE918C}"/>
              </a:ext>
            </a:extLst>
          </p:cNvPr>
          <p:cNvCxnSpPr>
            <a:cxnSpLocks/>
          </p:cNvCxnSpPr>
          <p:nvPr/>
        </p:nvCxnSpPr>
        <p:spPr>
          <a:xfrm flipV="1">
            <a:off x="4242429" y="5979431"/>
            <a:ext cx="3003665" cy="672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FF4E484A-58D7-A886-B941-4DD3B29C6B1D}"/>
              </a:ext>
            </a:extLst>
          </p:cNvPr>
          <p:cNvSpPr txBox="1"/>
          <p:nvPr/>
        </p:nvSpPr>
        <p:spPr>
          <a:xfrm>
            <a:off x="7391977" y="5790864"/>
            <a:ext cx="1650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Better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90F5EA42-3371-65B4-55BF-06C69376BA96}"/>
              </a:ext>
            </a:extLst>
          </p:cNvPr>
          <p:cNvSpPr txBox="1"/>
          <p:nvPr/>
        </p:nvSpPr>
        <p:spPr>
          <a:xfrm>
            <a:off x="2439500" y="5786671"/>
            <a:ext cx="171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0" lang="en-US" altLang="ja-JP" dirty="0">
                <a:solidFill>
                  <a:prstClr val="black"/>
                </a:solidFill>
                <a:ea typeface="メイリオ" panose="020B0604030504040204" pitchFamily="50" charset="-128"/>
                <a:cs typeface="Times New Roman" panose="02020603050405020304" pitchFamily="18" charset="0"/>
              </a:rPr>
              <a:t>Worse outcome</a:t>
            </a:r>
            <a:endParaRPr lang="ja-JP" altLang="en-US" dirty="0">
              <a:solidFill>
                <a:prstClr val="black"/>
              </a:solidFill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ED49840-2A8F-753E-32D9-E6F42D15B499}"/>
              </a:ext>
            </a:extLst>
          </p:cNvPr>
          <p:cNvSpPr/>
          <p:nvPr/>
        </p:nvSpPr>
        <p:spPr>
          <a:xfrm>
            <a:off x="3169918" y="127467"/>
            <a:ext cx="5131726" cy="3895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DE498CE-DFBD-6473-A4DC-5ECAB1607BEE}"/>
              </a:ext>
            </a:extLst>
          </p:cNvPr>
          <p:cNvSpPr txBox="1"/>
          <p:nvPr/>
        </p:nvSpPr>
        <p:spPr>
          <a:xfrm>
            <a:off x="128229" y="6098144"/>
            <a:ext cx="119418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CI = confidence interval; CV</a:t>
            </a:r>
            <a:r>
              <a:rPr lang="en-US" altLang="ja-JP" sz="2000" baseline="-25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AV</a:t>
            </a: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 = calcium volume of the aortic leaflets; LVOT = left ventricular outflow tract; PVL = paravalvular leakage; RR = risk ratio. 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7C3515D-D3B7-F230-9093-A6879ED36762}"/>
              </a:ext>
            </a:extLst>
          </p:cNvPr>
          <p:cNvSpPr txBox="1"/>
          <p:nvPr/>
        </p:nvSpPr>
        <p:spPr>
          <a:xfrm>
            <a:off x="326969" y="54535"/>
            <a:ext cx="94574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altLang="ja-JP" sz="20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</a:rPr>
              <a:t>Online Resource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9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A</a:t>
            </a:r>
            <a:r>
              <a:rPr lang="en-US" altLang="ja-JP" sz="2000" dirty="0">
                <a:solidFill>
                  <a:prstClr val="black"/>
                </a:solidFill>
              </a:rPr>
              <a:t>. Subanalysis for PVL improvement including PVL severity at discharge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4240080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428</TotalTime>
  <Words>1622</Words>
  <Application>Microsoft Office PowerPoint</Application>
  <PresentationFormat>ワイド画面</PresentationFormat>
  <Paragraphs>416</Paragraphs>
  <Slides>13</Slides>
  <Notes>1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19" baseType="lpstr">
      <vt:lpstr>メイリオ</vt:lpstr>
      <vt:lpstr>游ゴシック</vt:lpstr>
      <vt:lpstr>Arial</vt:lpstr>
      <vt:lpstr>Calibri</vt:lpstr>
      <vt:lpstr>Calibri Light</vt:lpstr>
      <vt:lpstr>1_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下 紘和</dc:creator>
  <cp:lastModifiedBy>Yoichi Sugiyama</cp:lastModifiedBy>
  <cp:revision>187</cp:revision>
  <dcterms:created xsi:type="dcterms:W3CDTF">2021-02-03T12:37:14Z</dcterms:created>
  <dcterms:modified xsi:type="dcterms:W3CDTF">2025-07-19T11:41:00Z</dcterms:modified>
</cp:coreProperties>
</file>